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notesSlides/notesSlide1.xml" ContentType="application/vnd.openxmlformats-officedocument.presentationml.notesSlide+xml"/>
  <Override PartName="/ppt/tags/tag48.xml" ContentType="application/vnd.openxmlformats-officedocument.presentationml.tags+xml"/>
  <Override PartName="/ppt/notesSlides/notesSlide2.xml" ContentType="application/vnd.openxmlformats-officedocument.presentationml.notesSlide+xml"/>
  <Override PartName="/ppt/tags/tag49.xml" ContentType="application/vnd.openxmlformats-officedocument.presentationml.tags+xml"/>
  <Override PartName="/ppt/notesSlides/notesSlide3.xml" ContentType="application/vnd.openxmlformats-officedocument.presentationml.notesSlide+xml"/>
  <Override PartName="/ppt/tags/tag50.xml" ContentType="application/vnd.openxmlformats-officedocument.presentationml.tags+xml"/>
  <Override PartName="/ppt/notesSlides/notesSlide4.xml" ContentType="application/vnd.openxmlformats-officedocument.presentationml.notesSlide+xml"/>
  <Override PartName="/ppt/tags/tag51.xml" ContentType="application/vnd.openxmlformats-officedocument.presentationml.tags+xml"/>
  <Override PartName="/ppt/notesSlides/notesSlide5.xml" ContentType="application/vnd.openxmlformats-officedocument.presentationml.notesSlide+xml"/>
  <Override PartName="/ppt/tags/tag52.xml" ContentType="application/vnd.openxmlformats-officedocument.presentationml.tags+xml"/>
  <Override PartName="/ppt/notesSlides/notesSlide6.xml" ContentType="application/vnd.openxmlformats-officedocument.presentationml.notesSlide+xml"/>
  <Override PartName="/ppt/tags/tag53.xml" ContentType="application/vnd.openxmlformats-officedocument.presentationml.tags+xml"/>
  <Override PartName="/ppt/notesSlides/notesSlide7.xml" ContentType="application/vnd.openxmlformats-officedocument.presentationml.notesSlide+xml"/>
  <Override PartName="/ppt/tags/tag54.xml" ContentType="application/vnd.openxmlformats-officedocument.presentationml.tags+xml"/>
  <Override PartName="/ppt/notesSlides/notesSlide8.xml" ContentType="application/vnd.openxmlformats-officedocument.presentationml.notesSlide+xml"/>
  <Override PartName="/ppt/tags/tag55.xml" ContentType="application/vnd.openxmlformats-officedocument.presentationml.tags+xml"/>
  <Override PartName="/ppt/notesSlides/notesSlide9.xml" ContentType="application/vnd.openxmlformats-officedocument.presentationml.notesSlide+xml"/>
  <Override PartName="/ppt/tags/tag56.xml" ContentType="application/vnd.openxmlformats-officedocument.presentationml.tags+xml"/>
  <Override PartName="/ppt/notesSlides/notesSlide10.xml" ContentType="application/vnd.openxmlformats-officedocument.presentationml.notesSlide+xml"/>
  <Override PartName="/ppt/tags/tag57.xml" ContentType="application/vnd.openxmlformats-officedocument.presentationml.tags+xml"/>
  <Override PartName="/ppt/notesSlides/notesSlide11.xml" ContentType="application/vnd.openxmlformats-officedocument.presentationml.notesSlide+xml"/>
  <Override PartName="/ppt/tags/tag58.xml" ContentType="application/vnd.openxmlformats-officedocument.presentationml.tags+xml"/>
  <Override PartName="/ppt/notesSlides/notesSlide12.xml" ContentType="application/vnd.openxmlformats-officedocument.presentationml.notesSlide+xml"/>
  <Override PartName="/ppt/tags/tag59.xml" ContentType="application/vnd.openxmlformats-officedocument.presentationml.tags+xml"/>
  <Override PartName="/ppt/notesSlides/notesSlide13.xml" ContentType="application/vnd.openxmlformats-officedocument.presentationml.notesSlide+xml"/>
  <Override PartName="/ppt/tags/tag60.xml" ContentType="application/vnd.openxmlformats-officedocument.presentationml.tags+xml"/>
  <Override PartName="/ppt/notesSlides/notesSlide14.xml" ContentType="application/vnd.openxmlformats-officedocument.presentationml.notesSlide+xml"/>
  <Override PartName="/ppt/tags/tag61.xml" ContentType="application/vnd.openxmlformats-officedocument.presentationml.tags+xml"/>
  <Override PartName="/ppt/notesSlides/notesSlide15.xml" ContentType="application/vnd.openxmlformats-officedocument.presentationml.notesSlide+xml"/>
  <Override PartName="/ppt/tags/tag62.xml" ContentType="application/vnd.openxmlformats-officedocument.presentationml.tags+xml"/>
  <Override PartName="/ppt/notesSlides/notesSlide16.xml" ContentType="application/vnd.openxmlformats-officedocument.presentationml.notesSlide+xml"/>
  <Override PartName="/ppt/tags/tag63.xml" ContentType="application/vnd.openxmlformats-officedocument.presentationml.tags+xml"/>
  <Override PartName="/ppt/notesSlides/notesSlide17.xml" ContentType="application/vnd.openxmlformats-officedocument.presentationml.notesSlide+xml"/>
  <Override PartName="/ppt/tags/tag64.xml" ContentType="application/vnd.openxmlformats-officedocument.presentationml.tags+xml"/>
  <Override PartName="/ppt/notesSlides/notesSlide18.xml" ContentType="application/vnd.openxmlformats-officedocument.presentationml.notesSlide+xml"/>
  <Override PartName="/ppt/tags/tag65.xml" ContentType="application/vnd.openxmlformats-officedocument.presentationml.tags+xml"/>
  <Override PartName="/ppt/notesSlides/notesSlide19.xml" ContentType="application/vnd.openxmlformats-officedocument.presentationml.notesSlide+xml"/>
  <Override PartName="/ppt/tags/tag66.xml" ContentType="application/vnd.openxmlformats-officedocument.presentationml.tags+xml"/>
  <Override PartName="/ppt/notesSlides/notesSlide20.xml" ContentType="application/vnd.openxmlformats-officedocument.presentationml.notesSlide+xml"/>
  <Override PartName="/ppt/tags/tag67.xml" ContentType="application/vnd.openxmlformats-officedocument.presentationml.tags+xml"/>
  <Override PartName="/ppt/notesSlides/notesSlide21.xml" ContentType="application/vnd.openxmlformats-officedocument.presentationml.notesSlide+xml"/>
  <Override PartName="/ppt/tags/tag68.xml" ContentType="application/vnd.openxmlformats-officedocument.presentationml.tags+xml"/>
  <Override PartName="/ppt/notesSlides/notesSlide22.xml" ContentType="application/vnd.openxmlformats-officedocument.presentationml.notesSlide+xml"/>
  <Override PartName="/ppt/tags/tag69.xml" ContentType="application/vnd.openxmlformats-officedocument.presentationml.tags+xml"/>
  <Override PartName="/ppt/notesSlides/notesSlide23.xml" ContentType="application/vnd.openxmlformats-officedocument.presentationml.notesSlide+xml"/>
  <Override PartName="/ppt/tags/tag70.xml" ContentType="application/vnd.openxmlformats-officedocument.presentationml.tags+xml"/>
  <Override PartName="/ppt/notesSlides/notesSlide24.xml" ContentType="application/vnd.openxmlformats-officedocument.presentationml.notesSlide+xml"/>
  <Override PartName="/ppt/tags/tag71.xml" ContentType="application/vnd.openxmlformats-officedocument.presentationml.tags+xml"/>
  <Override PartName="/ppt/notesSlides/notesSlide25.xml" ContentType="application/vnd.openxmlformats-officedocument.presentationml.notesSlide+xml"/>
  <Override PartName="/ppt/tags/tag72.xml" ContentType="application/vnd.openxmlformats-officedocument.presentationml.tags+xml"/>
  <Override PartName="/ppt/notesSlides/notesSlide26.xml" ContentType="application/vnd.openxmlformats-officedocument.presentationml.notesSlide+xml"/>
  <Override PartName="/ppt/tags/tag73.xml" ContentType="application/vnd.openxmlformats-officedocument.presentationml.tags+xml"/>
  <Override PartName="/ppt/notesSlides/notesSlide27.xml" ContentType="application/vnd.openxmlformats-officedocument.presentationml.notesSlide+xml"/>
  <Override PartName="/ppt/tags/tag74.xml" ContentType="application/vnd.openxmlformats-officedocument.presentationml.tags+xml"/>
  <Override PartName="/ppt/notesSlides/notesSlide28.xml" ContentType="application/vnd.openxmlformats-officedocument.presentationml.notesSlide+xml"/>
  <Override PartName="/ppt/tags/tag75.xml" ContentType="application/vnd.openxmlformats-officedocument.presentationml.tags+xml"/>
  <Override PartName="/ppt/notesSlides/notesSlide29.xml" ContentType="application/vnd.openxmlformats-officedocument.presentationml.notesSlide+xml"/>
  <Override PartName="/ppt/tags/tag76.xml" ContentType="application/vnd.openxmlformats-officedocument.presentationml.tags+xml"/>
  <Override PartName="/ppt/notesSlides/notesSlide30.xml" ContentType="application/vnd.openxmlformats-officedocument.presentationml.notesSlide+xml"/>
  <Override PartName="/ppt/tags/tag77.xml" ContentType="application/vnd.openxmlformats-officedocument.presentationml.tags+xml"/>
  <Override PartName="/ppt/notesSlides/notesSlide31.xml" ContentType="application/vnd.openxmlformats-officedocument.presentationml.notesSlide+xml"/>
  <Override PartName="/ppt/tags/tag78.xml" ContentType="application/vnd.openxmlformats-officedocument.presentationml.tags+xml"/>
  <Override PartName="/ppt/notesSlides/notesSlide32.xml" ContentType="application/vnd.openxmlformats-officedocument.presentationml.notesSlide+xml"/>
  <Override PartName="/ppt/tags/tag79.xml" ContentType="application/vnd.openxmlformats-officedocument.presentationml.tags+xml"/>
  <Override PartName="/ppt/notesSlides/notesSlide3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2"/>
  </p:notesMasterIdLst>
  <p:sldIdLst>
    <p:sldId id="918" r:id="rId2"/>
    <p:sldId id="921" r:id="rId3"/>
    <p:sldId id="923" r:id="rId4"/>
    <p:sldId id="922" r:id="rId5"/>
    <p:sldId id="926" r:id="rId6"/>
    <p:sldId id="971" r:id="rId7"/>
    <p:sldId id="975" r:id="rId8"/>
    <p:sldId id="973" r:id="rId9"/>
    <p:sldId id="974" r:id="rId10"/>
    <p:sldId id="941" r:id="rId11"/>
    <p:sldId id="942" r:id="rId12"/>
    <p:sldId id="944" r:id="rId13"/>
    <p:sldId id="945" r:id="rId14"/>
    <p:sldId id="947" r:id="rId15"/>
    <p:sldId id="948" r:id="rId16"/>
    <p:sldId id="949" r:id="rId17"/>
    <p:sldId id="1843" r:id="rId18"/>
    <p:sldId id="962" r:id="rId19"/>
    <p:sldId id="965" r:id="rId20"/>
    <p:sldId id="968" r:id="rId21"/>
    <p:sldId id="969" r:id="rId22"/>
    <p:sldId id="970" r:id="rId23"/>
    <p:sldId id="1005" r:id="rId24"/>
    <p:sldId id="1006" r:id="rId25"/>
    <p:sldId id="1007" r:id="rId26"/>
    <p:sldId id="1008" r:id="rId27"/>
    <p:sldId id="1010" r:id="rId28"/>
    <p:sldId id="1011" r:id="rId29"/>
    <p:sldId id="1012" r:id="rId30"/>
    <p:sldId id="1013" r:id="rId31"/>
    <p:sldId id="1016" r:id="rId32"/>
    <p:sldId id="1017" r:id="rId33"/>
    <p:sldId id="1019" r:id="rId34"/>
    <p:sldId id="1018" r:id="rId35"/>
    <p:sldId id="1020" r:id="rId36"/>
    <p:sldId id="1021" r:id="rId37"/>
    <p:sldId id="1022" r:id="rId38"/>
    <p:sldId id="1023" r:id="rId39"/>
    <p:sldId id="1025" r:id="rId40"/>
    <p:sldId id="1026" r:id="rId41"/>
    <p:sldId id="1027" r:id="rId42"/>
    <p:sldId id="1028" r:id="rId43"/>
    <p:sldId id="1030" r:id="rId44"/>
    <p:sldId id="1849" r:id="rId45"/>
    <p:sldId id="1032" r:id="rId46"/>
    <p:sldId id="1034" r:id="rId47"/>
    <p:sldId id="1035" r:id="rId48"/>
    <p:sldId id="1045" r:id="rId49"/>
    <p:sldId id="1046" r:id="rId50"/>
    <p:sldId id="1047" r:id="rId51"/>
    <p:sldId id="1048" r:id="rId52"/>
    <p:sldId id="1049" r:id="rId53"/>
    <p:sldId id="1050" r:id="rId54"/>
    <p:sldId id="1052" r:id="rId55"/>
    <p:sldId id="1053" r:id="rId56"/>
    <p:sldId id="1054" r:id="rId57"/>
    <p:sldId id="1055" r:id="rId58"/>
    <p:sldId id="1058" r:id="rId59"/>
    <p:sldId id="1056" r:id="rId60"/>
    <p:sldId id="1057" r:id="rId61"/>
    <p:sldId id="1059" r:id="rId62"/>
    <p:sldId id="1521" r:id="rId63"/>
    <p:sldId id="1522" r:id="rId64"/>
    <p:sldId id="1518" r:id="rId65"/>
    <p:sldId id="1519" r:id="rId66"/>
    <p:sldId id="1067" r:id="rId67"/>
    <p:sldId id="1068" r:id="rId68"/>
    <p:sldId id="1069" r:id="rId69"/>
    <p:sldId id="1075" r:id="rId70"/>
    <p:sldId id="1076" r:id="rId71"/>
    <p:sldId id="1083" r:id="rId72"/>
    <p:sldId id="1084" r:id="rId73"/>
    <p:sldId id="1086" r:id="rId74"/>
    <p:sldId id="1087" r:id="rId75"/>
    <p:sldId id="1088" r:id="rId76"/>
    <p:sldId id="1090" r:id="rId77"/>
    <p:sldId id="1091" r:id="rId78"/>
    <p:sldId id="1092" r:id="rId79"/>
    <p:sldId id="1093" r:id="rId80"/>
    <p:sldId id="1655" r:id="rId81"/>
  </p:sldIdLst>
  <p:sldSz cx="12192000" cy="6858000"/>
  <p:notesSz cx="9144000" cy="6858000"/>
  <p:custDataLst>
    <p:tags r:id="rId8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68" autoAdjust="0"/>
    <p:restoredTop sz="95184" autoAdjust="0"/>
  </p:normalViewPr>
  <p:slideViewPr>
    <p:cSldViewPr snapToGrid="0">
      <p:cViewPr varScale="1">
        <p:scale>
          <a:sx n="85" d="100"/>
          <a:sy n="85" d="100"/>
        </p:scale>
        <p:origin x="8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84" Type="http://schemas.openxmlformats.org/officeDocument/2006/relationships/presProps" Target="presProps.xml"/><Relationship Id="rId16" Type="http://schemas.openxmlformats.org/officeDocument/2006/relationships/slide" Target="slides/slide15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5" Type="http://schemas.openxmlformats.org/officeDocument/2006/relationships/slide" Target="slides/slide4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slide" Target="slides/slide79.xml"/><Relationship Id="rId85" Type="http://schemas.openxmlformats.org/officeDocument/2006/relationships/viewProps" Target="view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tags" Target="tags/tag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slide" Target="slides/slide80.xml"/><Relationship Id="rId86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24" Type="http://schemas.openxmlformats.org/officeDocument/2006/relationships/slide" Target="slides/slide23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87" Type="http://schemas.openxmlformats.org/officeDocument/2006/relationships/tableStyles" Target="tableStyles.xml"/><Relationship Id="rId61" Type="http://schemas.openxmlformats.org/officeDocument/2006/relationships/slide" Target="slides/slide60.xml"/><Relationship Id="rId8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7E907F-BA5C-42C2-AFFE-54C780B65D30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14397" y="857250"/>
            <a:ext cx="411520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DC699E-C866-4A5B-95A4-1162B1D3EB7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7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8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9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0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1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2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3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4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5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7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8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9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0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1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2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3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4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5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7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8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9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4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5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150" y="1122363"/>
            <a:ext cx="91449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150" y="3602038"/>
            <a:ext cx="91449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5760" y="365125"/>
            <a:ext cx="2629159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85" y="365125"/>
            <a:ext cx="7735062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933" y="1709741"/>
            <a:ext cx="1051663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933" y="4589466"/>
            <a:ext cx="1051663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83" y="1825625"/>
            <a:ext cx="518211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809" y="1825625"/>
            <a:ext cx="518211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365127"/>
            <a:ext cx="1051663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873" y="1681163"/>
            <a:ext cx="515829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873" y="2505076"/>
            <a:ext cx="5158295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809" y="1681163"/>
            <a:ext cx="518369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809" y="2505076"/>
            <a:ext cx="518369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2" y="457200"/>
            <a:ext cx="393262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698" y="987428"/>
            <a:ext cx="617280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2" y="2057400"/>
            <a:ext cx="393262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2" y="457200"/>
            <a:ext cx="393262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698" y="987428"/>
            <a:ext cx="6172808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2" y="2057400"/>
            <a:ext cx="393262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83" y="365127"/>
            <a:ext cx="1051663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83" y="1825625"/>
            <a:ext cx="1051663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83" y="6356354"/>
            <a:ext cx="27434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8C74B-AB0E-41D1-B132-9A0008E1C19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998" y="6356354"/>
            <a:ext cx="411520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1448" y="6356354"/>
            <a:ext cx="27434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486C2-D5B9-44C6-906C-F070823DA52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0.xml"/><Relationship Id="rId4" Type="http://schemas.openxmlformats.org/officeDocument/2006/relationships/image" Target="../media/image3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1.xml"/><Relationship Id="rId4" Type="http://schemas.openxmlformats.org/officeDocument/2006/relationships/image" Target="../media/image3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2.xml"/><Relationship Id="rId4" Type="http://schemas.openxmlformats.org/officeDocument/2006/relationships/image" Target="../media/image37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3.xml"/><Relationship Id="rId4" Type="http://schemas.openxmlformats.org/officeDocument/2006/relationships/image" Target="../media/image3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4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5.xml"/><Relationship Id="rId4" Type="http://schemas.openxmlformats.org/officeDocument/2006/relationships/image" Target="../media/image46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6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7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8.xml"/><Relationship Id="rId6" Type="http://schemas.openxmlformats.org/officeDocument/2006/relationships/image" Target="../media/image57.png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Relationship Id="rId4" Type="http://schemas.openxmlformats.org/officeDocument/2006/relationships/image" Target="../media/image4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9.xml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0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1.xml"/><Relationship Id="rId5" Type="http://schemas.openxmlformats.org/officeDocument/2006/relationships/image" Target="../media/image68.png"/><Relationship Id="rId4" Type="http://schemas.openxmlformats.org/officeDocument/2006/relationships/image" Target="../media/image67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2.xml"/><Relationship Id="rId4" Type="http://schemas.openxmlformats.org/officeDocument/2006/relationships/image" Target="../media/image70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3.xml"/><Relationship Id="rId5" Type="http://schemas.openxmlformats.org/officeDocument/2006/relationships/image" Target="../media/image73.png"/><Relationship Id="rId4" Type="http://schemas.openxmlformats.org/officeDocument/2006/relationships/image" Target="../media/image72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4.xml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5.xml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6.xml"/><Relationship Id="rId4" Type="http://schemas.openxmlformats.org/officeDocument/2006/relationships/image" Target="../media/image81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7.xml"/><Relationship Id="rId4" Type="http://schemas.openxmlformats.org/officeDocument/2006/relationships/image" Target="../media/image83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8.xml"/><Relationship Id="rId5" Type="http://schemas.openxmlformats.org/officeDocument/2006/relationships/image" Target="../media/image86.png"/><Relationship Id="rId4" Type="http://schemas.openxmlformats.org/officeDocument/2006/relationships/image" Target="../media/image8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Relationship Id="rId4" Type="http://schemas.openxmlformats.org/officeDocument/2006/relationships/image" Target="../media/image6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9.xml"/><Relationship Id="rId5" Type="http://schemas.openxmlformats.org/officeDocument/2006/relationships/image" Target="../media/image89.png"/><Relationship Id="rId4" Type="http://schemas.openxmlformats.org/officeDocument/2006/relationships/image" Target="../media/image88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0.xml"/><Relationship Id="rId5" Type="http://schemas.openxmlformats.org/officeDocument/2006/relationships/image" Target="../media/image92.png"/><Relationship Id="rId4" Type="http://schemas.openxmlformats.org/officeDocument/2006/relationships/image" Target="../media/image91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1.xml"/><Relationship Id="rId4" Type="http://schemas.openxmlformats.org/officeDocument/2006/relationships/image" Target="../media/image94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2.xml"/><Relationship Id="rId4" Type="http://schemas.openxmlformats.org/officeDocument/2006/relationships/image" Target="../media/image96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3.xml"/><Relationship Id="rId4" Type="http://schemas.openxmlformats.org/officeDocument/2006/relationships/image" Target="../media/image98.png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4.xml"/><Relationship Id="rId4" Type="http://schemas.openxmlformats.org/officeDocument/2006/relationships/image" Target="../media/image100.png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5.xml"/><Relationship Id="rId4" Type="http://schemas.openxmlformats.org/officeDocument/2006/relationships/image" Target="../media/image102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6.xml"/><Relationship Id="rId4" Type="http://schemas.openxmlformats.org/officeDocument/2006/relationships/image" Target="../media/image104.pn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7.xml"/><Relationship Id="rId4" Type="http://schemas.openxmlformats.org/officeDocument/2006/relationships/image" Target="../media/image106.pn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8.xml"/><Relationship Id="rId4" Type="http://schemas.openxmlformats.org/officeDocument/2006/relationships/image" Target="../media/image10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Relationship Id="rId4" Type="http://schemas.openxmlformats.org/officeDocument/2006/relationships/image" Target="../media/image8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9.xml"/><Relationship Id="rId4" Type="http://schemas.openxmlformats.org/officeDocument/2006/relationships/image" Target="../media/image110.png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0.xml"/><Relationship Id="rId5" Type="http://schemas.openxmlformats.org/officeDocument/2006/relationships/image" Target="../media/image113.png"/><Relationship Id="rId4" Type="http://schemas.openxmlformats.org/officeDocument/2006/relationships/image" Target="../media/image112.pn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1.xml"/><Relationship Id="rId5" Type="http://schemas.openxmlformats.org/officeDocument/2006/relationships/image" Target="../media/image116.png"/><Relationship Id="rId4" Type="http://schemas.openxmlformats.org/officeDocument/2006/relationships/image" Target="../media/image115.png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2.xml"/><Relationship Id="rId6" Type="http://schemas.openxmlformats.org/officeDocument/2006/relationships/image" Target="../media/image120.png"/><Relationship Id="rId5" Type="http://schemas.openxmlformats.org/officeDocument/2006/relationships/image" Target="../media/image119.png"/><Relationship Id="rId4" Type="http://schemas.openxmlformats.org/officeDocument/2006/relationships/image" Target="../media/image118.png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3.xml"/><Relationship Id="rId6" Type="http://schemas.openxmlformats.org/officeDocument/2006/relationships/image" Target="../media/image124.png"/><Relationship Id="rId5" Type="http://schemas.openxmlformats.org/officeDocument/2006/relationships/image" Target="../media/image123.png"/><Relationship Id="rId4" Type="http://schemas.openxmlformats.org/officeDocument/2006/relationships/image" Target="../media/image122.png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4.xml"/><Relationship Id="rId5" Type="http://schemas.openxmlformats.org/officeDocument/2006/relationships/image" Target="../media/image127.png"/><Relationship Id="rId4" Type="http://schemas.openxmlformats.org/officeDocument/2006/relationships/image" Target="../media/image126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5.xml"/><Relationship Id="rId5" Type="http://schemas.openxmlformats.org/officeDocument/2006/relationships/image" Target="../media/image130.png"/><Relationship Id="rId4" Type="http://schemas.openxmlformats.org/officeDocument/2006/relationships/image" Target="../media/image129.png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6.xml"/><Relationship Id="rId5" Type="http://schemas.openxmlformats.org/officeDocument/2006/relationships/image" Target="../media/image133.png"/><Relationship Id="rId4" Type="http://schemas.openxmlformats.org/officeDocument/2006/relationships/image" Target="../media/image132.png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7.xml"/><Relationship Id="rId5" Type="http://schemas.openxmlformats.org/officeDocument/2006/relationships/image" Target="../media/image135.png"/><Relationship Id="rId4" Type="http://schemas.openxmlformats.org/officeDocument/2006/relationships/image" Target="../media/image134.png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8.xml"/><Relationship Id="rId5" Type="http://schemas.openxmlformats.org/officeDocument/2006/relationships/image" Target="../media/image137.png"/><Relationship Id="rId4" Type="http://schemas.openxmlformats.org/officeDocument/2006/relationships/image" Target="../media/image13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9.xml"/><Relationship Id="rId5" Type="http://schemas.openxmlformats.org/officeDocument/2006/relationships/image" Target="../media/image139.png"/><Relationship Id="rId4" Type="http://schemas.openxmlformats.org/officeDocument/2006/relationships/image" Target="../media/image138.png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0.xml"/><Relationship Id="rId5" Type="http://schemas.openxmlformats.org/officeDocument/2006/relationships/image" Target="../media/image141.png"/><Relationship Id="rId4" Type="http://schemas.openxmlformats.org/officeDocument/2006/relationships/image" Target="../media/image140.png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1.xml"/><Relationship Id="rId5" Type="http://schemas.openxmlformats.org/officeDocument/2006/relationships/image" Target="../media/image143.png"/><Relationship Id="rId4" Type="http://schemas.openxmlformats.org/officeDocument/2006/relationships/image" Target="../media/image142.png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2.xml"/><Relationship Id="rId5" Type="http://schemas.openxmlformats.org/officeDocument/2006/relationships/image" Target="../media/image145.png"/><Relationship Id="rId4" Type="http://schemas.openxmlformats.org/officeDocument/2006/relationships/image" Target="../media/image144.png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3.xml"/><Relationship Id="rId6" Type="http://schemas.openxmlformats.org/officeDocument/2006/relationships/image" Target="../media/image148.png"/><Relationship Id="rId5" Type="http://schemas.openxmlformats.org/officeDocument/2006/relationships/image" Target="../media/image147.png"/><Relationship Id="rId4" Type="http://schemas.openxmlformats.org/officeDocument/2006/relationships/image" Target="../media/image146.png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4.xml"/><Relationship Id="rId6" Type="http://schemas.openxmlformats.org/officeDocument/2006/relationships/image" Target="../media/image151.png"/><Relationship Id="rId5" Type="http://schemas.openxmlformats.org/officeDocument/2006/relationships/image" Target="../media/image150.png"/><Relationship Id="rId4" Type="http://schemas.openxmlformats.org/officeDocument/2006/relationships/image" Target="../media/image149.png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5.xml"/><Relationship Id="rId6" Type="http://schemas.openxmlformats.org/officeDocument/2006/relationships/image" Target="../media/image154.png"/><Relationship Id="rId5" Type="http://schemas.openxmlformats.org/officeDocument/2006/relationships/image" Target="../media/image153.png"/><Relationship Id="rId4" Type="http://schemas.openxmlformats.org/officeDocument/2006/relationships/image" Target="../media/image152.png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6.xml"/><Relationship Id="rId6" Type="http://schemas.openxmlformats.org/officeDocument/2006/relationships/image" Target="../media/image157.png"/><Relationship Id="rId5" Type="http://schemas.openxmlformats.org/officeDocument/2006/relationships/image" Target="../media/image156.png"/><Relationship Id="rId4" Type="http://schemas.openxmlformats.org/officeDocument/2006/relationships/image" Target="../media/image155.png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7.xml"/><Relationship Id="rId5" Type="http://schemas.openxmlformats.org/officeDocument/2006/relationships/image" Target="../media/image159.png"/><Relationship Id="rId4" Type="http://schemas.openxmlformats.org/officeDocument/2006/relationships/image" Target="../media/image158.png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8.xml"/><Relationship Id="rId6" Type="http://schemas.openxmlformats.org/officeDocument/2006/relationships/image" Target="../media/image162.png"/><Relationship Id="rId5" Type="http://schemas.openxmlformats.org/officeDocument/2006/relationships/image" Target="../media/image161.png"/><Relationship Id="rId4" Type="http://schemas.openxmlformats.org/officeDocument/2006/relationships/image" Target="../media/image16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3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9.xml"/><Relationship Id="rId6" Type="http://schemas.openxmlformats.org/officeDocument/2006/relationships/image" Target="../media/image165.png"/><Relationship Id="rId5" Type="http://schemas.openxmlformats.org/officeDocument/2006/relationships/image" Target="../media/image164.png"/><Relationship Id="rId4" Type="http://schemas.openxmlformats.org/officeDocument/2006/relationships/image" Target="../media/image163.png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4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0.xml"/><Relationship Id="rId5" Type="http://schemas.openxmlformats.org/officeDocument/2006/relationships/image" Target="../media/image167.png"/><Relationship Id="rId4" Type="http://schemas.openxmlformats.org/officeDocument/2006/relationships/image" Target="../media/image166.png"/></Relationships>
</file>

<file path=ppt/slides/_rels/slide6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5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1.xml"/><Relationship Id="rId6" Type="http://schemas.openxmlformats.org/officeDocument/2006/relationships/image" Target="../media/image170.png"/><Relationship Id="rId5" Type="http://schemas.openxmlformats.org/officeDocument/2006/relationships/image" Target="../media/image169.png"/><Relationship Id="rId4" Type="http://schemas.openxmlformats.org/officeDocument/2006/relationships/image" Target="../media/image168.png"/></Relationships>
</file>

<file path=ppt/slides/_rels/slide6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6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2.xml"/><Relationship Id="rId6" Type="http://schemas.openxmlformats.org/officeDocument/2006/relationships/image" Target="../media/image173.png"/><Relationship Id="rId5" Type="http://schemas.openxmlformats.org/officeDocument/2006/relationships/image" Target="../media/image172.png"/><Relationship Id="rId4" Type="http://schemas.openxmlformats.org/officeDocument/2006/relationships/image" Target="../media/image171.png"/></Relationships>
</file>

<file path=ppt/slides/_rels/slide6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7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3.xml"/><Relationship Id="rId6" Type="http://schemas.openxmlformats.org/officeDocument/2006/relationships/image" Target="../media/image176.png"/><Relationship Id="rId5" Type="http://schemas.openxmlformats.org/officeDocument/2006/relationships/image" Target="../media/image175.png"/><Relationship Id="rId4" Type="http://schemas.openxmlformats.org/officeDocument/2006/relationships/image" Target="../media/image174.png"/></Relationships>
</file>

<file path=ppt/slides/_rels/slide6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8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Relationship Id="rId6" Type="http://schemas.openxmlformats.org/officeDocument/2006/relationships/image" Target="../media/image179.png"/><Relationship Id="rId5" Type="http://schemas.openxmlformats.org/officeDocument/2006/relationships/image" Target="../media/image178.png"/><Relationship Id="rId4" Type="http://schemas.openxmlformats.org/officeDocument/2006/relationships/image" Target="../media/image177.png"/></Relationships>
</file>

<file path=ppt/slides/_rels/slide6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9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5.xml"/><Relationship Id="rId6" Type="http://schemas.openxmlformats.org/officeDocument/2006/relationships/image" Target="../media/image182.png"/><Relationship Id="rId5" Type="http://schemas.openxmlformats.org/officeDocument/2006/relationships/image" Target="../media/image181.png"/><Relationship Id="rId4" Type="http://schemas.openxmlformats.org/officeDocument/2006/relationships/image" Target="../media/image180.png"/></Relationships>
</file>

<file path=ppt/slides/_rels/slide6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0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6.xml"/><Relationship Id="rId5" Type="http://schemas.openxmlformats.org/officeDocument/2006/relationships/image" Target="../media/image184.png"/><Relationship Id="rId4" Type="http://schemas.openxmlformats.org/officeDocument/2006/relationships/image" Target="../media/image183.png"/></Relationships>
</file>

<file path=ppt/slides/_rels/slide6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7.xml"/><Relationship Id="rId6" Type="http://schemas.openxmlformats.org/officeDocument/2006/relationships/image" Target="../media/image187.png"/><Relationship Id="rId5" Type="http://schemas.openxmlformats.org/officeDocument/2006/relationships/image" Target="../media/image186.png"/><Relationship Id="rId4" Type="http://schemas.openxmlformats.org/officeDocument/2006/relationships/image" Target="../media/image185.png"/></Relationships>
</file>

<file path=ppt/slides/_rels/slide6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8.xml"/><Relationship Id="rId5" Type="http://schemas.openxmlformats.org/officeDocument/2006/relationships/image" Target="../media/image189.png"/><Relationship Id="rId4" Type="http://schemas.openxmlformats.org/officeDocument/2006/relationships/image" Target="../media/image18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8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7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3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9.xml"/><Relationship Id="rId6" Type="http://schemas.openxmlformats.org/officeDocument/2006/relationships/image" Target="../media/image192.png"/><Relationship Id="rId5" Type="http://schemas.openxmlformats.org/officeDocument/2006/relationships/image" Target="../media/image191.png"/><Relationship Id="rId4" Type="http://schemas.openxmlformats.org/officeDocument/2006/relationships/image" Target="../media/image190.png"/></Relationships>
</file>

<file path=ppt/slides/_rels/slide7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4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0.xml"/><Relationship Id="rId5" Type="http://schemas.openxmlformats.org/officeDocument/2006/relationships/image" Target="../media/image194.png"/><Relationship Id="rId4" Type="http://schemas.openxmlformats.org/officeDocument/2006/relationships/image" Target="../media/image193.png"/></Relationships>
</file>

<file path=ppt/slides/_rels/slide7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5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1.xml"/><Relationship Id="rId5" Type="http://schemas.openxmlformats.org/officeDocument/2006/relationships/image" Target="../media/image196.png"/><Relationship Id="rId4" Type="http://schemas.openxmlformats.org/officeDocument/2006/relationships/image" Target="../media/image195.png"/></Relationships>
</file>

<file path=ppt/slides/_rels/slide7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6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2.xml"/><Relationship Id="rId5" Type="http://schemas.openxmlformats.org/officeDocument/2006/relationships/image" Target="../media/image198.png"/><Relationship Id="rId4" Type="http://schemas.openxmlformats.org/officeDocument/2006/relationships/image" Target="../media/image197.png"/></Relationships>
</file>

<file path=ppt/slides/_rels/slide7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7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3.xml"/><Relationship Id="rId5" Type="http://schemas.openxmlformats.org/officeDocument/2006/relationships/image" Target="../media/image200.png"/><Relationship Id="rId4" Type="http://schemas.openxmlformats.org/officeDocument/2006/relationships/image" Target="../media/image199.png"/></Relationships>
</file>

<file path=ppt/slides/_rels/slide7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8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4.xml"/><Relationship Id="rId5" Type="http://schemas.openxmlformats.org/officeDocument/2006/relationships/image" Target="../media/image202.png"/><Relationship Id="rId4" Type="http://schemas.openxmlformats.org/officeDocument/2006/relationships/image" Target="../media/image201.png"/></Relationships>
</file>

<file path=ppt/slides/_rels/slide7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9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5.xml"/><Relationship Id="rId5" Type="http://schemas.openxmlformats.org/officeDocument/2006/relationships/image" Target="../media/image204.png"/><Relationship Id="rId4" Type="http://schemas.openxmlformats.org/officeDocument/2006/relationships/image" Target="../media/image203.png"/></Relationships>
</file>

<file path=ppt/slides/_rels/slide7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0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6.xml"/><Relationship Id="rId5" Type="http://schemas.openxmlformats.org/officeDocument/2006/relationships/image" Target="../media/image206.png"/><Relationship Id="rId4" Type="http://schemas.openxmlformats.org/officeDocument/2006/relationships/image" Target="../media/image205.png"/></Relationships>
</file>

<file path=ppt/slides/_rels/slide7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7.xml"/><Relationship Id="rId5" Type="http://schemas.openxmlformats.org/officeDocument/2006/relationships/image" Target="../media/image208.png"/><Relationship Id="rId4" Type="http://schemas.openxmlformats.org/officeDocument/2006/relationships/image" Target="../media/image207.png"/></Relationships>
</file>

<file path=ppt/slides/_rels/slide7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8.xml"/><Relationship Id="rId5" Type="http://schemas.openxmlformats.org/officeDocument/2006/relationships/image" Target="../media/image210.png"/><Relationship Id="rId4" Type="http://schemas.openxmlformats.org/officeDocument/2006/relationships/image" Target="../media/image20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3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9.xml"/><Relationship Id="rId5" Type="http://schemas.openxmlformats.org/officeDocument/2006/relationships/image" Target="../media/image212.png"/><Relationship Id="rId4" Type="http://schemas.openxmlformats.org/officeDocument/2006/relationships/image" Target="../media/image2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9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C0FF6DC-B037-ED1C-C7A4-7166391F7A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6086" y="3272062"/>
            <a:ext cx="2461473" cy="701101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2387" y="1389380"/>
            <a:ext cx="3611880" cy="3093720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2198257" y="101917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2680857" y="100330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Sham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4023882" y="99441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I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2703082" y="133159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105162" y="133159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338467" y="13874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338467" y="17595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338467" y="21736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338467" y="26784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338467" y="33623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1338467" y="40462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7" name="矩形 46"/>
          <p:cNvSpPr/>
          <p:nvPr/>
        </p:nvSpPr>
        <p:spPr>
          <a:xfrm>
            <a:off x="2534440" y="3311207"/>
            <a:ext cx="2960926" cy="296227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534441" y="3723005"/>
            <a:ext cx="2960925" cy="37433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/>
          <p:cNvSpPr txBox="1"/>
          <p:nvPr/>
        </p:nvSpPr>
        <p:spPr>
          <a:xfrm>
            <a:off x="6132082" y="328676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175262" y="38011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0121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4A-1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3D7BD0D-377C-9CF5-6E60-869A3BBF0740}"/>
              </a:ext>
            </a:extLst>
          </p:cNvPr>
          <p:cNvSpPr txBox="1"/>
          <p:nvPr/>
        </p:nvSpPr>
        <p:spPr>
          <a:xfrm>
            <a:off x="9661003" y="36074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LKBH5</a:t>
            </a: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73506CCF-9D03-1354-F78E-F4D85CF0E5AF}"/>
              </a:ext>
            </a:extLst>
          </p:cNvPr>
          <p:cNvSpPr/>
          <p:nvPr/>
        </p:nvSpPr>
        <p:spPr>
          <a:xfrm>
            <a:off x="7196086" y="3625489"/>
            <a:ext cx="2461473" cy="235249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94493C9-F663-290B-BA70-2E5064A7A9B3}"/>
              </a:ext>
            </a:extLst>
          </p:cNvPr>
          <p:cNvSpPr txBox="1"/>
          <p:nvPr/>
        </p:nvSpPr>
        <p:spPr>
          <a:xfrm>
            <a:off x="233849" y="1567691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1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6275" y="1540174"/>
            <a:ext cx="3968127" cy="3457436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94846" y="1207434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2401271" y="1191559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Sham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3972896" y="1182669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I/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2423496" y="1519854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054176" y="1519854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935056" y="16989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935056" y="21923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68707" y="280572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5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5" name="文本框 44"/>
          <p:cNvSpPr txBox="1"/>
          <p:nvPr/>
        </p:nvSpPr>
        <p:spPr>
          <a:xfrm>
            <a:off x="910926" y="363980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962355" y="44402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3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9" name="文本框 48"/>
          <p:cNvSpPr txBox="1"/>
          <p:nvPr/>
        </p:nvSpPr>
        <p:spPr>
          <a:xfrm>
            <a:off x="5808050" y="346245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814402" y="41391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E-1</a:t>
            </a:r>
          </a:p>
        </p:txBody>
      </p:sp>
      <p:sp>
        <p:nvSpPr>
          <p:cNvPr id="47" name="矩形 46"/>
          <p:cNvSpPr/>
          <p:nvPr/>
        </p:nvSpPr>
        <p:spPr>
          <a:xfrm>
            <a:off x="2401271" y="4097954"/>
            <a:ext cx="3413131" cy="3867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401271" y="3446444"/>
            <a:ext cx="3370580" cy="36830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EFC8034-3785-D124-CD56-E36E9C3652E4}"/>
              </a:ext>
            </a:extLst>
          </p:cNvPr>
          <p:cNvSpPr txBox="1"/>
          <p:nvPr/>
        </p:nvSpPr>
        <p:spPr>
          <a:xfrm>
            <a:off x="10206386" y="347869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9DC4031-A938-8F8B-7869-F06BEAE386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10535" y="2805729"/>
            <a:ext cx="2895851" cy="104403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FB9AD4D9-DCD6-0A78-4A1D-D4EFAC04DE52}"/>
              </a:ext>
            </a:extLst>
          </p:cNvPr>
          <p:cNvSpPr/>
          <p:nvPr/>
        </p:nvSpPr>
        <p:spPr>
          <a:xfrm>
            <a:off x="7310535" y="3417104"/>
            <a:ext cx="2863082" cy="36830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CEA9B33-1A33-9D5B-EDFA-5532133F4B25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1929" y="2126615"/>
            <a:ext cx="3733165" cy="31572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67952" y="170116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2374377" y="168529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Sham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3946002" y="167640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I/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2396602" y="201358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027282" y="201358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908162" y="21640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908162" y="26384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08162" y="32975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908162" y="40252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908162" y="48577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3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9" name="文本框 48"/>
          <p:cNvSpPr txBox="1"/>
          <p:nvPr/>
        </p:nvSpPr>
        <p:spPr>
          <a:xfrm>
            <a:off x="5575094" y="400404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575094" y="46863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E-2</a:t>
            </a:r>
          </a:p>
        </p:txBody>
      </p:sp>
      <p:sp>
        <p:nvSpPr>
          <p:cNvPr id="48" name="矩形 47"/>
          <p:cNvSpPr/>
          <p:nvPr/>
        </p:nvSpPr>
        <p:spPr>
          <a:xfrm>
            <a:off x="2134981" y="4605655"/>
            <a:ext cx="3406155" cy="40640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134981" y="3940174"/>
            <a:ext cx="3406155" cy="442596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7401696" y="2916093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00E320D-323F-979C-A419-762C0A123380}"/>
              </a:ext>
            </a:extLst>
          </p:cNvPr>
          <p:cNvSpPr txBox="1"/>
          <p:nvPr/>
        </p:nvSpPr>
        <p:spPr>
          <a:xfrm>
            <a:off x="9361816" y="40389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2B2EFE10-0435-D093-1588-CE3C624A55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01461" y="3456262"/>
            <a:ext cx="2834886" cy="967824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76E785FC-D374-0706-1F28-B41006F22F46}"/>
              </a:ext>
            </a:extLst>
          </p:cNvPr>
          <p:cNvSpPr/>
          <p:nvPr/>
        </p:nvSpPr>
        <p:spPr>
          <a:xfrm>
            <a:off x="6509949" y="4038917"/>
            <a:ext cx="2817910" cy="2451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DC984BB-C01F-3A71-4CE7-91099F75026A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2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6258" y="1709493"/>
            <a:ext cx="3618229" cy="3439013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953073" y="1290393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2462343" y="1275153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ctrl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3986343" y="1266263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H/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2484568" y="1603448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067623" y="1603448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1075503" y="221939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0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1081853" y="27508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7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1072328" y="335414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062803" y="407232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081853" y="470478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3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9" name="文本框 48"/>
          <p:cNvSpPr txBox="1"/>
          <p:nvPr/>
        </p:nvSpPr>
        <p:spPr>
          <a:xfrm>
            <a:off x="5724972" y="38272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638612" y="45313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F-1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075503" y="17952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3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7" name="矩形 46"/>
          <p:cNvSpPr/>
          <p:nvPr/>
        </p:nvSpPr>
        <p:spPr>
          <a:xfrm>
            <a:off x="2484568" y="3758955"/>
            <a:ext cx="3028726" cy="43163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462343" y="4476188"/>
            <a:ext cx="3050951" cy="355453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8EC1B7E-CCE0-FB43-E542-01C4FF1DC71B}"/>
              </a:ext>
            </a:extLst>
          </p:cNvPr>
          <p:cNvSpPr txBox="1"/>
          <p:nvPr/>
        </p:nvSpPr>
        <p:spPr>
          <a:xfrm>
            <a:off x="9348918" y="38328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C9E4EC3-AF51-E89D-AFD8-62C79430DC93}"/>
              </a:ext>
            </a:extLst>
          </p:cNvPr>
          <p:cNvSpPr txBox="1"/>
          <p:nvPr/>
        </p:nvSpPr>
        <p:spPr>
          <a:xfrm>
            <a:off x="7663011" y="2750893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E0F1294B-596E-CA53-DB9C-663F0DDD67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6962" y="3266671"/>
            <a:ext cx="2491956" cy="998307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CB28D4C7-33A3-8400-DD49-C89D093A1BFD}"/>
              </a:ext>
            </a:extLst>
          </p:cNvPr>
          <p:cNvSpPr/>
          <p:nvPr/>
        </p:nvSpPr>
        <p:spPr>
          <a:xfrm>
            <a:off x="6856962" y="3832861"/>
            <a:ext cx="2491956" cy="318787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A10EE4B-B542-BCEE-E30C-7C385CC46E9D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4714" y="1754344"/>
            <a:ext cx="3675577" cy="3349311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517348" y="129730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2095198" y="128143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ctrl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3552523" y="127254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H/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2117423" y="160972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3633803" y="160972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695658" y="17506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14708" y="22631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14708" y="29010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5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5" name="文本框 44"/>
          <p:cNvSpPr txBox="1"/>
          <p:nvPr/>
        </p:nvSpPr>
        <p:spPr>
          <a:xfrm>
            <a:off x="682224" y="37255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688991" y="46050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387673" y="35394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387673" y="43821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F-2</a:t>
            </a:r>
          </a:p>
        </p:txBody>
      </p:sp>
      <p:sp>
        <p:nvSpPr>
          <p:cNvPr id="47" name="矩形 46"/>
          <p:cNvSpPr/>
          <p:nvPr/>
        </p:nvSpPr>
        <p:spPr>
          <a:xfrm>
            <a:off x="1933908" y="3518535"/>
            <a:ext cx="3296384" cy="33845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933908" y="4359910"/>
            <a:ext cx="3296384" cy="3676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294A574-9C5A-1696-4E07-D8CE0429D3A2}"/>
              </a:ext>
            </a:extLst>
          </p:cNvPr>
          <p:cNvSpPr txBox="1"/>
          <p:nvPr/>
        </p:nvSpPr>
        <p:spPr>
          <a:xfrm>
            <a:off x="9230002" y="36620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463D5C5-68CE-5E4F-4176-809E77FE14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47531" y="3173367"/>
            <a:ext cx="2682472" cy="1028789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D9966DB6-7646-C9E5-2A35-ABB3D4550647}"/>
              </a:ext>
            </a:extLst>
          </p:cNvPr>
          <p:cNvSpPr/>
          <p:nvPr/>
        </p:nvSpPr>
        <p:spPr>
          <a:xfrm>
            <a:off x="6547530" y="3632200"/>
            <a:ext cx="2682472" cy="33845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ECE46E5-780E-6E67-3E65-0514E01E37E8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2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2399926" y="1811044"/>
            <a:ext cx="2310130" cy="3388360"/>
            <a:chOff x="13175" y="2785"/>
            <a:chExt cx="2084" cy="3858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/>
            <a:srcRect l="69267" t="4291"/>
            <a:stretch>
              <a:fillRect/>
            </a:stretch>
          </p:blipFill>
          <p:spPr>
            <a:xfrm>
              <a:off x="13175" y="2785"/>
              <a:ext cx="1040" cy="3859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4"/>
            <a:srcRect b="3138"/>
            <a:stretch>
              <a:fillRect/>
            </a:stretch>
          </p:blipFill>
          <p:spPr>
            <a:xfrm>
              <a:off x="14215" y="2785"/>
              <a:ext cx="1044" cy="3859"/>
            </a:xfrm>
            <a:prstGeom prst="rect">
              <a:avLst/>
            </a:prstGeom>
          </p:spPr>
        </p:pic>
      </p:grpSp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85881" y="1442744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964191" y="230570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983241" y="273877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73716" y="32772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964191" y="399544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983241" y="485650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659903" y="37777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659903" y="458588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H-1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976891" y="184850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rcRect t="4291" r="83333"/>
          <a:stretch>
            <a:fillRect/>
          </a:stretch>
        </p:blipFill>
        <p:spPr>
          <a:xfrm>
            <a:off x="1867161" y="1797709"/>
            <a:ext cx="497205" cy="340169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398021" y="4469789"/>
            <a:ext cx="2291132" cy="3867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45645" y="3761764"/>
            <a:ext cx="2264411" cy="34036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2398021" y="1412264"/>
            <a:ext cx="2366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1       2       1       2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9881870" y="292100"/>
            <a:ext cx="20281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si-Foxo1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4501333-C112-B9FF-94F8-FEAF04F0E09A}"/>
              </a:ext>
            </a:extLst>
          </p:cNvPr>
          <p:cNvSpPr txBox="1"/>
          <p:nvPr/>
        </p:nvSpPr>
        <p:spPr>
          <a:xfrm>
            <a:off x="7857259" y="38570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EC63E07-F952-51C2-6FC0-F0ED8796B79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69764" y="3524238"/>
            <a:ext cx="1882303" cy="815411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242BD6F3-8E12-3882-A763-637DC9D1AC80}"/>
              </a:ext>
            </a:extLst>
          </p:cNvPr>
          <p:cNvSpPr/>
          <p:nvPr/>
        </p:nvSpPr>
        <p:spPr>
          <a:xfrm>
            <a:off x="5964572" y="3857013"/>
            <a:ext cx="1882304" cy="213439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C6369A1-7BE6-05E2-74F5-2639ADBA6C30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4653" y="1214120"/>
            <a:ext cx="2898796" cy="4732284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1902423" y="84582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080733" y="21621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099783" y="28003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090258" y="34575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106133" y="44367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1073431" y="540893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3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9" name="文本框 48"/>
          <p:cNvSpPr txBox="1"/>
          <p:nvPr/>
        </p:nvSpPr>
        <p:spPr>
          <a:xfrm>
            <a:off x="4942316" y="41424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942316" y="517372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H-2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093433" y="15754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514563" y="815340"/>
            <a:ext cx="2366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1       2       1       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112483" y="12382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70 kD</a:t>
            </a:r>
          </a:p>
        </p:txBody>
      </p:sp>
      <p:sp>
        <p:nvSpPr>
          <p:cNvPr id="47" name="矩形 46"/>
          <p:cNvSpPr/>
          <p:nvPr/>
        </p:nvSpPr>
        <p:spPr>
          <a:xfrm>
            <a:off x="2421218" y="4087495"/>
            <a:ext cx="2442231" cy="32448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507578" y="4999356"/>
            <a:ext cx="2372995" cy="50419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613C7DA-CEE2-3D98-850D-CA1A8D314B70}"/>
              </a:ext>
            </a:extLst>
          </p:cNvPr>
          <p:cNvSpPr txBox="1"/>
          <p:nvPr/>
        </p:nvSpPr>
        <p:spPr>
          <a:xfrm>
            <a:off x="7901716" y="40874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49EAF0E-C8FD-3298-C65C-6F31A2E051F6}"/>
              </a:ext>
            </a:extLst>
          </p:cNvPr>
          <p:cNvSpPr txBox="1"/>
          <p:nvPr/>
        </p:nvSpPr>
        <p:spPr>
          <a:xfrm>
            <a:off x="9881870" y="292100"/>
            <a:ext cx="20281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si-Foxo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F27079E-4041-3438-8651-5D180CB34C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05103" y="3433482"/>
            <a:ext cx="1996613" cy="1181202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E22E3A5C-3D33-93F1-D508-9D1890D7C546}"/>
              </a:ext>
            </a:extLst>
          </p:cNvPr>
          <p:cNvSpPr/>
          <p:nvPr/>
        </p:nvSpPr>
        <p:spPr>
          <a:xfrm>
            <a:off x="5954505" y="4024083"/>
            <a:ext cx="1947211" cy="32448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6EF01E8-28CC-9379-0947-2696DC4EB86D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2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8AB3435-0EEF-B0F5-6F3E-2C5886494F2D}"/>
              </a:ext>
            </a:extLst>
          </p:cNvPr>
          <p:cNvSpPr txBox="1"/>
          <p:nvPr/>
        </p:nvSpPr>
        <p:spPr>
          <a:xfrm>
            <a:off x="6410902" y="2922905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l="41168" r="2225"/>
          <a:stretch>
            <a:fillRect/>
          </a:stretch>
        </p:blipFill>
        <p:spPr>
          <a:xfrm>
            <a:off x="2653479" y="1746063"/>
            <a:ext cx="2084070" cy="39319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884494" y="1377763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062804" y="26941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081854" y="33322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072329" y="378441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062804" y="456736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081854" y="541763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698179" y="426518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743003" y="524166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H-3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075504" y="210737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496634" y="1347283"/>
            <a:ext cx="2366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1       2       1       2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9881870" y="292100"/>
            <a:ext cx="20281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Foxo1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094554" y="17701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70 kD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rcRect r="86775"/>
          <a:stretch>
            <a:fillRect/>
          </a:stretch>
        </p:blipFill>
        <p:spPr>
          <a:xfrm>
            <a:off x="1965774" y="1770193"/>
            <a:ext cx="483235" cy="390715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653479" y="4234628"/>
            <a:ext cx="2044700" cy="34036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653479" y="5033458"/>
            <a:ext cx="2044700" cy="4978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E6D433A-AE8E-612D-E859-A5698A947B2B}"/>
              </a:ext>
            </a:extLst>
          </p:cNvPr>
          <p:cNvSpPr txBox="1"/>
          <p:nvPr/>
        </p:nvSpPr>
        <p:spPr>
          <a:xfrm>
            <a:off x="7510258" y="423462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EA0A279B-FF18-9596-912A-B9663AFAB6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80368" y="3849014"/>
            <a:ext cx="1729890" cy="662997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F4D979DD-A89B-764D-586B-A7F626260C5E}"/>
              </a:ext>
            </a:extLst>
          </p:cNvPr>
          <p:cNvSpPr/>
          <p:nvPr/>
        </p:nvSpPr>
        <p:spPr>
          <a:xfrm>
            <a:off x="5780368" y="4234627"/>
            <a:ext cx="1729890" cy="258677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2446183-888C-D950-33B2-966702159271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3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rcRect l="9790" t="716"/>
          <a:stretch>
            <a:fillRect/>
          </a:stretch>
        </p:blipFill>
        <p:spPr>
          <a:xfrm>
            <a:off x="5097780" y="1853304"/>
            <a:ext cx="3190875" cy="421640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4546600" y="1566284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3724910" y="263435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3743960" y="32617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3734435" y="372464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724910" y="46587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743960" y="560615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8320031" y="44067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8320031" y="534119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M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3737610" y="212317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5116830" y="1535804"/>
            <a:ext cx="31718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2      3        1      2      3     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9152890" y="635"/>
            <a:ext cx="3038475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Foxo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si-Foxo1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3756660" y="18615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70 kD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r="87249"/>
          <a:stretch>
            <a:fillRect/>
          </a:stretch>
        </p:blipFill>
        <p:spPr>
          <a:xfrm>
            <a:off x="4579620" y="1853304"/>
            <a:ext cx="450850" cy="421449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5097780" y="4342467"/>
            <a:ext cx="3190876" cy="413422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5590" y="1853304"/>
            <a:ext cx="3579495" cy="421005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86360" y="5221979"/>
            <a:ext cx="8202295" cy="4978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C18EF3C-A6D8-4454-6EDA-CEDC69F129FB}"/>
              </a:ext>
            </a:extLst>
          </p:cNvPr>
          <p:cNvSpPr txBox="1"/>
          <p:nvPr/>
        </p:nvSpPr>
        <p:spPr>
          <a:xfrm>
            <a:off x="11074663" y="336238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2F76C36-32C6-B3B6-BE8F-D6311A105CB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68397" y="2710761"/>
            <a:ext cx="2606266" cy="1066892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85AE63DC-58CF-5418-EAAC-A4B4F3B8DDA0}"/>
              </a:ext>
            </a:extLst>
          </p:cNvPr>
          <p:cNvSpPr/>
          <p:nvPr/>
        </p:nvSpPr>
        <p:spPr>
          <a:xfrm>
            <a:off x="8478221" y="3261734"/>
            <a:ext cx="2606266" cy="30735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B00EB47-46BE-BB1B-A005-F74022E27786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.2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b="2472"/>
          <a:stretch>
            <a:fillRect/>
          </a:stretch>
        </p:blipFill>
        <p:spPr>
          <a:xfrm>
            <a:off x="3713714" y="1811020"/>
            <a:ext cx="1651000" cy="38576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590274" y="135382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682224" y="25298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01274" y="30441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691749" y="35356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82224" y="43065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701274" y="52571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329154" y="40730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329154" y="50120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M-3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738229" y="1338580"/>
            <a:ext cx="17735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  1      2      3      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9152890" y="635"/>
            <a:ext cx="3038475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Foxo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si-Foxo1+si-circDhx32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3614" y="1818640"/>
            <a:ext cx="1867535" cy="385000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643615" y="3940175"/>
            <a:ext cx="3721100" cy="42037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999129" y="4876165"/>
            <a:ext cx="3365585" cy="4978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682224" y="21482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01274" y="18503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70 kD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3555599" y="1338580"/>
            <a:ext cx="17735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  1      2      3      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E2A3223-E8DA-263B-69E9-99B2D1ECD4CE}"/>
              </a:ext>
            </a:extLst>
          </p:cNvPr>
          <p:cNvSpPr txBox="1"/>
          <p:nvPr/>
        </p:nvSpPr>
        <p:spPr>
          <a:xfrm>
            <a:off x="7888958" y="40278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69AAC7F4-A176-B6EE-A958-02EB070EC8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17239" y="3583232"/>
            <a:ext cx="1371719" cy="845893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2A818121-485C-EF83-1546-7000552074A4}"/>
              </a:ext>
            </a:extLst>
          </p:cNvPr>
          <p:cNvSpPr/>
          <p:nvPr/>
        </p:nvSpPr>
        <p:spPr>
          <a:xfrm>
            <a:off x="6517239" y="4027804"/>
            <a:ext cx="1371719" cy="2787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8B1286B-5C02-77A2-050F-C45CA4A4D0EF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3</a:t>
            </a: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91955" y="1689100"/>
            <a:ext cx="1906905" cy="3691255"/>
          </a:xfrm>
          <a:prstGeom prst="rect">
            <a:avLst/>
          </a:prstGeom>
        </p:spPr>
      </p:pic>
      <p:grpSp>
        <p:nvGrpSpPr>
          <p:cNvPr id="26" name="组合 25"/>
          <p:cNvGrpSpPr/>
          <p:nvPr/>
        </p:nvGrpSpPr>
        <p:grpSpPr>
          <a:xfrm>
            <a:off x="-99695" y="1394460"/>
            <a:ext cx="6075792" cy="4069080"/>
            <a:chOff x="5885815" y="1293495"/>
            <a:chExt cx="6075792" cy="4069080"/>
          </a:xfrm>
        </p:grpSpPr>
        <p:pic>
          <p:nvPicPr>
            <p:cNvPr id="42" name="图片 41"/>
            <p:cNvPicPr>
              <a:picLocks noChangeAspect="1"/>
            </p:cNvPicPr>
            <p:nvPr/>
          </p:nvPicPr>
          <p:blipFill>
            <a:blip r:embed="rId4"/>
            <a:srcRect t="2748" b="8937"/>
            <a:stretch>
              <a:fillRect/>
            </a:stretch>
          </p:blipFill>
          <p:spPr>
            <a:xfrm>
              <a:off x="9332595" y="1647825"/>
              <a:ext cx="1729740" cy="3714750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/>
          </p:nvSpPr>
          <p:spPr>
            <a:xfrm>
              <a:off x="6707505" y="1323975"/>
              <a:ext cx="50927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/>
                <a:t>M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5885815" y="2421890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100 kD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5904865" y="2963545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70 kD</a:t>
              </a: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5895340" y="3514725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55 kD</a:t>
              </a: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5885815" y="4340860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40 kD</a:t>
              </a: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5904865" y="5033010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35 kD</a:t>
              </a: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1062335" y="3956050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/>
                <a:t>AdipoR1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1077687" y="4721113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/>
                <a:t>GAPDH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5898515" y="1934845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130 kD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7319645" y="1293495"/>
              <a:ext cx="297243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  1      2      3      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5917565" y="1673225"/>
              <a:ext cx="883920" cy="245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170 kD</a:t>
              </a:r>
            </a:p>
          </p:txBody>
        </p:sp>
        <p:pic>
          <p:nvPicPr>
            <p:cNvPr id="39" name="图片 38"/>
            <p:cNvPicPr>
              <a:picLocks noChangeAspect="1"/>
            </p:cNvPicPr>
            <p:nvPr/>
          </p:nvPicPr>
          <p:blipFill>
            <a:blip r:embed="rId5"/>
            <a:srcRect t="2490" b="6474"/>
            <a:stretch>
              <a:fillRect/>
            </a:stretch>
          </p:blipFill>
          <p:spPr>
            <a:xfrm>
              <a:off x="6778625" y="1647825"/>
              <a:ext cx="2374265" cy="3714750"/>
            </a:xfrm>
            <a:prstGeom prst="rect">
              <a:avLst/>
            </a:prstGeom>
          </p:spPr>
        </p:pic>
        <p:sp>
          <p:nvSpPr>
            <p:cNvPr id="44" name="矩形 43"/>
            <p:cNvSpPr/>
            <p:nvPr/>
          </p:nvSpPr>
          <p:spPr>
            <a:xfrm>
              <a:off x="7211695" y="3881755"/>
              <a:ext cx="3850640" cy="4635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矩形 51"/>
            <p:cNvSpPr/>
            <p:nvPr/>
          </p:nvSpPr>
          <p:spPr>
            <a:xfrm>
              <a:off x="7249795" y="4680585"/>
              <a:ext cx="3812540" cy="4762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6707505" y="132397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5885815" y="20574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5904865" y="25012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895340" y="35039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885815" y="41681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5904865" y="49860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1240770" y="38601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1259186" y="46589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M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5898515" y="17513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7470775" y="1293495"/>
            <a:ext cx="2972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2      3      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9152890" y="635"/>
            <a:ext cx="3038475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Foxo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si-Foxo1+si-circDhx32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6"/>
          <a:srcRect r="89374"/>
          <a:stretch>
            <a:fillRect/>
          </a:stretch>
        </p:blipFill>
        <p:spPr>
          <a:xfrm>
            <a:off x="6769735" y="1689100"/>
            <a:ext cx="447040" cy="368681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/>
          <a:srcRect l="55864"/>
          <a:stretch>
            <a:fillRect/>
          </a:stretch>
        </p:blipFill>
        <p:spPr>
          <a:xfrm>
            <a:off x="7410450" y="1689100"/>
            <a:ext cx="1856740" cy="368681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7410451" y="3857625"/>
            <a:ext cx="3788410" cy="32194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7470775" y="4652010"/>
            <a:ext cx="3728086" cy="43434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C68FE07-340B-2324-5F08-315BCD951B09}"/>
              </a:ext>
            </a:extLst>
          </p:cNvPr>
          <p:cNvSpPr txBox="1"/>
          <p:nvPr/>
        </p:nvSpPr>
        <p:spPr>
          <a:xfrm>
            <a:off x="9334818" y="60896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D323385-AA56-9420-119B-096F9B59BBB2}"/>
              </a:ext>
            </a:extLst>
          </p:cNvPr>
          <p:cNvSpPr txBox="1"/>
          <p:nvPr/>
        </p:nvSpPr>
        <p:spPr>
          <a:xfrm>
            <a:off x="4703563" y="592169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F308335-F568-C59E-04AF-AF6CFF27CD4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47085" y="5589573"/>
            <a:ext cx="1356478" cy="76206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3479754-F690-61EC-BB91-461613B7739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71972" y="5456062"/>
            <a:ext cx="1432684" cy="1028789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55AF4E4A-ACD2-8E9B-01B0-0713AF509DB8}"/>
              </a:ext>
            </a:extLst>
          </p:cNvPr>
          <p:cNvSpPr/>
          <p:nvPr/>
        </p:nvSpPr>
        <p:spPr>
          <a:xfrm>
            <a:off x="7871972" y="6037057"/>
            <a:ext cx="1419983" cy="32194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FECDD017-6859-118F-26D7-9F179B082F89}"/>
              </a:ext>
            </a:extLst>
          </p:cNvPr>
          <p:cNvSpPr/>
          <p:nvPr/>
        </p:nvSpPr>
        <p:spPr>
          <a:xfrm>
            <a:off x="3338830" y="5921692"/>
            <a:ext cx="1334571" cy="28225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7F0E1AD-90B6-27F0-C676-2D44157C3D90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4.5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599851" y="992281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3082451" y="976406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Sham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4425476" y="967516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I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3104676" y="1304701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506756" y="1304701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740061" y="139614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740061" y="177714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740061" y="220005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740061" y="265153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740061" y="333543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1740061" y="401932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151434" y="321185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151434" y="376691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381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4A-2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7801" y="1358041"/>
            <a:ext cx="3436620" cy="297180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3082451" y="3222719"/>
            <a:ext cx="2914937" cy="291782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985247" y="3696111"/>
            <a:ext cx="3110753" cy="3867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9D747F8-45EB-D46E-E16B-302B67640721}"/>
              </a:ext>
            </a:extLst>
          </p:cNvPr>
          <p:cNvSpPr txBox="1"/>
          <p:nvPr/>
        </p:nvSpPr>
        <p:spPr>
          <a:xfrm>
            <a:off x="10229737" y="335440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LKBH5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60A69B2-532E-D8AC-47C4-C7FB51633F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99678" y="3131794"/>
            <a:ext cx="2530059" cy="594412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A8181AEC-1151-225C-8D9D-B72A9BBB311C}"/>
              </a:ext>
            </a:extLst>
          </p:cNvPr>
          <p:cNvSpPr/>
          <p:nvPr/>
        </p:nvSpPr>
        <p:spPr>
          <a:xfrm>
            <a:off x="7699678" y="3382421"/>
            <a:ext cx="2530059" cy="24511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80B09E7-B70C-DA80-16F9-F45BCAB656F7}"/>
              </a:ext>
            </a:extLst>
          </p:cNvPr>
          <p:cNvSpPr txBox="1"/>
          <p:nvPr/>
        </p:nvSpPr>
        <p:spPr>
          <a:xfrm>
            <a:off x="395380" y="855244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2</a:t>
            </a: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2218" y="1676400"/>
            <a:ext cx="2201545" cy="41148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8843" y="1674495"/>
            <a:ext cx="1739900" cy="40843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497493" y="23183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516543" y="27082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07018" y="35490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497493" y="43859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516543" y="54305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444106" y="42386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444106" y="515822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O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510193" y="19475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472853" y="1338580"/>
            <a:ext cx="38411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1      2        3      </a:t>
            </a:r>
            <a:r>
              <a:rPr lang="en-US" altLang="zh-CN" b="1"/>
              <a:t>M </a:t>
            </a:r>
            <a:r>
              <a:rPr lang="en-US" altLang="zh-CN"/>
              <a:t>    1       2      3     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oe-Foxo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3</a:t>
            </a:r>
            <a:r>
              <a:rPr lang="zh-CN" altLang="en-US" b="1" dirty="0"/>
              <a:t>：</a:t>
            </a:r>
            <a:r>
              <a:rPr lang="en-US" altLang="zh-CN" b="1" dirty="0"/>
              <a:t>oe-Foxo1+oe-circDhx32</a:t>
            </a:r>
          </a:p>
        </p:txBody>
      </p:sp>
      <p:sp>
        <p:nvSpPr>
          <p:cNvPr id="47" name="矩形 46"/>
          <p:cNvSpPr/>
          <p:nvPr/>
        </p:nvSpPr>
        <p:spPr>
          <a:xfrm>
            <a:off x="1472218" y="4166870"/>
            <a:ext cx="3946525" cy="38862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472218" y="4928870"/>
            <a:ext cx="3946525" cy="59372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7453295" y="3222088"/>
            <a:ext cx="107707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19A1EFA-CE01-8E78-ED91-3AB3F56694BC}"/>
              </a:ext>
            </a:extLst>
          </p:cNvPr>
          <p:cNvSpPr txBox="1"/>
          <p:nvPr/>
        </p:nvSpPr>
        <p:spPr>
          <a:xfrm>
            <a:off x="9630273" y="44708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E218AE7-D8E9-7597-F1D5-98472447EA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53389" y="3848688"/>
            <a:ext cx="3276884" cy="1074513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940C56ED-A827-91C5-8FBE-DD69C0FECEC9}"/>
              </a:ext>
            </a:extLst>
          </p:cNvPr>
          <p:cNvSpPr/>
          <p:nvPr/>
        </p:nvSpPr>
        <p:spPr>
          <a:xfrm>
            <a:off x="6450730" y="4365289"/>
            <a:ext cx="3179543" cy="38862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530491D-F396-C54C-9923-55B1A66E557C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.2</a:t>
            </a: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39765" y="1689100"/>
            <a:ext cx="3507105" cy="394017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346200" y="135128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394970" y="21494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414020" y="26257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404495" y="35096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94970" y="44437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414020" y="52076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9314180" y="41036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9284335" y="486964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O-3</a:t>
            </a:r>
            <a:r>
              <a:rPr lang="zh-CN" altLang="en-US" dirty="0"/>
              <a:t>、</a:t>
            </a:r>
            <a:r>
              <a:rPr lang="en-US" altLang="zh-CN" dirty="0"/>
              <a:t>4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407670" y="18434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58340" y="1320800"/>
            <a:ext cx="3641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2        3        1       2       3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oe-Foxo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3</a:t>
            </a:r>
            <a:r>
              <a:rPr lang="zh-CN" altLang="en-US" b="1" dirty="0"/>
              <a:t>：</a:t>
            </a:r>
            <a:r>
              <a:rPr lang="en-US" altLang="zh-CN" b="1" dirty="0"/>
              <a:t>oe-Foxo1+oe-circDhx32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10640" y="1692275"/>
            <a:ext cx="4289425" cy="394462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855470" y="3977005"/>
            <a:ext cx="7283824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790065" y="4766310"/>
            <a:ext cx="745680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EB12983-C45C-C0F5-AD17-134C9AD583DD}"/>
              </a:ext>
            </a:extLst>
          </p:cNvPr>
          <p:cNvSpPr txBox="1"/>
          <p:nvPr/>
        </p:nvSpPr>
        <p:spPr>
          <a:xfrm>
            <a:off x="8995858" y="61804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AE34985B-22A6-7CCE-7EF3-B0852031A6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4926" y="5731421"/>
            <a:ext cx="2796782" cy="1028789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54C66421-0FED-8DD5-B5E4-0F7FE5B0C780}"/>
              </a:ext>
            </a:extLst>
          </p:cNvPr>
          <p:cNvSpPr/>
          <p:nvPr/>
        </p:nvSpPr>
        <p:spPr>
          <a:xfrm>
            <a:off x="6167717" y="6218498"/>
            <a:ext cx="2716941" cy="31677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706BB67-7024-228B-B751-FC590265EA63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3.4</a:t>
            </a: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t="4141"/>
          <a:stretch>
            <a:fillRect/>
          </a:stretch>
        </p:blipFill>
        <p:spPr>
          <a:xfrm>
            <a:off x="5147870" y="1457325"/>
            <a:ext cx="3696970" cy="391033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640928" y="626141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956870" y="108902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56770" y="18872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75820" y="23418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66295" y="32797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56770" y="41814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75820" y="49453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8844840" y="379710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8844840" y="456358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O-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69470" y="155956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569010" y="1058545"/>
            <a:ext cx="3641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2        3        1       2       3     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7520" y="1457325"/>
            <a:ext cx="3957320" cy="394335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569010" y="3696335"/>
            <a:ext cx="7226300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569010" y="4460875"/>
            <a:ext cx="722630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4B3A192-A4DF-38A0-ECED-FADA4FA2FF94}"/>
              </a:ext>
            </a:extLst>
          </p:cNvPr>
          <p:cNvSpPr txBox="1"/>
          <p:nvPr/>
        </p:nvSpPr>
        <p:spPr>
          <a:xfrm>
            <a:off x="8191394" y="60965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6F818B9-AE82-5B39-42A3-F82F06300A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70818" y="5547359"/>
            <a:ext cx="2720576" cy="1120237"/>
          </a:xfrm>
          <a:prstGeom prst="rect">
            <a:avLst/>
          </a:prstGeom>
        </p:spPr>
      </p:pic>
      <p:sp>
        <p:nvSpPr>
          <p:cNvPr id="28" name="矩形 27">
            <a:extLst>
              <a:ext uri="{FF2B5EF4-FFF2-40B4-BE49-F238E27FC236}">
                <a16:creationId xmlns:a16="http://schemas.microsoft.com/office/drawing/2014/main" id="{899C05BB-8A57-65C1-9945-FCEDF5EDDB0F}"/>
              </a:ext>
            </a:extLst>
          </p:cNvPr>
          <p:cNvSpPr/>
          <p:nvPr/>
        </p:nvSpPr>
        <p:spPr>
          <a:xfrm>
            <a:off x="5470817" y="6118543"/>
            <a:ext cx="2704321" cy="21367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A456BBF-E9F0-0D39-5279-E5382DEE73D8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5.6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9781BD6-1E19-F77B-C09B-7326BDE7E5D5}"/>
              </a:ext>
            </a:extLst>
          </p:cNvPr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oe-Foxo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3</a:t>
            </a:r>
            <a:r>
              <a:rPr lang="zh-CN" altLang="en-US" b="1" dirty="0"/>
              <a:t>：</a:t>
            </a:r>
            <a:r>
              <a:rPr lang="en-US" altLang="zh-CN" b="1" dirty="0"/>
              <a:t>oe-Foxo1+oe-circDhx32</a:t>
            </a: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7631" y="1677147"/>
            <a:ext cx="2879725" cy="421449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803811" y="1261222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003711" y="18104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022761" y="24073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013236" y="32030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003711" y="421143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022761" y="51175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755142" y="41126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812292" y="48327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1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622961" y="1230742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7" name="矩形 46"/>
          <p:cNvSpPr/>
          <p:nvPr/>
        </p:nvSpPr>
        <p:spPr>
          <a:xfrm>
            <a:off x="2481991" y="4055222"/>
            <a:ext cx="2285365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393577" y="4730862"/>
            <a:ext cx="237378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7240299-4B4D-2F64-3716-12D046A06DFF}"/>
              </a:ext>
            </a:extLst>
          </p:cNvPr>
          <p:cNvSpPr txBox="1"/>
          <p:nvPr/>
        </p:nvSpPr>
        <p:spPr>
          <a:xfrm>
            <a:off x="8072775" y="40888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E0A1C74-A034-C376-F3AC-101DFCE8B2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1454" y="3491896"/>
            <a:ext cx="1950889" cy="929721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22881A56-7739-B743-99E8-1EABEA91C4C2}"/>
              </a:ext>
            </a:extLst>
          </p:cNvPr>
          <p:cNvSpPr/>
          <p:nvPr/>
        </p:nvSpPr>
        <p:spPr>
          <a:xfrm>
            <a:off x="6101454" y="4028234"/>
            <a:ext cx="1950889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71AC5EB-43F0-ACB2-42FB-8C0D0102726F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</a:t>
            </a: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3865" y="1972945"/>
            <a:ext cx="2947670" cy="381190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083310" y="143510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283210" y="19843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302260" y="25812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292735" y="33769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283210" y="43141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02260" y="52914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205072" y="42752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252734" y="49918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2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02460" y="1404620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8080" y="1972945"/>
            <a:ext cx="2840990" cy="382778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790066" y="4204970"/>
            <a:ext cx="5411470" cy="36639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694328" y="4904740"/>
            <a:ext cx="5507207" cy="49847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70996FC-761D-170F-396C-E567DD8D61B9}"/>
              </a:ext>
            </a:extLst>
          </p:cNvPr>
          <p:cNvSpPr txBox="1"/>
          <p:nvPr/>
        </p:nvSpPr>
        <p:spPr>
          <a:xfrm>
            <a:off x="10160000" y="42182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235F31AE-E6B2-87EC-0D4E-6175E0F5CD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87853" y="3796941"/>
            <a:ext cx="1920406" cy="937341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972F3622-9D78-0931-D78B-455B8EBD7E3B}"/>
              </a:ext>
            </a:extLst>
          </p:cNvPr>
          <p:cNvSpPr/>
          <p:nvPr/>
        </p:nvSpPr>
        <p:spPr>
          <a:xfrm>
            <a:off x="8187851" y="4218230"/>
            <a:ext cx="1920407" cy="29050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0974A5F-F8EC-C61F-4152-1E27DEC5636B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2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63F522A-A0C5-186B-F07C-7B04E3E62246}"/>
              </a:ext>
            </a:extLst>
          </p:cNvPr>
          <p:cNvSpPr txBox="1"/>
          <p:nvPr/>
        </p:nvSpPr>
        <p:spPr>
          <a:xfrm>
            <a:off x="8609518" y="3253740"/>
            <a:ext cx="107707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4455" y="1918335"/>
            <a:ext cx="2806065" cy="378523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189940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408890" y="19977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408890" y="26574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399365" y="33553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408890" y="42386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408890" y="53498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110680" y="41558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100520" y="48771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3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009090" y="1338580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2810" y="1918335"/>
            <a:ext cx="2874010" cy="378523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009090" y="4053206"/>
            <a:ext cx="5091430" cy="47625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918447" y="4838700"/>
            <a:ext cx="5192233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8669F70-3504-125D-325E-B4B210B9FAAF}"/>
              </a:ext>
            </a:extLst>
          </p:cNvPr>
          <p:cNvSpPr txBox="1"/>
          <p:nvPr/>
        </p:nvSpPr>
        <p:spPr>
          <a:xfrm>
            <a:off x="10553126" y="391074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028BF32-687A-EA44-4583-775CA85E28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51875" y="3509352"/>
            <a:ext cx="1806097" cy="891617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2C43D901-D702-EE58-E253-6D93825F16EF}"/>
              </a:ext>
            </a:extLst>
          </p:cNvPr>
          <p:cNvSpPr/>
          <p:nvPr/>
        </p:nvSpPr>
        <p:spPr>
          <a:xfrm>
            <a:off x="8651874" y="3930650"/>
            <a:ext cx="1806097" cy="25495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ABA7DB7-4E8B-2266-756A-DB4A0DF19D38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3</a:t>
            </a: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rcRect t="-252" b="10484"/>
          <a:stretch>
            <a:fillRect/>
          </a:stretch>
        </p:blipFill>
        <p:spPr>
          <a:xfrm>
            <a:off x="4735404" y="1769879"/>
            <a:ext cx="1941830" cy="361188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061294" y="1197744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261194" y="195148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280244" y="24861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270719" y="31840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261194" y="40768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280244" y="49474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77234" y="380664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731209" y="455594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005539" y="1167264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rcRect r="87607"/>
          <a:stretch>
            <a:fillRect/>
          </a:stretch>
        </p:blipFill>
        <p:spPr>
          <a:xfrm>
            <a:off x="1164164" y="1769879"/>
            <a:ext cx="739775" cy="365315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l="57521"/>
          <a:stretch>
            <a:fillRect/>
          </a:stretch>
        </p:blipFill>
        <p:spPr>
          <a:xfrm>
            <a:off x="2005539" y="1769879"/>
            <a:ext cx="2515235" cy="362140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075389" y="3787274"/>
            <a:ext cx="4483309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005539" y="4454024"/>
            <a:ext cx="467169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9B3DF4F-31C5-3C9D-DF79-87F50B620C0F}"/>
              </a:ext>
            </a:extLst>
          </p:cNvPr>
          <p:cNvSpPr txBox="1"/>
          <p:nvPr/>
        </p:nvSpPr>
        <p:spPr>
          <a:xfrm>
            <a:off x="9571773" y="38069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DA4018B8-100F-31BE-9F60-0E1E60EED6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51705" y="3537016"/>
            <a:ext cx="1600339" cy="784928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C06E80E4-7E6A-F014-9C4C-7C36793C1E14}"/>
              </a:ext>
            </a:extLst>
          </p:cNvPr>
          <p:cNvSpPr/>
          <p:nvPr/>
        </p:nvSpPr>
        <p:spPr>
          <a:xfrm>
            <a:off x="7851705" y="3787273"/>
            <a:ext cx="1563118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2CD7F77-3DEC-739E-6C7B-0AA3C53FCAE1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4</a:t>
            </a: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1222" y="1691639"/>
            <a:ext cx="2931795" cy="377698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158352" y="1143634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358252" y="189737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377302" y="243204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367777" y="31299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58252" y="40227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77302" y="489330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193017" y="38447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212067" y="447465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5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102597" y="1113154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8" name="矩形 47"/>
          <p:cNvSpPr/>
          <p:nvPr/>
        </p:nvSpPr>
        <p:spPr>
          <a:xfrm>
            <a:off x="1918447" y="4337684"/>
            <a:ext cx="228409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918447" y="3902709"/>
            <a:ext cx="2169459" cy="22479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36FA438-20F3-798C-41C8-5D7A92AB73FC}"/>
              </a:ext>
            </a:extLst>
          </p:cNvPr>
          <p:cNvSpPr txBox="1"/>
          <p:nvPr/>
        </p:nvSpPr>
        <p:spPr>
          <a:xfrm>
            <a:off x="7019701" y="379326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2FB7034E-203E-3074-3A0B-D728E1F0D3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2048" y="3380074"/>
            <a:ext cx="1806097" cy="769687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B4403D61-68E2-A372-98D1-2242983D95DB}"/>
              </a:ext>
            </a:extLst>
          </p:cNvPr>
          <p:cNvSpPr/>
          <p:nvPr/>
        </p:nvSpPr>
        <p:spPr>
          <a:xfrm>
            <a:off x="5172301" y="3854953"/>
            <a:ext cx="1806098" cy="18342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E5C0ABB-6932-59A1-F054-6CAD3BC58C52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5</a:t>
            </a: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rcRect l="55790"/>
          <a:stretch>
            <a:fillRect/>
          </a:stretch>
        </p:blipFill>
        <p:spPr>
          <a:xfrm>
            <a:off x="2179608" y="2049967"/>
            <a:ext cx="2142490" cy="336740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404273" y="1609277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497493" y="217633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516543" y="271100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07018" y="34088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497493" y="423055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516543" y="507447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322098" y="39356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375587" y="45153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241838" y="1578797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rcRect r="87511"/>
          <a:stretch>
            <a:fillRect/>
          </a:stretch>
        </p:blipFill>
        <p:spPr>
          <a:xfrm>
            <a:off x="1390938" y="2050602"/>
            <a:ext cx="605155" cy="336677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179608" y="4429947"/>
            <a:ext cx="214249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255809" y="3977192"/>
            <a:ext cx="2066290" cy="25336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994E122-0911-BEB7-70AF-D24A23544944}"/>
              </a:ext>
            </a:extLst>
          </p:cNvPr>
          <p:cNvSpPr txBox="1"/>
          <p:nvPr/>
        </p:nvSpPr>
        <p:spPr>
          <a:xfrm>
            <a:off x="7319511" y="42237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80877904-7C03-512B-17FD-1E742C1B86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43897" y="3813708"/>
            <a:ext cx="1775614" cy="746825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A7101954-EAC5-6DED-994C-2924B268CDBB}"/>
              </a:ext>
            </a:extLst>
          </p:cNvPr>
          <p:cNvSpPr/>
          <p:nvPr/>
        </p:nvSpPr>
        <p:spPr>
          <a:xfrm>
            <a:off x="5528417" y="4261558"/>
            <a:ext cx="1775614" cy="22025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D3EFC8B-1E01-10FF-72F9-72EE765A735D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6</a:t>
            </a: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rcRect b="1918"/>
          <a:stretch>
            <a:fillRect/>
          </a:stretch>
        </p:blipFill>
        <p:spPr>
          <a:xfrm>
            <a:off x="4276030" y="2069689"/>
            <a:ext cx="2790190" cy="324739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245175" y="1467709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385385" y="21592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357445" y="26761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347920" y="326729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38395" y="400008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57445" y="485289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094160" y="390833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094161" y="449507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7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082740" y="1437229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rcRect t="3637"/>
          <a:stretch>
            <a:fillRect/>
          </a:stretch>
        </p:blipFill>
        <p:spPr>
          <a:xfrm>
            <a:off x="1269305" y="2069689"/>
            <a:ext cx="2959735" cy="324739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1790065" y="4368389"/>
            <a:ext cx="5276156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900518" y="3816575"/>
            <a:ext cx="5165702" cy="42862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98973C7-0738-FF97-3D91-ED415EA2A95F}"/>
              </a:ext>
            </a:extLst>
          </p:cNvPr>
          <p:cNvSpPr txBox="1"/>
          <p:nvPr/>
        </p:nvSpPr>
        <p:spPr>
          <a:xfrm>
            <a:off x="10038775" y="399544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4839F7B0-F569-F479-F2CC-1400A3F229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56880" y="3593528"/>
            <a:ext cx="1889924" cy="800169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A7BE58AF-3F8F-7A4E-55C4-012F6EC6B07B}"/>
              </a:ext>
            </a:extLst>
          </p:cNvPr>
          <p:cNvSpPr/>
          <p:nvPr/>
        </p:nvSpPr>
        <p:spPr>
          <a:xfrm>
            <a:off x="8056878" y="3995441"/>
            <a:ext cx="1870953" cy="29154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91CA36F-0E73-DA1B-DD08-522398F57907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7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754069" y="132397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3236669" y="130810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Sham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4579694" y="1299210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I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3258894" y="163639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660974" y="1636395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894279" y="18078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894279" y="21977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894279" y="26117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903169" y="30721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912059" y="37204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903169" y="43865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191324" y="363203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27736" y="42086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381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4A-3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91864" y="1674495"/>
            <a:ext cx="3299460" cy="310134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3164541" y="4140200"/>
            <a:ext cx="3026783" cy="36830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3261534" y="3682501"/>
            <a:ext cx="2872958" cy="225781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FA558C6-9F4C-196B-3C3B-ACAC8E4B9719}"/>
              </a:ext>
            </a:extLst>
          </p:cNvPr>
          <p:cNvSpPr txBox="1"/>
          <p:nvPr/>
        </p:nvSpPr>
        <p:spPr>
          <a:xfrm>
            <a:off x="9654011" y="36825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LKBH5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93822AC-8374-219F-0B37-B947D85D068C}"/>
              </a:ext>
            </a:extLst>
          </p:cNvPr>
          <p:cNvSpPr txBox="1"/>
          <p:nvPr/>
        </p:nvSpPr>
        <p:spPr>
          <a:xfrm>
            <a:off x="7847419" y="2825055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BD18C2E6-ABAF-9E11-3ECB-7A510D49BB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75244" y="3378134"/>
            <a:ext cx="2522439" cy="762066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849A0BF1-07C9-D4A3-D918-F54AD15891BB}"/>
              </a:ext>
            </a:extLst>
          </p:cNvPr>
          <p:cNvSpPr/>
          <p:nvPr/>
        </p:nvSpPr>
        <p:spPr>
          <a:xfrm>
            <a:off x="7131572" y="3727204"/>
            <a:ext cx="2466111" cy="238371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43B7144-F5B4-B740-0FEA-D89BFA509E45}"/>
              </a:ext>
            </a:extLst>
          </p:cNvPr>
          <p:cNvSpPr txBox="1"/>
          <p:nvPr/>
        </p:nvSpPr>
        <p:spPr>
          <a:xfrm>
            <a:off x="395380" y="855244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3</a:t>
            </a: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9733" y="1546561"/>
            <a:ext cx="2639060" cy="361378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105168" y="1066501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245378" y="17580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217438" y="236380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207913" y="307056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98388" y="396337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81878" y="476283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320023" y="385209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320023" y="449979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B-8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42733" y="1036021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rcRect r="88929"/>
          <a:stretch>
            <a:fillRect/>
          </a:stretch>
        </p:blipFill>
        <p:spPr>
          <a:xfrm>
            <a:off x="1058178" y="1545926"/>
            <a:ext cx="654685" cy="371665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l="54762" b="2784"/>
          <a:stretch>
            <a:fillRect/>
          </a:stretch>
        </p:blipFill>
        <p:spPr>
          <a:xfrm>
            <a:off x="1860818" y="1545926"/>
            <a:ext cx="2675890" cy="361442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958208" y="3770331"/>
            <a:ext cx="5290586" cy="46355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878598" y="4376121"/>
            <a:ext cx="537019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5B849D9-E8D6-24B5-2CCC-8CA6852C8D62}"/>
              </a:ext>
            </a:extLst>
          </p:cNvPr>
          <p:cNvSpPr txBox="1"/>
          <p:nvPr/>
        </p:nvSpPr>
        <p:spPr>
          <a:xfrm>
            <a:off x="10249902" y="386094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2BD8E84D-4C4B-61BD-668E-4C984D45EF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38979" y="3406287"/>
            <a:ext cx="2110923" cy="891617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6D3B7CF6-5326-83C4-8036-EA974521F629}"/>
              </a:ext>
            </a:extLst>
          </p:cNvPr>
          <p:cNvSpPr/>
          <p:nvPr/>
        </p:nvSpPr>
        <p:spPr>
          <a:xfrm>
            <a:off x="8138977" y="3860947"/>
            <a:ext cx="2067601" cy="3213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787281D-40AD-BC19-29D8-415338448D4B}"/>
              </a:ext>
            </a:extLst>
          </p:cNvPr>
          <p:cNvSpPr txBox="1"/>
          <p:nvPr/>
        </p:nvSpPr>
        <p:spPr>
          <a:xfrm>
            <a:off x="170765" y="745310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8</a:t>
            </a: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13853" y="1848485"/>
            <a:ext cx="2602230" cy="382079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972273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943573" y="20605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915633" y="26663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7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906108" y="33108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96583" y="42659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80073" y="52177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145618" y="27889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154577" y="46548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1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2640928" y="1338580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30383" y="1848485"/>
            <a:ext cx="2515235" cy="383095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402306" y="4616450"/>
            <a:ext cx="4705778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81543" y="2745105"/>
            <a:ext cx="4626542" cy="36830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48CF4F3-1089-162C-CF49-75113F378F3F}"/>
              </a:ext>
            </a:extLst>
          </p:cNvPr>
          <p:cNvSpPr txBox="1"/>
          <p:nvPr/>
        </p:nvSpPr>
        <p:spPr>
          <a:xfrm>
            <a:off x="10421620" y="29292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CB8D0519-431F-EB62-FA95-2D326CFC30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67937" y="2201773"/>
            <a:ext cx="1653683" cy="1242168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1715BC2D-E685-93BE-11CE-34EF873A50C2}"/>
              </a:ext>
            </a:extLst>
          </p:cNvPr>
          <p:cNvSpPr/>
          <p:nvPr/>
        </p:nvSpPr>
        <p:spPr>
          <a:xfrm>
            <a:off x="8767937" y="2867660"/>
            <a:ext cx="1653683" cy="36830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5A66603-2CB8-0BC2-D14D-0F606393C031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-AMPK-1</a:t>
            </a: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1413" y="1686486"/>
            <a:ext cx="4812665" cy="375031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DB7A02C0-5C82-A94A-0F42-AFD9760465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61062" y="2165228"/>
            <a:ext cx="3467400" cy="1112616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429673" y="1172771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560993" y="186428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533053" y="247007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23528" y="31146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14003" y="403408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497493" y="49237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14564" y="254691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194078" y="444543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2</a:t>
            </a:r>
            <a:r>
              <a:rPr lang="zh-CN" altLang="en-US"/>
              <a:t>、</a:t>
            </a:r>
            <a:r>
              <a:rPr lang="en-US" altLang="zh-CN"/>
              <a:t>3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079278" y="1142291"/>
            <a:ext cx="4114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2         3        1          2         3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7" name="矩形 46"/>
          <p:cNvSpPr/>
          <p:nvPr/>
        </p:nvSpPr>
        <p:spPr>
          <a:xfrm>
            <a:off x="4073678" y="2527524"/>
            <a:ext cx="1997982" cy="34925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4017613" y="4279191"/>
            <a:ext cx="2078388" cy="57760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2019631" y="2546911"/>
            <a:ext cx="1997982" cy="34925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1938943" y="4279191"/>
            <a:ext cx="2078669" cy="586708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FB930BD-ACB5-E404-B73C-61EF217DE225}"/>
              </a:ext>
            </a:extLst>
          </p:cNvPr>
          <p:cNvSpPr txBox="1"/>
          <p:nvPr/>
        </p:nvSpPr>
        <p:spPr>
          <a:xfrm>
            <a:off x="7404722" y="1741096"/>
            <a:ext cx="1139821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41CC15C-8928-CD6B-BAFF-B83AAB0A0AE1}"/>
              </a:ext>
            </a:extLst>
          </p:cNvPr>
          <p:cNvSpPr txBox="1"/>
          <p:nvPr/>
        </p:nvSpPr>
        <p:spPr>
          <a:xfrm>
            <a:off x="10511526" y="276845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837CA797-D758-C1CF-E64A-EEEDA1E2679A}"/>
              </a:ext>
            </a:extLst>
          </p:cNvPr>
          <p:cNvSpPr/>
          <p:nvPr/>
        </p:nvSpPr>
        <p:spPr>
          <a:xfrm>
            <a:off x="8850783" y="2772634"/>
            <a:ext cx="1677679" cy="34925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D822BC16-5718-DFFF-6098-60C2E84B05CE}"/>
              </a:ext>
            </a:extLst>
          </p:cNvPr>
          <p:cNvSpPr/>
          <p:nvPr/>
        </p:nvSpPr>
        <p:spPr>
          <a:xfrm>
            <a:off x="7098484" y="2792021"/>
            <a:ext cx="1752299" cy="34925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BCF61C3-8B83-18C3-F587-2F2CC517E57C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-AMPK-2.3</a:t>
            </a: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7739" y="1696534"/>
            <a:ext cx="2891155" cy="408368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74424" y="1259654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745724" y="19511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17784" y="25569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08259" y="320148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98734" y="41565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82224" y="510838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518894" y="27222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518894" y="47200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4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2443079" y="1229174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8" name="矩形 47"/>
          <p:cNvSpPr/>
          <p:nvPr/>
        </p:nvSpPr>
        <p:spPr>
          <a:xfrm>
            <a:off x="2187387" y="4604834"/>
            <a:ext cx="2331507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283694" y="2668957"/>
            <a:ext cx="2161176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CC0ACE7-EC3E-4172-5EEF-FDB26DC50E1D}"/>
              </a:ext>
            </a:extLst>
          </p:cNvPr>
          <p:cNvSpPr txBox="1"/>
          <p:nvPr/>
        </p:nvSpPr>
        <p:spPr>
          <a:xfrm>
            <a:off x="7410302" y="27816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17F0BFF0-93D1-8FA1-0A9F-4924986DDB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2309" y="2089787"/>
            <a:ext cx="1767993" cy="1158340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2BE49FEB-ECA9-7979-26B2-4EC865DCF994}"/>
              </a:ext>
            </a:extLst>
          </p:cNvPr>
          <p:cNvSpPr/>
          <p:nvPr/>
        </p:nvSpPr>
        <p:spPr>
          <a:xfrm>
            <a:off x="5642309" y="2722201"/>
            <a:ext cx="1767993" cy="401207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E7AEB74-41D1-7373-3482-7AF02ED39B77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-AMPK-4</a:t>
            </a:r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8913" y="1916915"/>
            <a:ext cx="4836160" cy="384175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624303" y="149273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755623" y="22464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27683" y="27900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18158" y="34345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708633" y="43540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92123" y="52436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05878" y="286147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605878" y="46928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5</a:t>
            </a:r>
            <a:r>
              <a:rPr lang="zh-CN" altLang="en-US"/>
              <a:t>、</a:t>
            </a:r>
            <a:r>
              <a:rPr lang="en-US" altLang="zh-CN"/>
              <a:t>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273908" y="1462255"/>
            <a:ext cx="4114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2         3        1          2         3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7" name="矩形 46"/>
          <p:cNvSpPr/>
          <p:nvPr/>
        </p:nvSpPr>
        <p:spPr>
          <a:xfrm>
            <a:off x="2273908" y="2749083"/>
            <a:ext cx="4134328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133572" y="4580105"/>
            <a:ext cx="4381501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30DC901-AF44-198B-97EE-44969B6E792E}"/>
              </a:ext>
            </a:extLst>
          </p:cNvPr>
          <p:cNvSpPr txBox="1"/>
          <p:nvPr/>
        </p:nvSpPr>
        <p:spPr>
          <a:xfrm>
            <a:off x="11108969" y="270655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-AMPK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3B2C85D9-5B4D-3AEC-902D-57EFA0F256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89798" y="2169913"/>
            <a:ext cx="3528366" cy="115834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9C553AF1-727D-CF16-5D61-93DB1A89DDF5}"/>
              </a:ext>
            </a:extLst>
          </p:cNvPr>
          <p:cNvSpPr/>
          <p:nvPr/>
        </p:nvSpPr>
        <p:spPr>
          <a:xfrm>
            <a:off x="7489798" y="2749083"/>
            <a:ext cx="3528366" cy="35750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8B83E3F-99A8-2DEE-C727-E9A1BB437F8B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-AMPK-5.6</a:t>
            </a: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l="56461"/>
          <a:stretch>
            <a:fillRect/>
          </a:stretch>
        </p:blipFill>
        <p:spPr>
          <a:xfrm>
            <a:off x="2499996" y="1848485"/>
            <a:ext cx="2080260" cy="400558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893571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864871" y="21139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836931" y="26485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27406" y="33997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17881" y="43903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01371" y="54844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629002" y="29219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629002" y="49850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7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2562226" y="1338580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rcRect r="87648"/>
          <a:stretch>
            <a:fillRect/>
          </a:stretch>
        </p:blipFill>
        <p:spPr>
          <a:xfrm>
            <a:off x="1774826" y="1848485"/>
            <a:ext cx="589915" cy="400431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499996" y="4872355"/>
            <a:ext cx="2080260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99996" y="2900680"/>
            <a:ext cx="1993751" cy="3460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C43BDB2-3C9E-C5E8-08D2-67A4BC76F798}"/>
              </a:ext>
            </a:extLst>
          </p:cNvPr>
          <p:cNvSpPr txBox="1"/>
          <p:nvPr/>
        </p:nvSpPr>
        <p:spPr>
          <a:xfrm>
            <a:off x="7160883" y="29219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515C823-8060-8968-D808-BE0A3EC2ED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85688" y="2200777"/>
            <a:ext cx="1653683" cy="1104996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5B119C37-776B-6A8D-6527-DE067FB7FD84}"/>
              </a:ext>
            </a:extLst>
          </p:cNvPr>
          <p:cNvSpPr/>
          <p:nvPr/>
        </p:nvSpPr>
        <p:spPr>
          <a:xfrm>
            <a:off x="5485688" y="2893695"/>
            <a:ext cx="1653683" cy="273367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170B6A5-F0D4-17AC-90FF-7C033B56C8B6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MPK-7</a:t>
            </a: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rcRect r="8963"/>
          <a:stretch>
            <a:fillRect/>
          </a:stretch>
        </p:blipFill>
        <p:spPr>
          <a:xfrm>
            <a:off x="1440106" y="1806575"/>
            <a:ext cx="4533900" cy="373253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502971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634291" y="21228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606351" y="27819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96826" y="33108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87301" y="42303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570791" y="51200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990836" y="274924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942891" y="464726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8</a:t>
            </a:r>
            <a:r>
              <a:rPr lang="zh-CN" altLang="en-US"/>
              <a:t>、</a:t>
            </a:r>
            <a:r>
              <a:rPr lang="en-US" altLang="zh-CN"/>
              <a:t>9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152576" y="1338580"/>
            <a:ext cx="4114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2         3        1          2         3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7" name="矩形 46"/>
          <p:cNvSpPr/>
          <p:nvPr/>
        </p:nvSpPr>
        <p:spPr>
          <a:xfrm>
            <a:off x="4023559" y="2701925"/>
            <a:ext cx="1866254" cy="42699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4023558" y="4580256"/>
            <a:ext cx="1950448" cy="53975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6826811" y="1742198"/>
            <a:ext cx="17068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5" name="矩形 4"/>
          <p:cNvSpPr/>
          <p:nvPr/>
        </p:nvSpPr>
        <p:spPr>
          <a:xfrm>
            <a:off x="2094657" y="2708910"/>
            <a:ext cx="1887674" cy="426992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1918446" y="4580255"/>
            <a:ext cx="2090977" cy="539749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EFB804F-6143-11ED-366E-0ED4F3D4B52B}"/>
              </a:ext>
            </a:extLst>
          </p:cNvPr>
          <p:cNvSpPr txBox="1"/>
          <p:nvPr/>
        </p:nvSpPr>
        <p:spPr>
          <a:xfrm>
            <a:off x="10082738" y="28717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MPK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13023742-A124-C0BE-83E2-A51E0F98C2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43321" y="2275202"/>
            <a:ext cx="3254022" cy="1005927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F80BF56A-21A4-985E-E82F-6E666CADD38E}"/>
              </a:ext>
            </a:extLst>
          </p:cNvPr>
          <p:cNvSpPr/>
          <p:nvPr/>
        </p:nvSpPr>
        <p:spPr>
          <a:xfrm>
            <a:off x="8509254" y="2845176"/>
            <a:ext cx="1588089" cy="362672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28A8DAA-1AE7-FD57-990C-0A41F54C2608}"/>
              </a:ext>
            </a:extLst>
          </p:cNvPr>
          <p:cNvSpPr/>
          <p:nvPr/>
        </p:nvSpPr>
        <p:spPr>
          <a:xfrm>
            <a:off x="6862111" y="2900720"/>
            <a:ext cx="1647143" cy="32486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6757E5F-1510-6303-5B77-3FC92D4A1389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MPK-8.9</a:t>
            </a:r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2843" y="1835150"/>
            <a:ext cx="4845050" cy="384111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474123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560993" y="21050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533053" y="27019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23528" y="33108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14003" y="42303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497493" y="52622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49323" y="28524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37893" y="479901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242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10</a:t>
            </a:r>
            <a:r>
              <a:rPr lang="zh-CN" altLang="en-US"/>
              <a:t>、</a:t>
            </a:r>
            <a:r>
              <a:rPr lang="en-US" altLang="zh-CN"/>
              <a:t>11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123728" y="1338580"/>
            <a:ext cx="4114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2         3        1          2         3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8" name="矩形 47"/>
          <p:cNvSpPr/>
          <p:nvPr/>
        </p:nvSpPr>
        <p:spPr>
          <a:xfrm>
            <a:off x="2242820" y="4651375"/>
            <a:ext cx="4006503" cy="5403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123728" y="2755265"/>
            <a:ext cx="3971290" cy="43942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40AC231-4588-7C91-C60A-74C6CAD7988F}"/>
              </a:ext>
            </a:extLst>
          </p:cNvPr>
          <p:cNvSpPr txBox="1"/>
          <p:nvPr/>
        </p:nvSpPr>
        <p:spPr>
          <a:xfrm>
            <a:off x="10357197" y="28524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MPK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2A26D87-8C76-2667-7A69-19061958E1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86760" y="2034419"/>
            <a:ext cx="3330229" cy="1394581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AF3DE95E-9015-C3AE-6BC8-064EC0CF6BF8}"/>
              </a:ext>
            </a:extLst>
          </p:cNvPr>
          <p:cNvSpPr/>
          <p:nvPr/>
        </p:nvSpPr>
        <p:spPr>
          <a:xfrm>
            <a:off x="6986760" y="2680185"/>
            <a:ext cx="3330229" cy="43942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4952D5F-BF01-B371-56CB-346F5986F98B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MPK-10.11</a:t>
            </a: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rcRect l="54435"/>
          <a:stretch>
            <a:fillRect/>
          </a:stretch>
        </p:blipFill>
        <p:spPr>
          <a:xfrm>
            <a:off x="2968065" y="1783901"/>
            <a:ext cx="2167255" cy="38049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115260" y="1304476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086560" y="204933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058620" y="25840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049095" y="33263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039570" y="42280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023060" y="525989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135320" y="270655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135320" y="469124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C-D-12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2917265" y="1273996"/>
            <a:ext cx="235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 2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rcRect r="83983"/>
          <a:stretch>
            <a:fillRect/>
          </a:stretch>
        </p:blipFill>
        <p:spPr>
          <a:xfrm>
            <a:off x="2098115" y="1783901"/>
            <a:ext cx="761365" cy="380301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968065" y="2668773"/>
            <a:ext cx="1959240" cy="4171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3155577" y="4578536"/>
            <a:ext cx="1959240" cy="470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6A5FA81-B3D7-8FD8-7646-CD8B939F1BCC}"/>
              </a:ext>
            </a:extLst>
          </p:cNvPr>
          <p:cNvSpPr txBox="1"/>
          <p:nvPr/>
        </p:nvSpPr>
        <p:spPr>
          <a:xfrm>
            <a:off x="8102638" y="263226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E125E7D-BE82-211F-A861-C41F80F0BB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71817" y="1965731"/>
            <a:ext cx="1653683" cy="1120237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4C5DBC35-7164-E8B0-958D-D7EDD40D7A7A}"/>
              </a:ext>
            </a:extLst>
          </p:cNvPr>
          <p:cNvSpPr/>
          <p:nvPr/>
        </p:nvSpPr>
        <p:spPr>
          <a:xfrm>
            <a:off x="6371817" y="2668773"/>
            <a:ext cx="1653683" cy="30580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858C83C-041B-5D3A-55AE-02925222E8FE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MPK-12</a:t>
            </a:r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5114" y="2053403"/>
            <a:ext cx="6186170" cy="255397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482525" y="1586043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598605" y="205340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598605" y="248075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98605" y="29481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98605" y="356533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598605" y="42943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741284" y="25140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767955" y="39015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242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E-F-1</a:t>
            </a:r>
            <a:r>
              <a:rPr lang="zh-CN" altLang="en-US"/>
              <a:t>、</a:t>
            </a:r>
            <a:r>
              <a:rPr lang="en-US" altLang="zh-CN"/>
              <a:t>2</a:t>
            </a:r>
            <a:r>
              <a:rPr lang="zh-CN" altLang="en-US"/>
              <a:t>、</a:t>
            </a:r>
            <a:r>
              <a:rPr lang="en-US" altLang="zh-CN"/>
              <a:t>3</a:t>
            </a:r>
            <a:r>
              <a:rPr lang="zh-CN" altLang="en-US"/>
              <a:t>、</a:t>
            </a:r>
            <a:r>
              <a:rPr lang="en-US" altLang="zh-CN"/>
              <a:t>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91795" y="1586043"/>
            <a:ext cx="5730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2     3     1     2      3   </a:t>
            </a:r>
            <a:r>
              <a:rPr lang="en-US" altLang="zh-CN" b="1"/>
              <a:t>M    </a:t>
            </a:r>
            <a:r>
              <a:rPr lang="en-US" altLang="zh-CN"/>
              <a:t>1      2     3     1     2     3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8" name="矩形 47"/>
          <p:cNvSpPr/>
          <p:nvPr/>
        </p:nvSpPr>
        <p:spPr>
          <a:xfrm>
            <a:off x="4952952" y="3753933"/>
            <a:ext cx="2792941" cy="5403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7" name="矩形 46"/>
          <p:cNvSpPr/>
          <p:nvPr/>
        </p:nvSpPr>
        <p:spPr>
          <a:xfrm>
            <a:off x="5054474" y="2480123"/>
            <a:ext cx="2667561" cy="36830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1845110" y="3776418"/>
            <a:ext cx="1359737" cy="49541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3231518" y="3753933"/>
            <a:ext cx="1428899" cy="510857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3250258" y="2470216"/>
            <a:ext cx="1428899" cy="36830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1991794" y="2465553"/>
            <a:ext cx="1239723" cy="36830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847B2AF-34EE-3F1A-2DEF-77AC8314F1B5}"/>
              </a:ext>
            </a:extLst>
          </p:cNvPr>
          <p:cNvSpPr txBox="1"/>
          <p:nvPr/>
        </p:nvSpPr>
        <p:spPr>
          <a:xfrm>
            <a:off x="2880622" y="4798961"/>
            <a:ext cx="173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47F20EF-6BD9-A44C-81B1-83C764B61B86}"/>
              </a:ext>
            </a:extLst>
          </p:cNvPr>
          <p:cNvSpPr txBox="1"/>
          <p:nvPr/>
        </p:nvSpPr>
        <p:spPr>
          <a:xfrm>
            <a:off x="6934786" y="546815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p65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04407ECA-8D56-933D-20AE-0C371E40B3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91794" y="5207355"/>
            <a:ext cx="4900085" cy="891617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1C744185-47BF-19BB-5D4A-E86FE0FA1E7E}"/>
              </a:ext>
            </a:extLst>
          </p:cNvPr>
          <p:cNvSpPr/>
          <p:nvPr/>
        </p:nvSpPr>
        <p:spPr>
          <a:xfrm>
            <a:off x="4611632" y="5543686"/>
            <a:ext cx="2280247" cy="245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016ED6CF-9205-ED76-4D47-264711728D86}"/>
              </a:ext>
            </a:extLst>
          </p:cNvPr>
          <p:cNvSpPr/>
          <p:nvPr/>
        </p:nvSpPr>
        <p:spPr>
          <a:xfrm>
            <a:off x="3153588" y="5543686"/>
            <a:ext cx="1070730" cy="286963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23F2608D-CC4D-9368-F754-EC64D3DF74AB}"/>
              </a:ext>
            </a:extLst>
          </p:cNvPr>
          <p:cNvSpPr/>
          <p:nvPr/>
        </p:nvSpPr>
        <p:spPr>
          <a:xfrm>
            <a:off x="1991794" y="5529116"/>
            <a:ext cx="1161793" cy="30153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9D9E37D-EE6B-CA87-0F49-DCB8F678E8F6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p65-1.2.3.4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754070" y="1135717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3236670" y="1119842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ctrl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4579695" y="1110952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H/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3258895" y="1448137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660975" y="1448137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894280" y="160180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894280" y="20094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894280" y="24323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894280" y="287498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894280" y="34788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894280" y="41627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97930" y="335631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97930" y="388339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4B-1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9955" y="1504017"/>
            <a:ext cx="3430905" cy="292544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3205478" y="3367443"/>
            <a:ext cx="2890522" cy="18766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3008705" y="3802753"/>
            <a:ext cx="3087295" cy="379059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434DF39-95ED-B8F0-AFEB-5D3CE732D4DB}"/>
              </a:ext>
            </a:extLst>
          </p:cNvPr>
          <p:cNvSpPr txBox="1"/>
          <p:nvPr/>
        </p:nvSpPr>
        <p:spPr>
          <a:xfrm>
            <a:off x="9670900" y="359006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LKBH5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22B3C73-FC94-AD65-6FA7-5E6787715323}"/>
              </a:ext>
            </a:extLst>
          </p:cNvPr>
          <p:cNvSpPr txBox="1"/>
          <p:nvPr/>
        </p:nvSpPr>
        <p:spPr>
          <a:xfrm>
            <a:off x="7891568" y="2628287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2C268C3C-D5CA-E9DD-5AD9-771FF113BC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17047" y="3391655"/>
            <a:ext cx="2453853" cy="777307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C1C26028-8D9B-76FB-2F3C-ACE98E4D39AB}"/>
              </a:ext>
            </a:extLst>
          </p:cNvPr>
          <p:cNvSpPr/>
          <p:nvPr/>
        </p:nvSpPr>
        <p:spPr>
          <a:xfrm>
            <a:off x="7181850" y="3583887"/>
            <a:ext cx="2453853" cy="21886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B7CF1BB-2F18-6876-4F5A-94A3047C278B}"/>
              </a:ext>
            </a:extLst>
          </p:cNvPr>
          <p:cNvSpPr txBox="1"/>
          <p:nvPr/>
        </p:nvSpPr>
        <p:spPr>
          <a:xfrm>
            <a:off x="233849" y="1567691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1</a:t>
            </a:r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6285" y="1867694"/>
            <a:ext cx="4565650" cy="359981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085340" y="1158399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172210" y="20277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144270" y="250015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134745" y="31624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125220" y="400192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108710" y="505158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25590" y="239664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625590" y="431244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242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E-F-5</a:t>
            </a:r>
            <a:r>
              <a:rPr lang="zh-CN" altLang="en-US"/>
              <a:t>、</a:t>
            </a:r>
            <a:r>
              <a:rPr lang="en-US" altLang="zh-CN"/>
              <a:t>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734945" y="1127919"/>
            <a:ext cx="4114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2         3        1        2       3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sp>
        <p:nvSpPr>
          <p:cNvPr id="47" name="矩形 46"/>
          <p:cNvSpPr/>
          <p:nvPr/>
        </p:nvSpPr>
        <p:spPr>
          <a:xfrm>
            <a:off x="2734945" y="2387124"/>
            <a:ext cx="3773431" cy="39243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734946" y="4209574"/>
            <a:ext cx="3856990" cy="5403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527210F-6D50-9C8F-4A7A-0283E26C3CC7}"/>
              </a:ext>
            </a:extLst>
          </p:cNvPr>
          <p:cNvSpPr txBox="1"/>
          <p:nvPr/>
        </p:nvSpPr>
        <p:spPr>
          <a:xfrm>
            <a:off x="10487955" y="247030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p65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ED758F6-56E1-6D28-C83E-0D58A86FCF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98690" y="2047798"/>
            <a:ext cx="3208298" cy="998307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FDD64098-9035-CAC8-C016-FC1FB0175CE1}"/>
              </a:ext>
            </a:extLst>
          </p:cNvPr>
          <p:cNvSpPr/>
          <p:nvPr/>
        </p:nvSpPr>
        <p:spPr>
          <a:xfrm>
            <a:off x="7298691" y="2500154"/>
            <a:ext cx="3208298" cy="31877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7EAB2E7-B8AC-1F86-814B-482DF7469EAA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p65-5.6</a:t>
            </a:r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795" y="1979891"/>
            <a:ext cx="4583430" cy="361188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1791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708025" y="1288376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-205105" y="205086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0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-233045" y="259442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-242570" y="328339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252095" y="411397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268605" y="505695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0103166" y="265870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0058288" y="47326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242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E-F-7</a:t>
            </a:r>
            <a:r>
              <a:rPr lang="zh-CN" altLang="en-US"/>
              <a:t>、</a:t>
            </a:r>
            <a:r>
              <a:rPr lang="en-US" altLang="zh-CN"/>
              <a:t>8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357630" y="1257896"/>
            <a:ext cx="4114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    2         3        1        2       3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+shNC-V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IR+shcircDhx32-V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13375" y="1979891"/>
            <a:ext cx="4582160" cy="361188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282864" y="2517100"/>
            <a:ext cx="1959610" cy="4032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5867866" y="4621491"/>
            <a:ext cx="2098073" cy="45339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7965938" y="4621491"/>
            <a:ext cx="2029597" cy="45339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3269615" y="2517100"/>
            <a:ext cx="1959610" cy="368141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A988A0B-E20F-AE34-8105-752E1971F3D2}"/>
              </a:ext>
            </a:extLst>
          </p:cNvPr>
          <p:cNvSpPr txBox="1"/>
          <p:nvPr/>
        </p:nvSpPr>
        <p:spPr>
          <a:xfrm>
            <a:off x="5178537" y="60064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65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F648BB80-C60C-A955-4EEA-4A6E1D0EC7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10205" y="5607773"/>
            <a:ext cx="3368332" cy="1120237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2334C77C-14EF-C486-B1AF-EA1E8F7E3031}"/>
              </a:ext>
            </a:extLst>
          </p:cNvPr>
          <p:cNvSpPr/>
          <p:nvPr/>
        </p:nvSpPr>
        <p:spPr>
          <a:xfrm>
            <a:off x="1809047" y="6056209"/>
            <a:ext cx="1714082" cy="21908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E627C9CB-F34D-D283-22E3-AEA27724D013}"/>
              </a:ext>
            </a:extLst>
          </p:cNvPr>
          <p:cNvSpPr/>
          <p:nvPr/>
        </p:nvSpPr>
        <p:spPr>
          <a:xfrm>
            <a:off x="3563592" y="6056209"/>
            <a:ext cx="1614945" cy="219084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C66AC75-FFB0-231E-B539-204F474CAF17}"/>
              </a:ext>
            </a:extLst>
          </p:cNvPr>
          <p:cNvSpPr txBox="1"/>
          <p:nvPr/>
        </p:nvSpPr>
        <p:spPr>
          <a:xfrm>
            <a:off x="199390" y="869077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65-7.8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8B75E5D-8E6B-CF87-6886-6B688B685FAF}"/>
              </a:ext>
            </a:extLst>
          </p:cNvPr>
          <p:cNvSpPr txBox="1"/>
          <p:nvPr/>
        </p:nvSpPr>
        <p:spPr>
          <a:xfrm>
            <a:off x="4825963" y="5633979"/>
            <a:ext cx="173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155" y="4114800"/>
            <a:ext cx="6128385" cy="24841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525145" y="363537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-278765" y="41027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-278765" y="45300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-278765" y="49707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278765" y="55613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278765" y="62903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35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9" name="文本框 48"/>
          <p:cNvSpPr txBox="1"/>
          <p:nvPr/>
        </p:nvSpPr>
        <p:spPr>
          <a:xfrm>
            <a:off x="6985" y="43332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-59690" y="59817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32912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E-F-9</a:t>
            </a:r>
            <a:r>
              <a:rPr lang="zh-CN" altLang="en-US"/>
              <a:t>、</a:t>
            </a:r>
            <a:r>
              <a:rPr lang="en-US" altLang="zh-CN"/>
              <a:t>10</a:t>
            </a:r>
            <a:r>
              <a:rPr lang="zh-CN" altLang="en-US"/>
              <a:t>、</a:t>
            </a:r>
            <a:r>
              <a:rPr lang="en-US" altLang="zh-CN"/>
              <a:t>11</a:t>
            </a:r>
            <a:r>
              <a:rPr lang="zh-CN" altLang="en-US"/>
              <a:t>、</a:t>
            </a:r>
            <a:r>
              <a:rPr lang="en-US" altLang="zh-CN"/>
              <a:t>12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936625" y="3635375"/>
            <a:ext cx="5966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1     2     3     1     2      3     </a:t>
            </a:r>
            <a:r>
              <a:rPr lang="en-US" altLang="zh-CN" b="1" dirty="0"/>
              <a:t>M     </a:t>
            </a:r>
            <a:r>
              <a:rPr lang="en-US" altLang="zh-CN" dirty="0"/>
              <a:t>1     2     3     1     2     3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9340831" y="807354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 err="1"/>
              <a:t>Sham+shNC-V</a:t>
            </a:r>
            <a:endParaRPr lang="en-US" altLang="zh-CN" b="1" dirty="0"/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 err="1"/>
              <a:t>IR+shNC-V</a:t>
            </a:r>
            <a:endParaRPr lang="en-US" altLang="zh-CN" b="1" dirty="0"/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3</a:t>
            </a:r>
            <a:r>
              <a:rPr lang="zh-CN" altLang="en-US" b="1" dirty="0"/>
              <a:t>：</a:t>
            </a:r>
            <a:r>
              <a:rPr lang="en-US" altLang="zh-CN" b="1" dirty="0"/>
              <a:t>IR+shcircDhx32-V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93865" y="4133850"/>
            <a:ext cx="6344285" cy="243967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931892" y="5951220"/>
            <a:ext cx="12347228" cy="39243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009015" y="4446905"/>
            <a:ext cx="12270105" cy="3282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A2036B7-CB65-28E9-FCF2-48346C02B214}"/>
              </a:ext>
            </a:extLst>
          </p:cNvPr>
          <p:cNvSpPr txBox="1"/>
          <p:nvPr/>
        </p:nvSpPr>
        <p:spPr>
          <a:xfrm>
            <a:off x="10451984" y="28352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65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271C6638-1D6F-0727-5558-F78BD05611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50037" y="2592038"/>
            <a:ext cx="4701947" cy="731583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9AEE1171-6DFE-3D32-EC1C-2CA4D20E1F90}"/>
              </a:ext>
            </a:extLst>
          </p:cNvPr>
          <p:cNvSpPr/>
          <p:nvPr/>
        </p:nvSpPr>
        <p:spPr>
          <a:xfrm>
            <a:off x="5750037" y="2793681"/>
            <a:ext cx="4701947" cy="3282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DC6788D-4194-F128-0CE8-0B7D2C816DF7}"/>
              </a:ext>
            </a:extLst>
          </p:cNvPr>
          <p:cNvSpPr txBox="1"/>
          <p:nvPr/>
        </p:nvSpPr>
        <p:spPr>
          <a:xfrm>
            <a:off x="170180" y="1201221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65-9.10.11.12</a:t>
            </a:r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6470" y="2403475"/>
            <a:ext cx="2731135" cy="360616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986155" y="191135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60655" y="30435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51130" y="35896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41605" y="459486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60655" y="55454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8474710" y="42480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8554720" y="502824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I-1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598295" y="1880870"/>
            <a:ext cx="2099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 2        3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63195" y="24949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b="9034"/>
          <a:stretch>
            <a:fillRect/>
          </a:stretch>
        </p:blipFill>
        <p:spPr>
          <a:xfrm>
            <a:off x="3701415" y="2403475"/>
            <a:ext cx="2298065" cy="360616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09640" y="2404110"/>
            <a:ext cx="2465070" cy="360616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886461" y="5024120"/>
            <a:ext cx="7588250" cy="49847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886460" y="4192905"/>
            <a:ext cx="7588250" cy="36639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D42B26C-1F96-949A-0530-B6EA041B5417}"/>
              </a:ext>
            </a:extLst>
          </p:cNvPr>
          <p:cNvSpPr txBox="1"/>
          <p:nvPr/>
        </p:nvSpPr>
        <p:spPr>
          <a:xfrm>
            <a:off x="9505888" y="3409084"/>
            <a:ext cx="146585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4C08DD6-881B-4B44-A12F-19D5C8B3E474}"/>
              </a:ext>
            </a:extLst>
          </p:cNvPr>
          <p:cNvSpPr txBox="1"/>
          <p:nvPr/>
        </p:nvSpPr>
        <p:spPr>
          <a:xfrm>
            <a:off x="11119003" y="423725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7D77464A-665D-099E-FE8E-47021B33CD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58631" y="3834765"/>
            <a:ext cx="1760373" cy="861135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98AC5AE7-568A-13AB-EAC4-57C731AFCDF9}"/>
              </a:ext>
            </a:extLst>
          </p:cNvPr>
          <p:cNvSpPr/>
          <p:nvPr/>
        </p:nvSpPr>
        <p:spPr>
          <a:xfrm>
            <a:off x="9358630" y="4242618"/>
            <a:ext cx="1760373" cy="271318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8F9049D-414D-2F33-0C8D-773291B56FCA}"/>
              </a:ext>
            </a:extLst>
          </p:cNvPr>
          <p:cNvSpPr txBox="1"/>
          <p:nvPr/>
        </p:nvSpPr>
        <p:spPr>
          <a:xfrm>
            <a:off x="170180" y="1201221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1</a:t>
            </a:r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rcRect l="11890" b="14958"/>
          <a:stretch>
            <a:fillRect/>
          </a:stretch>
        </p:blipFill>
        <p:spPr>
          <a:xfrm>
            <a:off x="1238885" y="2556510"/>
            <a:ext cx="3910330" cy="252349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586740" y="149352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-265430" y="26701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-255270" y="32365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240030" y="41414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256540" y="48342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0001250" y="371392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0001250" y="45891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I-2</a:t>
            </a:r>
            <a:r>
              <a:rPr lang="zh-CN" altLang="en-US"/>
              <a:t>、</a:t>
            </a:r>
            <a:r>
              <a:rPr lang="en-US" altLang="zh-CN"/>
              <a:t>3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198880" y="1463040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-254000" y="21837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rcRect r="88945" b="8882"/>
          <a:stretch>
            <a:fillRect/>
          </a:stretch>
        </p:blipFill>
        <p:spPr>
          <a:xfrm>
            <a:off x="681990" y="2077085"/>
            <a:ext cx="516890" cy="300291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34305" y="2077085"/>
            <a:ext cx="4516755" cy="300291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1250949" y="4330700"/>
            <a:ext cx="8500111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236979" y="3656965"/>
            <a:ext cx="8514081" cy="372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67416F4-856D-3149-2106-0B6B93A02225}"/>
              </a:ext>
            </a:extLst>
          </p:cNvPr>
          <p:cNvSpPr txBox="1"/>
          <p:nvPr/>
        </p:nvSpPr>
        <p:spPr>
          <a:xfrm>
            <a:off x="4792345" y="58185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A93B407-5DCD-1E52-21A8-D162955C3BD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0849" y="5145535"/>
            <a:ext cx="3246401" cy="1310754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29ED0B48-ACEE-D2BD-C6B6-174818D0925E}"/>
              </a:ext>
            </a:extLst>
          </p:cNvPr>
          <p:cNvSpPr/>
          <p:nvPr/>
        </p:nvSpPr>
        <p:spPr>
          <a:xfrm>
            <a:off x="1570849" y="5865551"/>
            <a:ext cx="3246401" cy="31490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172674D-3231-BA1C-658D-7B5D60493D3F}"/>
              </a:ext>
            </a:extLst>
          </p:cNvPr>
          <p:cNvSpPr txBox="1"/>
          <p:nvPr/>
        </p:nvSpPr>
        <p:spPr>
          <a:xfrm>
            <a:off x="229869" y="645686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2.3</a:t>
            </a:r>
          </a:p>
        </p:txBody>
      </p:sp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rcRect t="2873" b="11506"/>
          <a:stretch>
            <a:fillRect/>
          </a:stretch>
        </p:blipFill>
        <p:spPr>
          <a:xfrm>
            <a:off x="3786187" y="2021081"/>
            <a:ext cx="2837815" cy="352044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951230" y="1422911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9050" y="267068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525" y="318122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0" y="419532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9050" y="50570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91312" y="38526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691312" y="45708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I-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563370" y="1392431"/>
            <a:ext cx="2099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 2        3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21590" y="200647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1230" y="2021081"/>
            <a:ext cx="2648585" cy="352044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460500" y="3775586"/>
            <a:ext cx="5163502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345491" y="4458790"/>
            <a:ext cx="5278512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D5E4307-EC9E-3D12-1624-CA768336D5DE}"/>
              </a:ext>
            </a:extLst>
          </p:cNvPr>
          <p:cNvSpPr txBox="1"/>
          <p:nvPr/>
        </p:nvSpPr>
        <p:spPr>
          <a:xfrm>
            <a:off x="9483686" y="277156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4948D03-349D-2C47-BD6E-855C9617ABEF}"/>
              </a:ext>
            </a:extLst>
          </p:cNvPr>
          <p:cNvSpPr txBox="1"/>
          <p:nvPr/>
        </p:nvSpPr>
        <p:spPr>
          <a:xfrm>
            <a:off x="229869" y="645686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4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BD6FBE0E-107D-1C5E-9F0A-9D2C7B79B5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73695" y="2152178"/>
            <a:ext cx="2209992" cy="967824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6F0C4520-D9FB-69C0-C22D-EF54F98F060D}"/>
              </a:ext>
            </a:extLst>
          </p:cNvPr>
          <p:cNvSpPr/>
          <p:nvPr/>
        </p:nvSpPr>
        <p:spPr>
          <a:xfrm>
            <a:off x="7512423" y="2671956"/>
            <a:ext cx="1971263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b="16443"/>
          <a:stretch>
            <a:fillRect/>
          </a:stretch>
        </p:blipFill>
        <p:spPr>
          <a:xfrm>
            <a:off x="4148866" y="2087275"/>
            <a:ext cx="2319020" cy="339471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8E6458C-45B1-ECE3-D858-14E3A56D28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63230" y="2494945"/>
            <a:ext cx="1828958" cy="1005927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rcRect l="56544"/>
          <a:stretch>
            <a:fillRect/>
          </a:stretch>
        </p:blipFill>
        <p:spPr>
          <a:xfrm>
            <a:off x="1991771" y="2076480"/>
            <a:ext cx="1893570" cy="340677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281841" y="160404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349661" y="28073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340136" y="33623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30611" y="42075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49661" y="51314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447566" y="389607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467885" y="46472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I-5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893981" y="1573560"/>
            <a:ext cx="2099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 2        3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352201" y="22498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rcRect r="87388"/>
          <a:stretch>
            <a:fillRect/>
          </a:stretch>
        </p:blipFill>
        <p:spPr>
          <a:xfrm>
            <a:off x="1293271" y="2076480"/>
            <a:ext cx="549275" cy="340550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991771" y="3803362"/>
            <a:ext cx="4405605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991770" y="4485670"/>
            <a:ext cx="447611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927E1D5-ED7D-21FD-0B1B-55CA87C4B4A2}"/>
              </a:ext>
            </a:extLst>
          </p:cNvPr>
          <p:cNvSpPr txBox="1"/>
          <p:nvPr/>
        </p:nvSpPr>
        <p:spPr>
          <a:xfrm>
            <a:off x="10623951" y="30563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dipoR1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D03D77B-4FAA-A8B5-5811-ADED5136DB33}"/>
              </a:ext>
            </a:extLst>
          </p:cNvPr>
          <p:cNvSpPr txBox="1"/>
          <p:nvPr/>
        </p:nvSpPr>
        <p:spPr>
          <a:xfrm>
            <a:off x="229869" y="645686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5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D1BE4AF6-B06C-E285-96AD-EFA5B822F841}"/>
              </a:ext>
            </a:extLst>
          </p:cNvPr>
          <p:cNvSpPr/>
          <p:nvPr/>
        </p:nvSpPr>
        <p:spPr>
          <a:xfrm>
            <a:off x="8763229" y="3052475"/>
            <a:ext cx="1797195" cy="30988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b="9680"/>
          <a:stretch>
            <a:fillRect/>
          </a:stretch>
        </p:blipFill>
        <p:spPr>
          <a:xfrm>
            <a:off x="3935777" y="2060286"/>
            <a:ext cx="2701925" cy="351345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FE5746E-31F6-14E5-BF6E-A637AB0D1A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41093" y="2786881"/>
            <a:ext cx="2209992" cy="108213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rcRect l="55201"/>
          <a:stretch>
            <a:fillRect/>
          </a:stretch>
        </p:blipFill>
        <p:spPr>
          <a:xfrm>
            <a:off x="1760267" y="2060286"/>
            <a:ext cx="2028825" cy="351345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077642" y="1586576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45462" y="283435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35937" y="35138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26412" y="441232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45462" y="526513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70087" y="402292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670087" y="482634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I-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689782" y="1556096"/>
            <a:ext cx="2099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  2        3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48002" y="231238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rcRect r="87557"/>
          <a:stretch>
            <a:fillRect/>
          </a:stretch>
        </p:blipFill>
        <p:spPr>
          <a:xfrm>
            <a:off x="1050337" y="2060286"/>
            <a:ext cx="563245" cy="351218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792652" y="4010371"/>
            <a:ext cx="4845050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760267" y="4699346"/>
            <a:ext cx="487743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B02F2DB-0E4F-4E7D-8D08-BD8CF8779357}"/>
              </a:ext>
            </a:extLst>
          </p:cNvPr>
          <p:cNvSpPr txBox="1"/>
          <p:nvPr/>
        </p:nvSpPr>
        <p:spPr>
          <a:xfrm>
            <a:off x="10966328" y="332794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dipoR1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2E5FE76-2DC1-830F-8F8C-F82648A0BACC}"/>
              </a:ext>
            </a:extLst>
          </p:cNvPr>
          <p:cNvSpPr txBox="1"/>
          <p:nvPr/>
        </p:nvSpPr>
        <p:spPr>
          <a:xfrm>
            <a:off x="229869" y="645686"/>
            <a:ext cx="17900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AdipoR1-6</a:t>
            </a: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3E83D6E9-A42B-8005-DF3B-8CA2030A9D4E}"/>
              </a:ext>
            </a:extLst>
          </p:cNvPr>
          <p:cNvSpPr/>
          <p:nvPr/>
        </p:nvSpPr>
        <p:spPr>
          <a:xfrm>
            <a:off x="8741094" y="3327948"/>
            <a:ext cx="2225233" cy="32543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rcRect l="73991" r="4606"/>
          <a:stretch>
            <a:fillRect/>
          </a:stretch>
        </p:blipFill>
        <p:spPr>
          <a:xfrm>
            <a:off x="4672891" y="1814830"/>
            <a:ext cx="2077720" cy="331914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rcRect r="73290"/>
          <a:stretch>
            <a:fillRect/>
          </a:stretch>
        </p:blipFill>
        <p:spPr>
          <a:xfrm>
            <a:off x="1999541" y="1814195"/>
            <a:ext cx="2593340" cy="331978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056691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115621" y="24390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125781" y="29165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141021" y="37414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124511" y="47097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750611" y="26015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750611" y="433292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J-K-1</a:t>
            </a:r>
            <a:r>
              <a:rPr lang="zh-CN" altLang="en-US"/>
              <a:t>、</a:t>
            </a:r>
            <a:r>
              <a:rPr lang="en-US" altLang="zh-CN"/>
              <a:t>2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668831" y="1338580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127051" y="18637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7" name="矩形 46"/>
          <p:cNvSpPr/>
          <p:nvPr/>
        </p:nvSpPr>
        <p:spPr>
          <a:xfrm>
            <a:off x="2565961" y="2538095"/>
            <a:ext cx="4159250" cy="372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565961" y="4206240"/>
            <a:ext cx="418465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0F54018-908E-3140-E9BE-586EF4FED3CC}"/>
              </a:ext>
            </a:extLst>
          </p:cNvPr>
          <p:cNvSpPr txBox="1"/>
          <p:nvPr/>
        </p:nvSpPr>
        <p:spPr>
          <a:xfrm>
            <a:off x="11084248" y="245662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33199C0D-4FD4-78CF-7D94-1580B6DAB2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40641" y="1934008"/>
            <a:ext cx="3543607" cy="1013548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CBBF38DD-1BC3-9E19-BEE3-A6EE336BAA11}"/>
              </a:ext>
            </a:extLst>
          </p:cNvPr>
          <p:cNvSpPr/>
          <p:nvPr/>
        </p:nvSpPr>
        <p:spPr>
          <a:xfrm>
            <a:off x="7551474" y="2456628"/>
            <a:ext cx="3524905" cy="331022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21DDBC7-1475-F657-2FE9-D8B7E067BC2D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/>
              <a:t>p-AMPK</a:t>
            </a:r>
            <a:r>
              <a:rPr lang="en-US" altLang="zh-CN" sz="1800" b="1" dirty="0"/>
              <a:t>-1.2</a:t>
            </a:r>
          </a:p>
        </p:txBody>
      </p:sp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9616" y="1863725"/>
            <a:ext cx="4417060" cy="32480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877396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936326" y="23856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46486" y="29610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961726" y="38925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945216" y="47097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90646" y="25539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76676" y="433292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J-K-3</a:t>
            </a:r>
            <a:r>
              <a:rPr lang="zh-CN" altLang="en-US"/>
              <a:t>、</a:t>
            </a:r>
            <a:r>
              <a:rPr lang="en-US" altLang="zh-CN"/>
              <a:t>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489536" y="1338580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947756" y="18637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8" name="矩形 47"/>
          <p:cNvSpPr/>
          <p:nvPr/>
        </p:nvSpPr>
        <p:spPr>
          <a:xfrm>
            <a:off x="2489536" y="4206240"/>
            <a:ext cx="378714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561943" y="2538095"/>
            <a:ext cx="3714734" cy="372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D4477E1-4308-DA3D-75D6-46C36CE2BBDC}"/>
              </a:ext>
            </a:extLst>
          </p:cNvPr>
          <p:cNvSpPr txBox="1"/>
          <p:nvPr/>
        </p:nvSpPr>
        <p:spPr>
          <a:xfrm>
            <a:off x="10506545" y="291020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-AMPK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9FD6A30-EDB5-D5E4-D8C2-D983D57430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04937" y="2317847"/>
            <a:ext cx="3101609" cy="1036410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45801620-063D-105A-13F1-CBCBFC8D3D35}"/>
              </a:ext>
            </a:extLst>
          </p:cNvPr>
          <p:cNvSpPr/>
          <p:nvPr/>
        </p:nvSpPr>
        <p:spPr>
          <a:xfrm>
            <a:off x="7404936" y="2910204"/>
            <a:ext cx="3101609" cy="2609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C933555-B563-C4BC-464E-7708B26EDE57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/>
              <a:t>p-AMPK</a:t>
            </a:r>
            <a:r>
              <a:rPr lang="en-US" altLang="zh-CN" sz="1800" b="1" dirty="0"/>
              <a:t>-3.4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2368588" y="1010211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2851188" y="994336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ctrl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4194213" y="985446"/>
            <a:ext cx="1334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H/R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2873413" y="1322631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275493" y="1322631"/>
            <a:ext cx="1275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508798" y="137851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508798" y="17684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508798" y="227132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508798" y="274947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508798" y="335336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508798" y="422394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993803" y="31454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983643" y="393659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191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4B-2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rcRect r="-2851" b="2246"/>
          <a:stretch>
            <a:fillRect/>
          </a:stretch>
        </p:blipFill>
        <p:spPr>
          <a:xfrm>
            <a:off x="2475268" y="1353746"/>
            <a:ext cx="297815" cy="334454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rcRect t="1655"/>
          <a:stretch>
            <a:fillRect/>
          </a:stretch>
        </p:blipFill>
        <p:spPr>
          <a:xfrm>
            <a:off x="2783243" y="1378511"/>
            <a:ext cx="3200400" cy="331978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988983" y="3856281"/>
            <a:ext cx="2994660" cy="3867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988983" y="3106981"/>
            <a:ext cx="2994660" cy="322019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0637BFD-8FC5-55C2-A00C-482A4C71E446}"/>
              </a:ext>
            </a:extLst>
          </p:cNvPr>
          <p:cNvSpPr txBox="1"/>
          <p:nvPr/>
        </p:nvSpPr>
        <p:spPr>
          <a:xfrm>
            <a:off x="9274772" y="35597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LKBH5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360EDEB-4AB9-021E-4164-A1EF8C146B9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58727" y="3282268"/>
            <a:ext cx="2453853" cy="800169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2DB766D1-B855-AE5E-4420-0F8FA4F4444B}"/>
              </a:ext>
            </a:extLst>
          </p:cNvPr>
          <p:cNvSpPr/>
          <p:nvPr/>
        </p:nvSpPr>
        <p:spPr>
          <a:xfrm>
            <a:off x="6758727" y="3484074"/>
            <a:ext cx="2453853" cy="322019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D3AEDAD-9DA1-939A-3403-85D10D87670B}"/>
              </a:ext>
            </a:extLst>
          </p:cNvPr>
          <p:cNvSpPr txBox="1"/>
          <p:nvPr/>
        </p:nvSpPr>
        <p:spPr>
          <a:xfrm>
            <a:off x="233849" y="1567691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2</a:t>
            </a:r>
          </a:p>
        </p:txBody>
      </p:sp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rcRect r="64165"/>
          <a:stretch>
            <a:fillRect/>
          </a:stretch>
        </p:blipFill>
        <p:spPr>
          <a:xfrm>
            <a:off x="1862493" y="1765935"/>
            <a:ext cx="2538730" cy="332613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rcRect l="72761"/>
          <a:stretch>
            <a:fillRect/>
          </a:stretch>
        </p:blipFill>
        <p:spPr>
          <a:xfrm>
            <a:off x="4450753" y="1767205"/>
            <a:ext cx="1928495" cy="332359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841538" y="127254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900468" y="24936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10628" y="28644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925868" y="37960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909358" y="47377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379248" y="25615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470036" y="439860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J-K-5</a:t>
            </a:r>
            <a:r>
              <a:rPr lang="zh-CN" altLang="en-US"/>
              <a:t>、</a:t>
            </a:r>
            <a:r>
              <a:rPr lang="en-US" altLang="zh-CN"/>
              <a:t>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453678" y="1242060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911898" y="18649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8" name="矩形 47"/>
          <p:cNvSpPr/>
          <p:nvPr/>
        </p:nvSpPr>
        <p:spPr>
          <a:xfrm>
            <a:off x="2350807" y="4296410"/>
            <a:ext cx="2050415" cy="55513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72728" y="2503804"/>
            <a:ext cx="1928495" cy="3994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4450753" y="2503803"/>
            <a:ext cx="1928495" cy="39941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4450753" y="4296410"/>
            <a:ext cx="1928496" cy="555134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C17932D-4125-77E3-B713-548718316937}"/>
              </a:ext>
            </a:extLst>
          </p:cNvPr>
          <p:cNvSpPr txBox="1"/>
          <p:nvPr/>
        </p:nvSpPr>
        <p:spPr>
          <a:xfrm>
            <a:off x="8818454" y="1563369"/>
            <a:ext cx="2625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04EBAB1-B003-ADA8-4143-D8795E811739}"/>
              </a:ext>
            </a:extLst>
          </p:cNvPr>
          <p:cNvSpPr txBox="1"/>
          <p:nvPr/>
        </p:nvSpPr>
        <p:spPr>
          <a:xfrm>
            <a:off x="10926601" y="26162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-AMPK</a:t>
            </a: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A2E5685B-0E1E-9033-E69C-EB4340DE04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26855" y="2025599"/>
            <a:ext cx="3299746" cy="1181202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1B9E01F5-ADA6-5295-9799-85621EB63EE8}"/>
              </a:ext>
            </a:extLst>
          </p:cNvPr>
          <p:cNvSpPr/>
          <p:nvPr/>
        </p:nvSpPr>
        <p:spPr>
          <a:xfrm>
            <a:off x="9336032" y="2581759"/>
            <a:ext cx="1590570" cy="39941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C019417F-2C9C-8BF8-ACAF-A71479FF755D}"/>
              </a:ext>
            </a:extLst>
          </p:cNvPr>
          <p:cNvSpPr/>
          <p:nvPr/>
        </p:nvSpPr>
        <p:spPr>
          <a:xfrm>
            <a:off x="7686159" y="2623651"/>
            <a:ext cx="1590570" cy="36830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CF02022-B9BE-76DD-4CBE-D8588E86080F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/>
              <a:t>p-AMPK</a:t>
            </a:r>
            <a:r>
              <a:rPr lang="en-US" altLang="zh-CN" sz="1800" b="1" dirty="0"/>
              <a:t>-5.6</a:t>
            </a:r>
          </a:p>
        </p:txBody>
      </p:sp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0952" y="1592440"/>
            <a:ext cx="4592320" cy="381571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698102" y="120890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57032" y="21721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67192" y="28008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782432" y="38568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765922" y="49674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33272" y="25385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21842" y="43871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J-K-7</a:t>
            </a:r>
            <a:r>
              <a:rPr lang="zh-CN" altLang="en-US"/>
              <a:t>、</a:t>
            </a:r>
            <a:r>
              <a:rPr lang="en-US" altLang="zh-CN"/>
              <a:t>8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310242" y="1178420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68462" y="16502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8" name="矩形 47"/>
          <p:cNvSpPr/>
          <p:nvPr/>
        </p:nvSpPr>
        <p:spPr>
          <a:xfrm>
            <a:off x="2047987" y="4232770"/>
            <a:ext cx="418528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082609" y="2440165"/>
            <a:ext cx="4150664" cy="372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88618F1-329C-33D2-314C-F3E2F5D97B02}"/>
              </a:ext>
            </a:extLst>
          </p:cNvPr>
          <p:cNvSpPr txBox="1"/>
          <p:nvPr/>
        </p:nvSpPr>
        <p:spPr>
          <a:xfrm>
            <a:off x="10421620" y="25589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8B99146-6072-1C65-E1CE-144C9CB28158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/>
              <a:t>AMPK</a:t>
            </a:r>
            <a:r>
              <a:rPr lang="en-US" altLang="zh-CN" sz="1800" b="1" dirty="0"/>
              <a:t>-7.8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D91A76A-0705-C48B-0ADC-835BA4D724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92323" y="1803840"/>
            <a:ext cx="3429297" cy="1272650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86FA5FFA-8E2C-F80B-5FEB-39B9FB5105A5}"/>
              </a:ext>
            </a:extLst>
          </p:cNvPr>
          <p:cNvSpPr/>
          <p:nvPr/>
        </p:nvSpPr>
        <p:spPr>
          <a:xfrm>
            <a:off x="6992323" y="2440165"/>
            <a:ext cx="3429297" cy="372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rcRect l="28079" r="49752"/>
          <a:stretch>
            <a:fillRect/>
          </a:stretch>
        </p:blipFill>
        <p:spPr>
          <a:xfrm>
            <a:off x="2563121" y="1737360"/>
            <a:ext cx="2175510" cy="393509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rcRect l="77233"/>
          <a:stretch>
            <a:fillRect/>
          </a:stretch>
        </p:blipFill>
        <p:spPr>
          <a:xfrm>
            <a:off x="4852931" y="1737360"/>
            <a:ext cx="2233930" cy="393509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986541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832111" y="23856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42271" y="30676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57511" y="40170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41001" y="51276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107480" y="27114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107480" y="460851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J-K-9</a:t>
            </a:r>
            <a:r>
              <a:rPr lang="zh-CN" altLang="en-US"/>
              <a:t>、</a:t>
            </a:r>
            <a:r>
              <a:rPr lang="en-US" altLang="zh-CN"/>
              <a:t>10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563756" y="1338580"/>
            <a:ext cx="44945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  1         2        3               1        2 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43541" y="18103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rcRect r="93754"/>
          <a:stretch>
            <a:fillRect/>
          </a:stretch>
        </p:blipFill>
        <p:spPr>
          <a:xfrm>
            <a:off x="1805566" y="1737995"/>
            <a:ext cx="612775" cy="393446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625985" y="2600325"/>
            <a:ext cx="4432301" cy="46736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563120" y="4481830"/>
            <a:ext cx="4432301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813CC69-5C36-DED9-F7E6-E5D6BF7438F0}"/>
              </a:ext>
            </a:extLst>
          </p:cNvPr>
          <p:cNvSpPr txBox="1"/>
          <p:nvPr/>
        </p:nvSpPr>
        <p:spPr>
          <a:xfrm>
            <a:off x="11298805" y="20689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MPK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53D561B-3EFC-2AB0-5C3C-C6E371A60F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49440" y="1453463"/>
            <a:ext cx="3749365" cy="1204064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9E8423C1-A2CC-3426-5A07-D39324A4B540}"/>
              </a:ext>
            </a:extLst>
          </p:cNvPr>
          <p:cNvSpPr/>
          <p:nvPr/>
        </p:nvSpPr>
        <p:spPr>
          <a:xfrm>
            <a:off x="7578016" y="1983449"/>
            <a:ext cx="3720790" cy="46736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44464CE-B4AF-85A0-8234-026F8BAAE5AD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/>
              <a:t>AMPK</a:t>
            </a:r>
            <a:r>
              <a:rPr lang="en-US" altLang="zh-CN" sz="1800" b="1" dirty="0"/>
              <a:t>-9.10</a:t>
            </a:r>
          </a:p>
        </p:txBody>
      </p:sp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7734" y="1523253"/>
            <a:ext cx="4843145" cy="356298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623294" y="1081928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682224" y="220524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692384" y="278055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707624" y="372987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91114" y="48404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470548" y="23560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MPK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508984" y="423216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177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J-K-11</a:t>
            </a:r>
            <a:r>
              <a:rPr lang="zh-CN" altLang="en-US"/>
              <a:t>、</a:t>
            </a:r>
            <a:r>
              <a:rPr lang="en-US" altLang="zh-CN"/>
              <a:t>12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235434" y="1051448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693654" y="163882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7" name="矩形 46"/>
          <p:cNvSpPr/>
          <p:nvPr/>
        </p:nvSpPr>
        <p:spPr>
          <a:xfrm>
            <a:off x="2174968" y="2313192"/>
            <a:ext cx="2151949" cy="4362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044501" y="4105798"/>
            <a:ext cx="2198269" cy="458469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4362890" y="2313192"/>
            <a:ext cx="2078149" cy="43624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4242770" y="4105798"/>
            <a:ext cx="2198269" cy="51586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0A7CBBB-0A61-23B1-2746-D2E6B917DDD8}"/>
              </a:ext>
            </a:extLst>
          </p:cNvPr>
          <p:cNvSpPr txBox="1"/>
          <p:nvPr/>
        </p:nvSpPr>
        <p:spPr>
          <a:xfrm>
            <a:off x="11308080" y="265799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AMPK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74ECCE4-EEB9-91A4-DB96-214C3C0C8EB5}"/>
              </a:ext>
            </a:extLst>
          </p:cNvPr>
          <p:cNvSpPr txBox="1"/>
          <p:nvPr/>
        </p:nvSpPr>
        <p:spPr>
          <a:xfrm>
            <a:off x="8941997" y="1515633"/>
            <a:ext cx="104770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>
                <a:solidFill>
                  <a:srgbClr val="FF0000"/>
                </a:solidFill>
              </a:rPr>
              <a:t>SHOW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663D8C5D-16AC-EC70-4B1B-7888C0B94C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90236" y="2043564"/>
            <a:ext cx="3551228" cy="1272650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01A3F9F6-2EDC-F833-D2C9-C30C0270C832}"/>
              </a:ext>
            </a:extLst>
          </p:cNvPr>
          <p:cNvSpPr/>
          <p:nvPr/>
        </p:nvSpPr>
        <p:spPr>
          <a:xfrm>
            <a:off x="7707586" y="2589418"/>
            <a:ext cx="1735505" cy="4362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9E98E3EF-E48C-C1DB-071D-4DD417545DDF}"/>
              </a:ext>
            </a:extLst>
          </p:cNvPr>
          <p:cNvSpPr/>
          <p:nvPr/>
        </p:nvSpPr>
        <p:spPr>
          <a:xfrm>
            <a:off x="9505959" y="2589418"/>
            <a:ext cx="1735505" cy="43624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9A4C4D1-757E-3B9C-E37D-0C4C7EB2029E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/>
              <a:t>AMPK</a:t>
            </a:r>
            <a:r>
              <a:rPr lang="en-US" altLang="zh-CN" sz="1800" b="1" dirty="0"/>
              <a:t>-11.12</a:t>
            </a:r>
          </a:p>
        </p:txBody>
      </p:sp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rcRect l="36406" r="36670"/>
          <a:stretch>
            <a:fillRect/>
          </a:stretch>
        </p:blipFill>
        <p:spPr>
          <a:xfrm>
            <a:off x="1799254" y="1752824"/>
            <a:ext cx="1720850" cy="312356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rcRect l="71776"/>
          <a:stretch>
            <a:fillRect/>
          </a:stretch>
        </p:blipFill>
        <p:spPr>
          <a:xfrm>
            <a:off x="3740449" y="1752824"/>
            <a:ext cx="1804035" cy="312356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187114" y="1198469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246044" y="232178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256204" y="27853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271444" y="358225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254934" y="44490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483524" y="258347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483524" y="407890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799254" y="1167989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257474" y="175536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L-M-1</a:t>
            </a:r>
            <a:r>
              <a:rPr lang="zh-CN" altLang="en-US"/>
              <a:t>、</a:t>
            </a:r>
            <a:r>
              <a:rPr lang="en-US" altLang="zh-CN"/>
              <a:t>2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r="91648"/>
          <a:stretch>
            <a:fillRect/>
          </a:stretch>
        </p:blipFill>
        <p:spPr>
          <a:xfrm>
            <a:off x="1150284" y="1755364"/>
            <a:ext cx="533400" cy="312102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1790065" y="3927699"/>
            <a:ext cx="368737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799254" y="2575784"/>
            <a:ext cx="3745230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D3672B7-45BD-45E2-B7BE-1611A9185955}"/>
              </a:ext>
            </a:extLst>
          </p:cNvPr>
          <p:cNvSpPr txBox="1"/>
          <p:nvPr/>
        </p:nvSpPr>
        <p:spPr>
          <a:xfrm>
            <a:off x="9508826" y="25402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p65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90514940-4F68-F7DF-D1AB-82389EFC60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55665" y="1968645"/>
            <a:ext cx="1463167" cy="91447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B923F761-D964-59BE-7571-DF723696B6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07053" y="1930541"/>
            <a:ext cx="1463167" cy="952583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BD947F15-1092-4159-8E75-F416964EFBDC}"/>
              </a:ext>
            </a:extLst>
          </p:cNvPr>
          <p:cNvSpPr/>
          <p:nvPr/>
        </p:nvSpPr>
        <p:spPr>
          <a:xfrm>
            <a:off x="6455665" y="2509408"/>
            <a:ext cx="3014555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4B5D42B-F9A9-AB57-01D9-378FF653CCFC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p</a:t>
            </a:r>
            <a:r>
              <a:rPr lang="en-US" altLang="zh-CN" sz="1800" b="1" dirty="0"/>
              <a:t>p65-1.2</a:t>
            </a:r>
          </a:p>
        </p:txBody>
      </p:sp>
    </p:spTree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35BB930B-8559-ADBA-6499-09B2DEA04C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66947" y="2027779"/>
            <a:ext cx="1569856" cy="101354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rcRect t="2544"/>
          <a:stretch>
            <a:fillRect/>
          </a:stretch>
        </p:blipFill>
        <p:spPr>
          <a:xfrm>
            <a:off x="4517913" y="1744345"/>
            <a:ext cx="2039620" cy="301688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6"/>
          <a:srcRect l="55365"/>
          <a:stretch>
            <a:fillRect/>
          </a:stretch>
        </p:blipFill>
        <p:spPr>
          <a:xfrm>
            <a:off x="2470038" y="1744345"/>
            <a:ext cx="1918335" cy="312039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34073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93003" y="24479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7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803163" y="29648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18403" y="38239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01893" y="45840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06725" y="24479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606725" y="414053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346213" y="1338580"/>
            <a:ext cx="2042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04433" y="20059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L-M-3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6"/>
          <a:srcRect r="85445"/>
          <a:stretch>
            <a:fillRect/>
          </a:stretch>
        </p:blipFill>
        <p:spPr>
          <a:xfrm>
            <a:off x="1715023" y="1744345"/>
            <a:ext cx="625475" cy="311975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470038" y="3991610"/>
            <a:ext cx="408749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527824" y="2453005"/>
            <a:ext cx="3908836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BECA147-AF2C-E3D3-6F0D-274E8DA026B2}"/>
              </a:ext>
            </a:extLst>
          </p:cNvPr>
          <p:cNvSpPr txBox="1"/>
          <p:nvPr/>
        </p:nvSpPr>
        <p:spPr>
          <a:xfrm>
            <a:off x="9436803" y="252214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p65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B820A892-6DE0-2D63-DA29-05C3EFE4D9A0}"/>
              </a:ext>
            </a:extLst>
          </p:cNvPr>
          <p:cNvSpPr/>
          <p:nvPr/>
        </p:nvSpPr>
        <p:spPr>
          <a:xfrm>
            <a:off x="7866947" y="2491031"/>
            <a:ext cx="1549144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CD3EEFD-2F61-4602-623E-18EB5DA2806B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p</a:t>
            </a:r>
            <a:r>
              <a:rPr lang="en-US" altLang="zh-CN" sz="1800" b="1" dirty="0"/>
              <a:t>p65-</a:t>
            </a:r>
            <a:r>
              <a:rPr lang="en-US" altLang="zh-CN" b="1" dirty="0"/>
              <a:t>3</a:t>
            </a:r>
            <a:endParaRPr lang="en-US" altLang="zh-CN" sz="1800" b="1" dirty="0"/>
          </a:p>
        </p:txBody>
      </p:sp>
    </p:spTree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b="3019"/>
          <a:stretch>
            <a:fillRect/>
          </a:stretch>
        </p:blipFill>
        <p:spPr>
          <a:xfrm>
            <a:off x="4589780" y="1827847"/>
            <a:ext cx="2510155" cy="320230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F3AE4222-F83F-1C74-7203-D68E79D084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20832" y="2260883"/>
            <a:ext cx="1638442" cy="78492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88465" y="1810702"/>
            <a:ext cx="2629535" cy="321945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27835" y="1386522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86765" y="234092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96925" y="29733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12165" y="386810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795655" y="46370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7118424" y="240823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7118424" y="424282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339975" y="1356042"/>
            <a:ext cx="1978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98195" y="182784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L-M-4</a:t>
            </a:r>
          </a:p>
        </p:txBody>
      </p:sp>
      <p:sp>
        <p:nvSpPr>
          <p:cNvPr id="48" name="矩形 47"/>
          <p:cNvSpPr/>
          <p:nvPr/>
        </p:nvSpPr>
        <p:spPr>
          <a:xfrm>
            <a:off x="2237104" y="4115752"/>
            <a:ext cx="4782261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20472" y="2408237"/>
            <a:ext cx="4679464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BB22F24-DCC1-A63E-64E7-450AD737A77C}"/>
              </a:ext>
            </a:extLst>
          </p:cNvPr>
          <p:cNvSpPr txBox="1"/>
          <p:nvPr/>
        </p:nvSpPr>
        <p:spPr>
          <a:xfrm>
            <a:off x="9587378" y="24568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p65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3F21DFBC-921B-6DC8-1AB6-1B61D0CEA181}"/>
              </a:ext>
            </a:extLst>
          </p:cNvPr>
          <p:cNvSpPr/>
          <p:nvPr/>
        </p:nvSpPr>
        <p:spPr>
          <a:xfrm>
            <a:off x="8050825" y="2473608"/>
            <a:ext cx="1562235" cy="245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3FDDE11-27F0-B7E0-F606-4518F7BC79D8}"/>
              </a:ext>
            </a:extLst>
          </p:cNvPr>
          <p:cNvSpPr txBox="1"/>
          <p:nvPr/>
        </p:nvSpPr>
        <p:spPr>
          <a:xfrm>
            <a:off x="382270" y="7980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p</a:t>
            </a:r>
            <a:r>
              <a:rPr lang="en-US" altLang="zh-CN" sz="1800" b="1" dirty="0"/>
              <a:t>p65-4</a:t>
            </a:r>
          </a:p>
        </p:txBody>
      </p:sp>
    </p:spTree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2404" y="1720178"/>
            <a:ext cx="4614545" cy="37414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641074" y="1243293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682224" y="236660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692384" y="31324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707624" y="410714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91114" y="507170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790091" y="23885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736949" y="449036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351004" y="1212813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693654" y="180018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L-M-5</a:t>
            </a:r>
            <a:r>
              <a:rPr lang="zh-CN" altLang="en-US"/>
              <a:t>、</a:t>
            </a:r>
            <a:r>
              <a:rPr lang="en-US" altLang="zh-CN"/>
              <a:t>6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rcRect r="91980"/>
          <a:stretch>
            <a:fillRect/>
          </a:stretch>
        </p:blipFill>
        <p:spPr>
          <a:xfrm>
            <a:off x="1569319" y="1720178"/>
            <a:ext cx="553085" cy="376872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240715" y="4345903"/>
            <a:ext cx="200414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240715" y="2361527"/>
            <a:ext cx="1797105" cy="41338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4707387" y="2388514"/>
            <a:ext cx="1982847" cy="413386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4676176" y="4345903"/>
            <a:ext cx="2060773" cy="49847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B3C9EE7-6F0E-71B2-BF60-B986D79A383C}"/>
              </a:ext>
            </a:extLst>
          </p:cNvPr>
          <p:cNvSpPr txBox="1"/>
          <p:nvPr/>
        </p:nvSpPr>
        <p:spPr>
          <a:xfrm>
            <a:off x="11270713" y="24003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p65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33832D5-76C7-0816-3112-2B6177432DA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57648" y="1946932"/>
            <a:ext cx="3787468" cy="1158340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6B37DDBE-18E9-B1DA-5369-B7154F6715CF}"/>
              </a:ext>
            </a:extLst>
          </p:cNvPr>
          <p:cNvSpPr/>
          <p:nvPr/>
        </p:nvSpPr>
        <p:spPr>
          <a:xfrm>
            <a:off x="9526929" y="2400301"/>
            <a:ext cx="1618187" cy="329248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C9117BA3-63C8-3D55-B0EC-E166CA6DDBDA}"/>
              </a:ext>
            </a:extLst>
          </p:cNvPr>
          <p:cNvSpPr/>
          <p:nvPr/>
        </p:nvSpPr>
        <p:spPr>
          <a:xfrm>
            <a:off x="7357648" y="2361527"/>
            <a:ext cx="1618187" cy="38234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F12B62D-3576-5536-2F11-D35A19872F09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p</a:t>
            </a:r>
            <a:r>
              <a:rPr lang="en-US" altLang="zh-CN" sz="1800" b="1" dirty="0"/>
              <a:t>p65-5.6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F9DB1CA-A824-6D31-C82A-7D8CFD2F3923}"/>
              </a:ext>
            </a:extLst>
          </p:cNvPr>
          <p:cNvSpPr txBox="1"/>
          <p:nvPr/>
        </p:nvSpPr>
        <p:spPr>
          <a:xfrm>
            <a:off x="9414106" y="1478677"/>
            <a:ext cx="173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</p:spTree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7758" y="1802765"/>
            <a:ext cx="4816475" cy="378714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456343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497493" y="24923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507653" y="32581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22893" y="42329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506383" y="51974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38240" y="24396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164580" y="481333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166273" y="1338580"/>
            <a:ext cx="4159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508923" y="19259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6L-M-7</a:t>
            </a:r>
            <a:r>
              <a:rPr lang="zh-CN" altLang="en-US" dirty="0"/>
              <a:t>、</a:t>
            </a:r>
            <a:r>
              <a:rPr lang="en-US" altLang="zh-CN" dirty="0"/>
              <a:t>8</a:t>
            </a:r>
          </a:p>
        </p:txBody>
      </p:sp>
      <p:sp>
        <p:nvSpPr>
          <p:cNvPr id="47" name="矩形 46"/>
          <p:cNvSpPr/>
          <p:nvPr/>
        </p:nvSpPr>
        <p:spPr>
          <a:xfrm>
            <a:off x="1965613" y="2408555"/>
            <a:ext cx="4130387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790065" y="4631690"/>
            <a:ext cx="4318288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3505A5E-EA69-70DD-C978-B52D98DEB20E}"/>
              </a:ext>
            </a:extLst>
          </p:cNvPr>
          <p:cNvSpPr txBox="1"/>
          <p:nvPr/>
        </p:nvSpPr>
        <p:spPr>
          <a:xfrm>
            <a:off x="10399358" y="23637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65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372EBD3-0628-1DA7-D390-AC84F4F9D7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8845" y="1925900"/>
            <a:ext cx="3505504" cy="1272650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1201C364-0461-A962-5335-94170EFF2FFA}"/>
              </a:ext>
            </a:extLst>
          </p:cNvPr>
          <p:cNvSpPr/>
          <p:nvPr/>
        </p:nvSpPr>
        <p:spPr>
          <a:xfrm>
            <a:off x="6690362" y="2301510"/>
            <a:ext cx="3483988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221862D-7761-52EF-DA7E-53FC0A063298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65-7.8</a:t>
            </a:r>
          </a:p>
        </p:txBody>
      </p:sp>
    </p:spTree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rcRect l="56825"/>
          <a:stretch>
            <a:fillRect/>
          </a:stretch>
        </p:blipFill>
        <p:spPr>
          <a:xfrm>
            <a:off x="2346101" y="1737360"/>
            <a:ext cx="1969135" cy="141033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733961" y="136906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792891" y="23679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03051" y="29648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18291" y="38862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01781" y="46640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388896" y="22396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309970" y="420232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346101" y="1338580"/>
            <a:ext cx="2042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04321" y="17926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6L-M-9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r="85515"/>
          <a:stretch>
            <a:fillRect/>
          </a:stretch>
        </p:blipFill>
        <p:spPr>
          <a:xfrm>
            <a:off x="1660936" y="1737360"/>
            <a:ext cx="661035" cy="141160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rcRect r="85515"/>
          <a:stretch>
            <a:fillRect/>
          </a:stretch>
        </p:blipFill>
        <p:spPr>
          <a:xfrm>
            <a:off x="1660936" y="3204210"/>
            <a:ext cx="661035" cy="183832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rcRect l="56825"/>
          <a:stretch>
            <a:fillRect/>
          </a:stretch>
        </p:blipFill>
        <p:spPr>
          <a:xfrm>
            <a:off x="2345466" y="3209925"/>
            <a:ext cx="1969135" cy="183705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345466" y="2239645"/>
            <a:ext cx="1969136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361976" y="4089400"/>
            <a:ext cx="195262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ECA6A31-707A-CDAB-3393-870F65A22306}"/>
              </a:ext>
            </a:extLst>
          </p:cNvPr>
          <p:cNvSpPr txBox="1"/>
          <p:nvPr/>
        </p:nvSpPr>
        <p:spPr>
          <a:xfrm>
            <a:off x="7178517" y="213948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65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19C90D84-EF17-27DC-5776-638D32FBE5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62937" y="1871300"/>
            <a:ext cx="1615580" cy="1044030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6800D3D0-B00A-3D8A-01D4-3807EB53DB32}"/>
              </a:ext>
            </a:extLst>
          </p:cNvPr>
          <p:cNvSpPr/>
          <p:nvPr/>
        </p:nvSpPr>
        <p:spPr>
          <a:xfrm>
            <a:off x="5562937" y="2135187"/>
            <a:ext cx="1615580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48AE964-07BF-EC3C-19D4-9AF6C54DBEF8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65-9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1596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B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  <a:r>
              <a:rPr lang="zh-CN" altLang="en-US" dirty="0"/>
              <a:t>、</a:t>
            </a:r>
            <a:r>
              <a:rPr lang="en-US" altLang="zh-CN" dirty="0"/>
              <a:t>3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9881870" y="292100"/>
            <a:ext cx="2028190" cy="881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si-circDhx32</a:t>
            </a:r>
          </a:p>
        </p:txBody>
      </p:sp>
      <p:grpSp>
        <p:nvGrpSpPr>
          <p:cNvPr id="11" name="组合 10"/>
          <p:cNvGrpSpPr/>
          <p:nvPr/>
        </p:nvGrpSpPr>
        <p:grpSpPr>
          <a:xfrm>
            <a:off x="1359894" y="992791"/>
            <a:ext cx="5319395" cy="3689350"/>
            <a:chOff x="9268" y="2037"/>
            <a:chExt cx="8377" cy="5810"/>
          </a:xfrm>
        </p:grpSpPr>
        <p:sp>
          <p:nvSpPr>
            <p:cNvPr id="33" name="文本框 32"/>
            <p:cNvSpPr txBox="1"/>
            <p:nvPr/>
          </p:nvSpPr>
          <p:spPr>
            <a:xfrm>
              <a:off x="10563" y="2085"/>
              <a:ext cx="80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/>
                <a:t>M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9269" y="3886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100 kD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9299" y="4517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70 kD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9284" y="5348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55 kD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9269" y="6224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40 kD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9299" y="7291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35 kD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16253" y="4464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/>
                <a:t>Lamin B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9289" y="3302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130 kD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1365" y="2037"/>
              <a:ext cx="480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 1     2     1     2           1      2</a:t>
              </a: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661" y="2724"/>
              <a:ext cx="5512" cy="5123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9268" y="2856"/>
              <a:ext cx="1392" cy="3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b="1"/>
                <a:t>170 kD</a:t>
              </a:r>
            </a:p>
          </p:txBody>
        </p:sp>
        <p:sp>
          <p:nvSpPr>
            <p:cNvPr id="47" name="矩形 46"/>
            <p:cNvSpPr/>
            <p:nvPr/>
          </p:nvSpPr>
          <p:spPr>
            <a:xfrm>
              <a:off x="10563" y="4387"/>
              <a:ext cx="5610" cy="59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6" name="文本框 15"/>
          <p:cNvSpPr txBox="1"/>
          <p:nvPr/>
        </p:nvSpPr>
        <p:spPr>
          <a:xfrm>
            <a:off x="10334775" y="242880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78492" y="1877346"/>
            <a:ext cx="3420110" cy="2099284"/>
          </a:xfrm>
          <a:prstGeom prst="rect">
            <a:avLst/>
          </a:prstGeom>
        </p:spPr>
      </p:pic>
      <p:sp>
        <p:nvSpPr>
          <p:cNvPr id="15" name="矩形 14"/>
          <p:cNvSpPr/>
          <p:nvPr/>
        </p:nvSpPr>
        <p:spPr>
          <a:xfrm>
            <a:off x="6923444" y="2447216"/>
            <a:ext cx="3330204" cy="245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74BB4A5-FDCD-8259-4FE8-5FF70EDD3F8F}"/>
              </a:ext>
            </a:extLst>
          </p:cNvPr>
          <p:cNvSpPr txBox="1"/>
          <p:nvPr/>
        </p:nvSpPr>
        <p:spPr>
          <a:xfrm>
            <a:off x="9811688" y="53086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AA45743-B118-A906-F93F-238F4B028B41}"/>
              </a:ext>
            </a:extLst>
          </p:cNvPr>
          <p:cNvSpPr txBox="1"/>
          <p:nvPr/>
        </p:nvSpPr>
        <p:spPr>
          <a:xfrm>
            <a:off x="5254797" y="534916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Lamin B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9578A168-6702-D51E-7726-3455CD1728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92877" y="5087902"/>
            <a:ext cx="2644369" cy="77730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1A3E66D-B7DB-0F22-5EB4-79C0AE7C7A9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46379" y="5197377"/>
            <a:ext cx="2484335" cy="548688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F8EC65E8-8177-67E9-8A8E-EC06D3C3A91C}"/>
              </a:ext>
            </a:extLst>
          </p:cNvPr>
          <p:cNvSpPr/>
          <p:nvPr/>
        </p:nvSpPr>
        <p:spPr>
          <a:xfrm>
            <a:off x="2592877" y="5283126"/>
            <a:ext cx="2644369" cy="37719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CC92FC36-902C-88E5-DE52-77BB45407FD2}"/>
              </a:ext>
            </a:extLst>
          </p:cNvPr>
          <p:cNvSpPr/>
          <p:nvPr/>
        </p:nvSpPr>
        <p:spPr>
          <a:xfrm>
            <a:off x="7346379" y="5349166"/>
            <a:ext cx="2484335" cy="16412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04DB77B-A2CE-9F7A-9045-CD5DB53A0F78}"/>
              </a:ext>
            </a:extLst>
          </p:cNvPr>
          <p:cNvSpPr txBox="1"/>
          <p:nvPr/>
        </p:nvSpPr>
        <p:spPr>
          <a:xfrm>
            <a:off x="225971" y="1505835"/>
            <a:ext cx="130878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Lamin B-1.2.3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88FC9E2-81AA-B022-9FBE-34E4C1246633}"/>
              </a:ext>
            </a:extLst>
          </p:cNvPr>
          <p:cNvSpPr txBox="1"/>
          <p:nvPr/>
        </p:nvSpPr>
        <p:spPr>
          <a:xfrm>
            <a:off x="7948206" y="1138394"/>
            <a:ext cx="130878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1.2.3</a:t>
            </a:r>
          </a:p>
        </p:txBody>
      </p:sp>
    </p:spTree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7987" y="1522020"/>
            <a:ext cx="2483485" cy="161861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1987987" y="1162610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046917" y="21614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057077" y="28917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072317" y="39909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055807" y="47776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528622" y="203063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493372" y="436523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600127" y="1132130"/>
            <a:ext cx="2042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+si-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058347" y="15861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6L-M-10</a:t>
            </a: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5607" y="3152065"/>
            <a:ext cx="2482850" cy="209486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2497257" y="4238550"/>
            <a:ext cx="1920468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600127" y="2033195"/>
            <a:ext cx="1871345" cy="3073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5C8B6A6-2193-F74D-4463-B9685F795C0C}"/>
              </a:ext>
            </a:extLst>
          </p:cNvPr>
          <p:cNvSpPr txBox="1"/>
          <p:nvPr/>
        </p:nvSpPr>
        <p:spPr>
          <a:xfrm>
            <a:off x="7158835" y="203063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65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5F0AEDA7-4CEB-A20D-3281-A797986D14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88979" y="1639450"/>
            <a:ext cx="1569856" cy="1044030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40732CAC-3ED5-80DC-CA4E-800758573F5B}"/>
              </a:ext>
            </a:extLst>
          </p:cNvPr>
          <p:cNvSpPr/>
          <p:nvPr/>
        </p:nvSpPr>
        <p:spPr>
          <a:xfrm>
            <a:off x="5588980" y="2057672"/>
            <a:ext cx="1569856" cy="245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DBC2DDB-FC53-3658-92F7-267B546BDF92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65-10</a:t>
            </a:r>
          </a:p>
        </p:txBody>
      </p:sp>
    </p:spTree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3244" y="1708007"/>
            <a:ext cx="4510405" cy="358648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874544" y="244333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84704" y="30580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99944" y="405941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83434" y="49439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512635" y="23813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p6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412379" y="44506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02609" y="1173972"/>
            <a:ext cx="4510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3        </a:t>
            </a:r>
            <a:r>
              <a:rPr lang="en-US" altLang="zh-CN" b="1"/>
              <a:t>M  </a:t>
            </a:r>
            <a:r>
              <a:rPr lang="en-US" altLang="zh-CN"/>
              <a:t>    1        2         3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1337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 err="1"/>
              <a:t>HR+si-NC</a:t>
            </a:r>
            <a:endParaRPr lang="en-US" altLang="zh-CN" b="1" dirty="0"/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3</a:t>
            </a:r>
            <a:r>
              <a:rPr lang="zh-CN" altLang="en-US" b="1" dirty="0"/>
              <a:t>：</a:t>
            </a:r>
            <a:r>
              <a:rPr lang="en-US" altLang="zh-CN" b="1" dirty="0"/>
              <a:t>HR+si-circDhx3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85974" y="188580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9310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6L-M-11</a:t>
            </a:r>
            <a:r>
              <a:rPr lang="zh-CN" altLang="en-US"/>
              <a:t>、</a:t>
            </a:r>
            <a:r>
              <a:rPr lang="en-US" altLang="zh-CN"/>
              <a:t>12</a:t>
            </a:r>
          </a:p>
        </p:txBody>
      </p:sp>
      <p:sp>
        <p:nvSpPr>
          <p:cNvPr id="48" name="矩形 47"/>
          <p:cNvSpPr/>
          <p:nvPr/>
        </p:nvSpPr>
        <p:spPr>
          <a:xfrm>
            <a:off x="1902609" y="4324842"/>
            <a:ext cx="2012995" cy="44184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902609" y="2375391"/>
            <a:ext cx="1963654" cy="25104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4450191" y="2404067"/>
            <a:ext cx="1962824" cy="251043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4400019" y="4312255"/>
            <a:ext cx="2012995" cy="52197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C7D97DC-0A4F-E433-A52D-14CAEF2DC568}"/>
              </a:ext>
            </a:extLst>
          </p:cNvPr>
          <p:cNvSpPr txBox="1"/>
          <p:nvPr/>
        </p:nvSpPr>
        <p:spPr>
          <a:xfrm>
            <a:off x="11374597" y="24040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p65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EFC25CD-2289-AFFE-E924-1125F420E7D6}"/>
              </a:ext>
            </a:extLst>
          </p:cNvPr>
          <p:cNvSpPr txBox="1"/>
          <p:nvPr/>
        </p:nvSpPr>
        <p:spPr>
          <a:xfrm>
            <a:off x="10029679" y="1417686"/>
            <a:ext cx="11083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7388FCE-0C2B-2660-F5EF-1CA03C0CBD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87129" y="1895274"/>
            <a:ext cx="3787468" cy="1341236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EA24C276-5908-9E09-3A15-EBCCF73A73CE}"/>
              </a:ext>
            </a:extLst>
          </p:cNvPr>
          <p:cNvSpPr/>
          <p:nvPr/>
        </p:nvSpPr>
        <p:spPr>
          <a:xfrm>
            <a:off x="7586495" y="2443337"/>
            <a:ext cx="1665081" cy="1748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2DD7FBC5-BF32-F961-7419-695C5E2D3860}"/>
              </a:ext>
            </a:extLst>
          </p:cNvPr>
          <p:cNvSpPr/>
          <p:nvPr/>
        </p:nvSpPr>
        <p:spPr>
          <a:xfrm>
            <a:off x="9793156" y="2437405"/>
            <a:ext cx="1581441" cy="217706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E8F30C7-AA83-FD5C-37EF-287978ECD726}"/>
              </a:ext>
            </a:extLst>
          </p:cNvPr>
          <p:cNvSpPr txBox="1"/>
          <p:nvPr/>
        </p:nvSpPr>
        <p:spPr>
          <a:xfrm>
            <a:off x="229870" y="645686"/>
            <a:ext cx="15285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p65-11.</a:t>
            </a:r>
            <a:r>
              <a:rPr lang="en-US" altLang="zh-CN" b="1" dirty="0"/>
              <a:t>12</a:t>
            </a:r>
            <a:endParaRPr lang="en-US" altLang="zh-CN" sz="1800" b="1" dirty="0"/>
          </a:p>
        </p:txBody>
      </p:sp>
    </p:spTree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630" y="2418080"/>
            <a:ext cx="4920615" cy="234124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-387350" y="25088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387350" y="33610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414655" y="43084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1154410" y="288766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1154410" y="384778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686435" y="1911985"/>
            <a:ext cx="4893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2        3      4              1      2       3      4               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933700" y="1911985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B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51980" y="635"/>
            <a:ext cx="5239385" cy="1091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si-ALKBH5-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ALKBH5-2       </a:t>
            </a:r>
            <a:r>
              <a:rPr lang="en-US" altLang="zh-CN" b="1"/>
              <a:t>4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ALKBH5-3</a:t>
            </a:r>
            <a:endParaRPr lang="zh-CN" altLang="en-US" b="1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5"/>
          <a:srcRect b="7138"/>
          <a:stretch>
            <a:fillRect/>
          </a:stretch>
        </p:blipFill>
        <p:spPr>
          <a:xfrm>
            <a:off x="6374765" y="2323465"/>
            <a:ext cx="4734560" cy="245364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6374766" y="3721100"/>
            <a:ext cx="2205054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595629" y="2847340"/>
            <a:ext cx="2157732" cy="44795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3203275" y="2848299"/>
            <a:ext cx="2312970" cy="410384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8796354" y="3721100"/>
            <a:ext cx="2312971" cy="498474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31ADBFB-7772-0A66-5994-76F3C4D8852D}"/>
              </a:ext>
            </a:extLst>
          </p:cNvPr>
          <p:cNvSpPr txBox="1"/>
          <p:nvPr/>
        </p:nvSpPr>
        <p:spPr>
          <a:xfrm>
            <a:off x="7477293" y="603424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3679C24D-1C7E-724B-6BB7-16EEBBFFFC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33115" y="5717500"/>
            <a:ext cx="4077053" cy="914479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1B0DD92E-A7D1-0440-DCF4-981A03914EB1}"/>
              </a:ext>
            </a:extLst>
          </p:cNvPr>
          <p:cNvSpPr/>
          <p:nvPr/>
        </p:nvSpPr>
        <p:spPr>
          <a:xfrm>
            <a:off x="3358513" y="6034243"/>
            <a:ext cx="1796193" cy="34653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5D3527D7-42FB-9BD3-1C3D-E2A37333F2D1}"/>
              </a:ext>
            </a:extLst>
          </p:cNvPr>
          <p:cNvSpPr/>
          <p:nvPr/>
        </p:nvSpPr>
        <p:spPr>
          <a:xfrm>
            <a:off x="5516245" y="6034243"/>
            <a:ext cx="1893923" cy="34653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6994060-7157-7BCB-0374-63ABA0975CCF}"/>
              </a:ext>
            </a:extLst>
          </p:cNvPr>
          <p:cNvSpPr txBox="1"/>
          <p:nvPr/>
        </p:nvSpPr>
        <p:spPr>
          <a:xfrm>
            <a:off x="229870" y="645686"/>
            <a:ext cx="16794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1.2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77B207C-488E-71B5-4A38-28D928255912}"/>
              </a:ext>
            </a:extLst>
          </p:cNvPr>
          <p:cNvSpPr txBox="1"/>
          <p:nvPr/>
        </p:nvSpPr>
        <p:spPr>
          <a:xfrm>
            <a:off x="5597701" y="5282144"/>
            <a:ext cx="173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</p:spTree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2960" y="2416810"/>
            <a:ext cx="4906010" cy="207581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-250825" y="23660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250825" y="32181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278130" y="41656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1308080" y="27879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1308080" y="37023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822960" y="1769110"/>
            <a:ext cx="4893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2        3      4              1      2       3      4               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3070225" y="1769110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B-3</a:t>
            </a:r>
            <a:r>
              <a:rPr lang="zh-CN" altLang="en-US" dirty="0"/>
              <a:t>、</a:t>
            </a:r>
            <a:r>
              <a:rPr lang="en-US" altLang="zh-CN" dirty="0"/>
              <a:t>4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51980" y="635"/>
            <a:ext cx="5239385" cy="1091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si-ALKBH5-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ALKBH5-2       </a:t>
            </a:r>
            <a:r>
              <a:rPr lang="en-US" altLang="zh-CN" b="1"/>
              <a:t>4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ALKBH5-3</a:t>
            </a:r>
            <a:endParaRPr lang="zh-CN" altLang="en-US" b="1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18835" y="2416810"/>
            <a:ext cx="4895215" cy="207518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822959" y="3578225"/>
            <a:ext cx="9991091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822959" y="2704465"/>
            <a:ext cx="9916759" cy="4121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EEB1CAD-B724-125C-8333-E992070D958A}"/>
              </a:ext>
            </a:extLst>
          </p:cNvPr>
          <p:cNvSpPr txBox="1"/>
          <p:nvPr/>
        </p:nvSpPr>
        <p:spPr>
          <a:xfrm>
            <a:off x="10021606" y="563038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ALKBH5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352204C1-4A81-C2D1-8C39-DA851969B4C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69635" y="5389843"/>
            <a:ext cx="4023709" cy="853514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7A79CC1C-4CF4-8E54-6BCD-BF5927CABEBF}"/>
              </a:ext>
            </a:extLst>
          </p:cNvPr>
          <p:cNvSpPr/>
          <p:nvPr/>
        </p:nvSpPr>
        <p:spPr>
          <a:xfrm>
            <a:off x="5969635" y="5540375"/>
            <a:ext cx="4023709" cy="4121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D288CFB-F3A7-914E-6E10-4DB15D91FB73}"/>
              </a:ext>
            </a:extLst>
          </p:cNvPr>
          <p:cNvSpPr txBox="1"/>
          <p:nvPr/>
        </p:nvSpPr>
        <p:spPr>
          <a:xfrm>
            <a:off x="229870" y="645686"/>
            <a:ext cx="15356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ALKBH5-3.4</a:t>
            </a:r>
          </a:p>
        </p:txBody>
      </p:sp>
    </p:spTree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55005" y="1687195"/>
            <a:ext cx="4618355" cy="365379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-212090" y="25006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-201930" y="32931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186690" y="41789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203200" y="51523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0325436" y="24073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F2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0438766" y="47506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399540" y="1346835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oe-YTHDF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-200660" y="18808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911860" y="1346835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D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  <a:r>
              <a:rPr lang="zh-CN" altLang="en-US" dirty="0"/>
              <a:t>、</a:t>
            </a:r>
            <a:r>
              <a:rPr lang="en-US" altLang="zh-CN" dirty="0"/>
              <a:t>3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5"/>
          <a:srcRect b="3879"/>
          <a:stretch>
            <a:fillRect/>
          </a:stretch>
        </p:blipFill>
        <p:spPr>
          <a:xfrm>
            <a:off x="697230" y="1642745"/>
            <a:ext cx="4756785" cy="369824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1311274" y="4725035"/>
            <a:ext cx="9062086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311275" y="2305687"/>
            <a:ext cx="9014162" cy="49847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E722CD2-377A-EFEF-27E2-489E51EF886D}"/>
              </a:ext>
            </a:extLst>
          </p:cNvPr>
          <p:cNvSpPr txBox="1"/>
          <p:nvPr/>
        </p:nvSpPr>
        <p:spPr>
          <a:xfrm>
            <a:off x="9778830" y="607221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F2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64312DD-7E81-E3C7-40CC-CAD9997186BE}"/>
              </a:ext>
            </a:extLst>
          </p:cNvPr>
          <p:cNvSpPr txBox="1"/>
          <p:nvPr/>
        </p:nvSpPr>
        <p:spPr>
          <a:xfrm>
            <a:off x="229870" y="645686"/>
            <a:ext cx="17312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F2-1.2.3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714E7BF2-A883-A2D9-8E48-996393F17B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49533" y="5565739"/>
            <a:ext cx="3429297" cy="876376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CC171F5F-90D8-2938-EEFB-177A9BF2538C}"/>
              </a:ext>
            </a:extLst>
          </p:cNvPr>
          <p:cNvSpPr/>
          <p:nvPr/>
        </p:nvSpPr>
        <p:spPr>
          <a:xfrm>
            <a:off x="6349533" y="6088118"/>
            <a:ext cx="3429298" cy="21330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rcRect b="9581"/>
          <a:stretch>
            <a:fillRect/>
          </a:stretch>
        </p:blipFill>
        <p:spPr>
          <a:xfrm>
            <a:off x="5728569" y="1746062"/>
            <a:ext cx="4848225" cy="3523615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6337011" y="2355027"/>
            <a:ext cx="4149840" cy="38290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-201696" y="249282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-191536" y="322307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-176296" y="392220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-192806" y="48067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10677899" y="24045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F2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0732413" y="45616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409934" y="1276797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oe-YTHDF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-190266" y="193529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922254" y="1276797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D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rcRect t="2569" b="7757"/>
          <a:stretch>
            <a:fillRect/>
          </a:stretch>
        </p:blipFill>
        <p:spPr>
          <a:xfrm>
            <a:off x="682224" y="1746062"/>
            <a:ext cx="4917440" cy="352361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592690" y="4432748"/>
            <a:ext cx="5006974" cy="48133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B98228B-B571-827A-93B1-63837A609DCE}"/>
              </a:ext>
            </a:extLst>
          </p:cNvPr>
          <p:cNvSpPr txBox="1"/>
          <p:nvPr/>
        </p:nvSpPr>
        <p:spPr>
          <a:xfrm>
            <a:off x="9754201" y="608890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F2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4F26F20-33A7-7962-9C5D-A64B3B9FBD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02973" y="5608990"/>
            <a:ext cx="3551228" cy="1165961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9D7D4946-4427-E682-0BC4-05AEEA804502}"/>
              </a:ext>
            </a:extLst>
          </p:cNvPr>
          <p:cNvSpPr/>
          <p:nvPr/>
        </p:nvSpPr>
        <p:spPr>
          <a:xfrm>
            <a:off x="6271780" y="6119514"/>
            <a:ext cx="3482421" cy="2451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5664806-DF5E-9910-C579-70A0AEC36629}"/>
              </a:ext>
            </a:extLst>
          </p:cNvPr>
          <p:cNvSpPr txBox="1"/>
          <p:nvPr/>
        </p:nvSpPr>
        <p:spPr>
          <a:xfrm>
            <a:off x="240264" y="680822"/>
            <a:ext cx="16558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F2-4.5.6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669DC88-8B3C-0A74-D197-63CBCDC00B09}"/>
              </a:ext>
            </a:extLst>
          </p:cNvPr>
          <p:cNvSpPr txBox="1"/>
          <p:nvPr/>
        </p:nvSpPr>
        <p:spPr>
          <a:xfrm>
            <a:off x="7113082" y="5240690"/>
            <a:ext cx="173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</p:spTree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rcRect r="57372"/>
          <a:stretch>
            <a:fillRect/>
          </a:stretch>
        </p:blipFill>
        <p:spPr>
          <a:xfrm>
            <a:off x="1791821" y="1529117"/>
            <a:ext cx="2163445" cy="409892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rcRect l="71300"/>
          <a:stretch>
            <a:fillRect/>
          </a:stretch>
        </p:blipFill>
        <p:spPr>
          <a:xfrm>
            <a:off x="4080361" y="1530387"/>
            <a:ext cx="1456055" cy="409765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838686" y="227651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48846" y="30956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64086" y="405260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47576" y="526609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586581" y="228495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YTHDF2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536416" y="468164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866751" y="1122717"/>
            <a:ext cx="3669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  </a:t>
            </a:r>
            <a:r>
              <a:rPr lang="en-US" altLang="zh-CN" b="1"/>
              <a:t>M  </a:t>
            </a:r>
            <a:r>
              <a:rPr lang="en-US" altLang="zh-CN"/>
              <a:t>       1        2 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YTHDF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50116" y="16567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F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</a:p>
        </p:txBody>
      </p:sp>
      <p:sp>
        <p:nvSpPr>
          <p:cNvPr id="48" name="矩形 47"/>
          <p:cNvSpPr/>
          <p:nvPr/>
        </p:nvSpPr>
        <p:spPr>
          <a:xfrm>
            <a:off x="1791821" y="4673637"/>
            <a:ext cx="374459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791821" y="2200947"/>
            <a:ext cx="3669665" cy="4387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90871E5-02B2-C36F-D76E-292578DB898B}"/>
              </a:ext>
            </a:extLst>
          </p:cNvPr>
          <p:cNvSpPr txBox="1"/>
          <p:nvPr/>
        </p:nvSpPr>
        <p:spPr>
          <a:xfrm>
            <a:off x="9077475" y="259094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YTHDF2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3CD98A82-083E-B9CD-EE51-3668F3703D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0336" y="1998093"/>
            <a:ext cx="1204064" cy="118120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E7EF070-689D-0641-1D01-8744BD95402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69439" y="2018002"/>
            <a:ext cx="1308036" cy="1171247"/>
          </a:xfrm>
          <a:prstGeom prst="rect">
            <a:avLst/>
          </a:prstGeom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CADD02BA-B6B9-D6A6-F533-5120B834D30E}"/>
              </a:ext>
            </a:extLst>
          </p:cNvPr>
          <p:cNvSpPr/>
          <p:nvPr/>
        </p:nvSpPr>
        <p:spPr>
          <a:xfrm>
            <a:off x="6420336" y="2521622"/>
            <a:ext cx="2657139" cy="4387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7573600-CC8A-3E49-D4C5-96FA4F516F0C}"/>
              </a:ext>
            </a:extLst>
          </p:cNvPr>
          <p:cNvSpPr txBox="1"/>
          <p:nvPr/>
        </p:nvSpPr>
        <p:spPr>
          <a:xfrm>
            <a:off x="251754" y="922119"/>
            <a:ext cx="15648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F2-1.2</a:t>
            </a:r>
          </a:p>
        </p:txBody>
      </p:sp>
    </p:spTree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79631" y="1772770"/>
            <a:ext cx="3414395" cy="402018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1573791" y="24827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583951" y="33018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599191" y="42587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582681" y="54722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994026" y="247412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F2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004391" y="48337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3185421" y="1328905"/>
            <a:ext cx="28086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 1        2 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YTHDF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585221" y="18629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F-3</a:t>
            </a:r>
            <a:r>
              <a:rPr lang="zh-CN" altLang="en-US" dirty="0"/>
              <a:t>、</a:t>
            </a:r>
            <a:r>
              <a:rPr lang="en-US" altLang="zh-CN" dirty="0"/>
              <a:t>4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697741" y="1328905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47" name="矩形 46"/>
          <p:cNvSpPr/>
          <p:nvPr/>
        </p:nvSpPr>
        <p:spPr>
          <a:xfrm>
            <a:off x="3185421" y="2407135"/>
            <a:ext cx="2686461" cy="3790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3185421" y="4707105"/>
            <a:ext cx="277254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0BF116A-2AFC-B0BF-6842-B571350A3472}"/>
              </a:ext>
            </a:extLst>
          </p:cNvPr>
          <p:cNvSpPr txBox="1"/>
          <p:nvPr/>
        </p:nvSpPr>
        <p:spPr>
          <a:xfrm>
            <a:off x="9062744" y="25411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F2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E5E60DA1-06B5-3931-BB73-B7DBDDEEDD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68925" y="2046519"/>
            <a:ext cx="2293819" cy="990686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C02054B9-F398-272D-49AA-82FF2003890C}"/>
              </a:ext>
            </a:extLst>
          </p:cNvPr>
          <p:cNvSpPr/>
          <p:nvPr/>
        </p:nvSpPr>
        <p:spPr>
          <a:xfrm>
            <a:off x="6768925" y="2529689"/>
            <a:ext cx="2293819" cy="3790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3419475-4495-6B48-7630-F6CC071C8975}"/>
              </a:ext>
            </a:extLst>
          </p:cNvPr>
          <p:cNvSpPr txBox="1"/>
          <p:nvPr/>
        </p:nvSpPr>
        <p:spPr>
          <a:xfrm>
            <a:off x="251754" y="922119"/>
            <a:ext cx="15383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F2-3.4</a:t>
            </a:r>
          </a:p>
        </p:txBody>
      </p:sp>
    </p:spTree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rcRect t="9193" b="6758"/>
          <a:stretch>
            <a:fillRect/>
          </a:stretch>
        </p:blipFill>
        <p:spPr>
          <a:xfrm>
            <a:off x="2523530" y="1680845"/>
            <a:ext cx="2461260" cy="390144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1211618" y="233045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221778" y="31140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237018" y="40887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220508" y="51422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011986" y="246573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YTHDF2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031515" y="47329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663228" y="1194435"/>
            <a:ext cx="28086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 2        1        2 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si-YTHDF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223048" y="17284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F-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175548" y="1194435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5"/>
          <a:srcRect r="91231"/>
          <a:stretch>
            <a:fillRect/>
          </a:stretch>
        </p:blipFill>
        <p:spPr>
          <a:xfrm>
            <a:off x="2153958" y="1684020"/>
            <a:ext cx="360680" cy="389826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6992341" y="1763015"/>
            <a:ext cx="1524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47" name="矩形 46"/>
          <p:cNvSpPr/>
          <p:nvPr/>
        </p:nvSpPr>
        <p:spPr>
          <a:xfrm>
            <a:off x="2584801" y="2369541"/>
            <a:ext cx="1097109" cy="434897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558291" y="4697095"/>
            <a:ext cx="1168772" cy="3663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3777329" y="2369541"/>
            <a:ext cx="1117401" cy="434897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3750819" y="4697095"/>
            <a:ext cx="1233971" cy="36639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F45E270-05DC-B439-4297-5545CCA7D289}"/>
              </a:ext>
            </a:extLst>
          </p:cNvPr>
          <p:cNvSpPr txBox="1"/>
          <p:nvPr/>
        </p:nvSpPr>
        <p:spPr>
          <a:xfrm>
            <a:off x="8265131" y="256218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YTHDF2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9E1FD6C-FFB3-3F8B-6D36-BCB621E55C30}"/>
              </a:ext>
            </a:extLst>
          </p:cNvPr>
          <p:cNvSpPr txBox="1"/>
          <p:nvPr/>
        </p:nvSpPr>
        <p:spPr>
          <a:xfrm>
            <a:off x="251754" y="922119"/>
            <a:ext cx="15383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F2-5.6</a:t>
            </a: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75EA06C3-6E63-54F2-A656-7715A162BC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45656" y="2148905"/>
            <a:ext cx="2019475" cy="967824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13B374B4-D133-9D76-37F0-8C6B0A6D5ACA}"/>
              </a:ext>
            </a:extLst>
          </p:cNvPr>
          <p:cNvSpPr/>
          <p:nvPr/>
        </p:nvSpPr>
        <p:spPr>
          <a:xfrm>
            <a:off x="6294401" y="2526085"/>
            <a:ext cx="912812" cy="36951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DDA4FA1-A4B3-9BEE-FD60-59C7E589BC97}"/>
              </a:ext>
            </a:extLst>
          </p:cNvPr>
          <p:cNvSpPr/>
          <p:nvPr/>
        </p:nvSpPr>
        <p:spPr>
          <a:xfrm>
            <a:off x="7298290" y="2558775"/>
            <a:ext cx="912813" cy="369516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26515" y="1786852"/>
            <a:ext cx="4382770" cy="42621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847650" y="272347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57810" y="342705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64160" y="437511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56540" y="56152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311264" y="233638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C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309285" y="509234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459280" y="1418552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oe-YTHDC1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59080" y="215705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971600" y="1418552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H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  <a:r>
              <a:rPr lang="zh-CN" altLang="en-US" dirty="0"/>
              <a:t>、</a:t>
            </a:r>
            <a:r>
              <a:rPr lang="en-US" altLang="zh-CN" dirty="0"/>
              <a:t>3</a:t>
            </a:r>
          </a:p>
        </p:txBody>
      </p:sp>
      <p:sp>
        <p:nvSpPr>
          <p:cNvPr id="48" name="矩形 47"/>
          <p:cNvSpPr/>
          <p:nvPr/>
        </p:nvSpPr>
        <p:spPr>
          <a:xfrm>
            <a:off x="2368476" y="4965662"/>
            <a:ext cx="3940810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59280" y="2336762"/>
            <a:ext cx="3591896" cy="3790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87292F8-3354-EE9E-1E4B-8A4EEF65C62E}"/>
              </a:ext>
            </a:extLst>
          </p:cNvPr>
          <p:cNvSpPr txBox="1"/>
          <p:nvPr/>
        </p:nvSpPr>
        <p:spPr>
          <a:xfrm>
            <a:off x="10449000" y="233638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YTHDC1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6038CA3-91D0-850F-F21F-3D10318D5A36}"/>
              </a:ext>
            </a:extLst>
          </p:cNvPr>
          <p:cNvSpPr txBox="1"/>
          <p:nvPr/>
        </p:nvSpPr>
        <p:spPr>
          <a:xfrm>
            <a:off x="251754" y="922119"/>
            <a:ext cx="18575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C1-1.2.3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9AABB0DC-1C09-35CA-96E8-34F35AE345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20011" y="1985242"/>
            <a:ext cx="3101609" cy="1082134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78247B63-43C9-643B-81B7-B8741C4FC4CC}"/>
              </a:ext>
            </a:extLst>
          </p:cNvPr>
          <p:cNvSpPr/>
          <p:nvPr/>
        </p:nvSpPr>
        <p:spPr>
          <a:xfrm>
            <a:off x="7320011" y="2344382"/>
            <a:ext cx="3101609" cy="3790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1596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B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897439" y="22009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1884104" y="25692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874579" y="29673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875849" y="363156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873309" y="436308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8997950" y="254222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Lamin B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780724" y="1544955"/>
            <a:ext cx="2456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2     </a:t>
            </a:r>
            <a:r>
              <a:rPr lang="en-US" altLang="zh-CN" b="1"/>
              <a:t>M </a:t>
            </a:r>
            <a:r>
              <a:rPr lang="en-US" altLang="zh-CN"/>
              <a:t>    1     2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5113079" y="242506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 err="1"/>
              <a:t>Foxo</a:t>
            </a:r>
            <a:r>
              <a:rPr lang="en-US" altLang="zh-CN" sz="1200" b="1" dirty="0"/>
              <a:t> 1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5009" y="2065020"/>
            <a:ext cx="1398905" cy="295465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2014" y="2065020"/>
            <a:ext cx="799465" cy="295402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2795905" y="2368866"/>
            <a:ext cx="883920" cy="3467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rcRect r="66578"/>
          <a:stretch>
            <a:fillRect/>
          </a:stretch>
        </p:blipFill>
        <p:spPr>
          <a:xfrm>
            <a:off x="6298624" y="2065020"/>
            <a:ext cx="1529080" cy="283146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rcRect l="76956"/>
          <a:stretch>
            <a:fillRect/>
          </a:stretch>
        </p:blipFill>
        <p:spPr>
          <a:xfrm>
            <a:off x="7929304" y="2065020"/>
            <a:ext cx="1054100" cy="2831465"/>
          </a:xfrm>
          <a:prstGeom prst="rect">
            <a:avLst/>
          </a:prstGeom>
        </p:spPr>
      </p:pic>
      <p:sp>
        <p:nvSpPr>
          <p:cNvPr id="15" name="矩形 14"/>
          <p:cNvSpPr/>
          <p:nvPr/>
        </p:nvSpPr>
        <p:spPr>
          <a:xfrm>
            <a:off x="6298624" y="2493008"/>
            <a:ext cx="1087521" cy="3435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7929304" y="2431415"/>
            <a:ext cx="967046" cy="43751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4226936" y="2368866"/>
            <a:ext cx="769620" cy="3467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5363268" y="6198493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82C21BE0-23DB-73D0-542D-4E0B503EA1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95291" y="5126154"/>
            <a:ext cx="1158340" cy="662997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E069F922-353C-74AB-ABFA-238B2A8FFA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02336" y="5151704"/>
            <a:ext cx="624894" cy="586791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DAB4CC06-5E86-6D43-81CC-62F2F6DF666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81652" y="5113601"/>
            <a:ext cx="891617" cy="624894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5B2CC937-64E3-2868-7A33-5D8ABC10114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929304" y="5104103"/>
            <a:ext cx="823031" cy="624894"/>
          </a:xfrm>
          <a:prstGeom prst="rect">
            <a:avLst/>
          </a:prstGeom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2A2F1543-09B6-C43F-73B9-A6DA8AB63880}"/>
              </a:ext>
            </a:extLst>
          </p:cNvPr>
          <p:cNvSpPr/>
          <p:nvPr/>
        </p:nvSpPr>
        <p:spPr>
          <a:xfrm>
            <a:off x="2879300" y="5284297"/>
            <a:ext cx="883920" cy="3467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635B8957-DEDF-DF69-01A4-A07E64C57DC0}"/>
              </a:ext>
            </a:extLst>
          </p:cNvPr>
          <p:cNvSpPr/>
          <p:nvPr/>
        </p:nvSpPr>
        <p:spPr>
          <a:xfrm>
            <a:off x="6389349" y="5354827"/>
            <a:ext cx="883920" cy="3467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5D68F1D9-4C7D-FD3C-4CBB-D56A090A347A}"/>
              </a:ext>
            </a:extLst>
          </p:cNvPr>
          <p:cNvSpPr/>
          <p:nvPr/>
        </p:nvSpPr>
        <p:spPr>
          <a:xfrm>
            <a:off x="4302336" y="5295671"/>
            <a:ext cx="624894" cy="3467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BEBACE4E-848B-9CED-B78F-971CBEB6EC60}"/>
              </a:ext>
            </a:extLst>
          </p:cNvPr>
          <p:cNvSpPr/>
          <p:nvPr/>
        </p:nvSpPr>
        <p:spPr>
          <a:xfrm>
            <a:off x="7929304" y="5346020"/>
            <a:ext cx="823030" cy="3467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4C7202C-871C-E5E1-239F-220FF5BA4255}"/>
              </a:ext>
            </a:extLst>
          </p:cNvPr>
          <p:cNvSpPr txBox="1"/>
          <p:nvPr/>
        </p:nvSpPr>
        <p:spPr>
          <a:xfrm>
            <a:off x="4996556" y="532254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 err="1"/>
              <a:t>Foxo</a:t>
            </a:r>
            <a:r>
              <a:rPr lang="en-US" altLang="zh-CN" sz="1200" b="1" dirty="0"/>
              <a:t> 1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2E1C57F-ADF2-A8DB-EBAF-65308EE40176}"/>
              </a:ext>
            </a:extLst>
          </p:cNvPr>
          <p:cNvSpPr txBox="1"/>
          <p:nvPr/>
        </p:nvSpPr>
        <p:spPr>
          <a:xfrm>
            <a:off x="8752334" y="53858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Lamin B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B89F79E-6282-2F23-0534-D0D173908861}"/>
              </a:ext>
            </a:extLst>
          </p:cNvPr>
          <p:cNvSpPr txBox="1"/>
          <p:nvPr/>
        </p:nvSpPr>
        <p:spPr>
          <a:xfrm>
            <a:off x="9881870" y="1729105"/>
            <a:ext cx="1529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Lamin B-4.5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80A1B15-EBB2-373E-4557-506753278D45}"/>
              </a:ext>
            </a:extLst>
          </p:cNvPr>
          <p:cNvSpPr txBox="1"/>
          <p:nvPr/>
        </p:nvSpPr>
        <p:spPr>
          <a:xfrm>
            <a:off x="1166842" y="1661644"/>
            <a:ext cx="127903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4.5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28B8109-41AD-650B-C537-DB7E5A5E10B5}"/>
              </a:ext>
            </a:extLst>
          </p:cNvPr>
          <p:cNvSpPr txBox="1"/>
          <p:nvPr/>
        </p:nvSpPr>
        <p:spPr>
          <a:xfrm>
            <a:off x="9881870" y="292100"/>
            <a:ext cx="2028190" cy="881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si-circDhx32</a:t>
            </a:r>
          </a:p>
        </p:txBody>
      </p:sp>
    </p:spTree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9405" y="2242281"/>
            <a:ext cx="2879165" cy="2389668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687046" y="265415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681966" y="30715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87046" y="364157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687046" y="422380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4441235" y="24061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YTHDC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8071421" y="390173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oe-YTHDC1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43283" y="23228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grpSp>
        <p:nvGrpSpPr>
          <p:cNvPr id="17" name="组合 16"/>
          <p:cNvGrpSpPr/>
          <p:nvPr/>
        </p:nvGrpSpPr>
        <p:grpSpPr>
          <a:xfrm>
            <a:off x="1547357" y="1873981"/>
            <a:ext cx="2926680" cy="372609"/>
            <a:chOff x="4841275" y="2291993"/>
            <a:chExt cx="2926680" cy="372609"/>
          </a:xfrm>
        </p:grpSpPr>
        <p:sp>
          <p:nvSpPr>
            <p:cNvPr id="12" name="文本框 11"/>
            <p:cNvSpPr txBox="1"/>
            <p:nvPr/>
          </p:nvSpPr>
          <p:spPr>
            <a:xfrm>
              <a:off x="5040982" y="2291993"/>
              <a:ext cx="2726973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    1    1    1    2    2    2               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841275" y="2296302"/>
              <a:ext cx="39941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M</a:t>
              </a: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-H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8632" y="2226051"/>
            <a:ext cx="2694303" cy="2405898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5558118" y="3885383"/>
            <a:ext cx="2406865" cy="363972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873330" y="2406119"/>
            <a:ext cx="2304223" cy="344743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8" name="组合 17"/>
          <p:cNvGrpSpPr/>
          <p:nvPr/>
        </p:nvGrpSpPr>
        <p:grpSpPr>
          <a:xfrm>
            <a:off x="5227973" y="1880501"/>
            <a:ext cx="2926680" cy="372609"/>
            <a:chOff x="4841275" y="2291993"/>
            <a:chExt cx="2926680" cy="372609"/>
          </a:xfrm>
        </p:grpSpPr>
        <p:sp>
          <p:nvSpPr>
            <p:cNvPr id="19" name="文本框 18"/>
            <p:cNvSpPr txBox="1"/>
            <p:nvPr/>
          </p:nvSpPr>
          <p:spPr>
            <a:xfrm>
              <a:off x="5040982" y="2291993"/>
              <a:ext cx="2726973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    1   1     1    2    2    2               </a:t>
              </a: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4841275" y="2296302"/>
              <a:ext cx="39941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M</a:t>
              </a:r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8AA49C3B-C79B-8024-0295-F7CE7F285664}"/>
              </a:ext>
            </a:extLst>
          </p:cNvPr>
          <p:cNvSpPr txBox="1"/>
          <p:nvPr/>
        </p:nvSpPr>
        <p:spPr>
          <a:xfrm>
            <a:off x="8802997" y="1857751"/>
            <a:ext cx="1224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4469733-7913-E4A0-62F0-E435E44D2A03}"/>
              </a:ext>
            </a:extLst>
          </p:cNvPr>
          <p:cNvSpPr txBox="1"/>
          <p:nvPr/>
        </p:nvSpPr>
        <p:spPr>
          <a:xfrm>
            <a:off x="10564797" y="24061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YTHDC1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45D40B3F-2264-F995-8891-F876ECD31AE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85559" y="2285645"/>
            <a:ext cx="1912786" cy="670618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83A0FAAA-742A-7079-A97E-A918F6CD505E}"/>
              </a:ext>
            </a:extLst>
          </p:cNvPr>
          <p:cNvSpPr/>
          <p:nvPr/>
        </p:nvSpPr>
        <p:spPr>
          <a:xfrm>
            <a:off x="8598224" y="2322890"/>
            <a:ext cx="1900122" cy="252701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DE18A24-8519-6231-BE81-3473BB8E3D9C}"/>
              </a:ext>
            </a:extLst>
          </p:cNvPr>
          <p:cNvSpPr txBox="1"/>
          <p:nvPr/>
        </p:nvSpPr>
        <p:spPr>
          <a:xfrm>
            <a:off x="251754" y="922119"/>
            <a:ext cx="17846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YTHDC1-4.5.6</a:t>
            </a:r>
          </a:p>
        </p:txBody>
      </p:sp>
    </p:spTree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3144" y="1997709"/>
            <a:ext cx="4572635" cy="391795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682224" y="26746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01274" y="34493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98734" y="432625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91114" y="54686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336263" y="241236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65779" y="512000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293854" y="1369694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Sham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IR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29214" y="210819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806174" y="1369694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-B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  <a:r>
              <a:rPr lang="zh-CN" altLang="en-US" dirty="0"/>
              <a:t>、</a:t>
            </a:r>
            <a:r>
              <a:rPr lang="en-US" altLang="zh-CN" dirty="0"/>
              <a:t>3</a:t>
            </a:r>
          </a:p>
        </p:txBody>
      </p:sp>
      <p:sp>
        <p:nvSpPr>
          <p:cNvPr id="48" name="矩形 47"/>
          <p:cNvSpPr/>
          <p:nvPr/>
        </p:nvSpPr>
        <p:spPr>
          <a:xfrm>
            <a:off x="2205588" y="5014594"/>
            <a:ext cx="4015543" cy="51943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205588" y="2376168"/>
            <a:ext cx="4015543" cy="34353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783AA69-FA2F-FB7E-D2FC-799A5B360AA7}"/>
              </a:ext>
            </a:extLst>
          </p:cNvPr>
          <p:cNvSpPr txBox="1"/>
          <p:nvPr/>
        </p:nvSpPr>
        <p:spPr>
          <a:xfrm>
            <a:off x="10297937" y="23851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AEF1E99-88C3-A108-4EA2-3ADFEAB67C4C}"/>
              </a:ext>
            </a:extLst>
          </p:cNvPr>
          <p:cNvSpPr txBox="1"/>
          <p:nvPr/>
        </p:nvSpPr>
        <p:spPr>
          <a:xfrm>
            <a:off x="7894494" y="1751265"/>
            <a:ext cx="15365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663AFA4-0FBA-EEF5-9EA6-61462561E7D9}"/>
              </a:ext>
            </a:extLst>
          </p:cNvPr>
          <p:cNvSpPr txBox="1"/>
          <p:nvPr/>
        </p:nvSpPr>
        <p:spPr>
          <a:xfrm>
            <a:off x="251754" y="922119"/>
            <a:ext cx="1599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1.2.3</a:t>
            </a: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9B0A82A8-5BBA-621D-6F79-422E91B464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05812" y="2230754"/>
            <a:ext cx="3292125" cy="739204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EB5A650A-91B3-BBBF-2A11-2A9B2496BEA7}"/>
              </a:ext>
            </a:extLst>
          </p:cNvPr>
          <p:cNvSpPr/>
          <p:nvPr/>
        </p:nvSpPr>
        <p:spPr>
          <a:xfrm>
            <a:off x="7016701" y="2385170"/>
            <a:ext cx="3292126" cy="289449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b="7108"/>
          <a:stretch>
            <a:fillRect/>
          </a:stretch>
        </p:blipFill>
        <p:spPr>
          <a:xfrm>
            <a:off x="2056316" y="1722807"/>
            <a:ext cx="4646295" cy="407479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943162" y="251060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962212" y="332975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959672" y="42955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952052" y="536683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819452" y="22124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819452" y="523761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554792" y="1267913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10800435" y="0"/>
            <a:ext cx="1451404" cy="881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Sham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IR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990152" y="194418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067112" y="1267913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-B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sp>
        <p:nvSpPr>
          <p:cNvPr id="47" name="矩形 46"/>
          <p:cNvSpPr/>
          <p:nvPr/>
        </p:nvSpPr>
        <p:spPr>
          <a:xfrm>
            <a:off x="2653553" y="2212434"/>
            <a:ext cx="3956350" cy="29817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542092" y="5108394"/>
            <a:ext cx="4160519" cy="503554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5790A7B-FB08-F234-FB20-DA6DA75999D3}"/>
              </a:ext>
            </a:extLst>
          </p:cNvPr>
          <p:cNvSpPr txBox="1"/>
          <p:nvPr/>
        </p:nvSpPr>
        <p:spPr>
          <a:xfrm>
            <a:off x="11217681" y="238805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881D754-82C5-3444-A5D6-466D7AE128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95073" y="2066743"/>
            <a:ext cx="3322608" cy="1005927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6206EBE1-60C7-06EA-28AB-8FF2CE01A909}"/>
              </a:ext>
            </a:extLst>
          </p:cNvPr>
          <p:cNvSpPr/>
          <p:nvPr/>
        </p:nvSpPr>
        <p:spPr>
          <a:xfrm>
            <a:off x="7897906" y="2361520"/>
            <a:ext cx="3254188" cy="298173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612822B-B555-5607-74DC-34C98EBD60D2}"/>
              </a:ext>
            </a:extLst>
          </p:cNvPr>
          <p:cNvSpPr txBox="1"/>
          <p:nvPr/>
        </p:nvSpPr>
        <p:spPr>
          <a:xfrm>
            <a:off x="251754" y="922119"/>
            <a:ext cx="1575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4.5.6</a:t>
            </a:r>
          </a:p>
        </p:txBody>
      </p:sp>
    </p:spTree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6804" y="1810945"/>
            <a:ext cx="4458335" cy="420497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682224" y="24903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701274" y="32650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98734" y="423982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91114" y="55688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50472" y="21919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341436" y="510083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293854" y="1185470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Ctrl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29214" y="187063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806174" y="1185470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-C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  <a:r>
              <a:rPr lang="zh-CN" altLang="en-US" dirty="0"/>
              <a:t>、</a:t>
            </a:r>
            <a:r>
              <a:rPr lang="en-US" altLang="zh-CN" dirty="0"/>
              <a:t>3</a:t>
            </a:r>
          </a:p>
        </p:txBody>
      </p:sp>
      <p:sp>
        <p:nvSpPr>
          <p:cNvPr id="48" name="矩形 47"/>
          <p:cNvSpPr/>
          <p:nvPr/>
        </p:nvSpPr>
        <p:spPr>
          <a:xfrm>
            <a:off x="2205590" y="4981501"/>
            <a:ext cx="4019550" cy="48378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293855" y="2191945"/>
            <a:ext cx="3789120" cy="29845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7792297" y="1931595"/>
            <a:ext cx="23856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17EA321-C4C9-F7D9-A2F5-FE58484B5927}"/>
              </a:ext>
            </a:extLst>
          </p:cNvPr>
          <p:cNvSpPr txBox="1"/>
          <p:nvPr/>
        </p:nvSpPr>
        <p:spPr>
          <a:xfrm>
            <a:off x="10682491" y="266086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A3D7FA59-4CD5-C1EE-B353-451D00D03D8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67504" y="2437055"/>
            <a:ext cx="3314987" cy="929721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5E3AEB04-B229-6DC7-B482-C913D2EDF2A5}"/>
              </a:ext>
            </a:extLst>
          </p:cNvPr>
          <p:cNvSpPr/>
          <p:nvPr/>
        </p:nvSpPr>
        <p:spPr>
          <a:xfrm>
            <a:off x="7367504" y="2660861"/>
            <a:ext cx="3235283" cy="29845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5C120AA-2614-2CD2-954C-C96B04DF4E86}"/>
              </a:ext>
            </a:extLst>
          </p:cNvPr>
          <p:cNvSpPr txBox="1"/>
          <p:nvPr/>
        </p:nvSpPr>
        <p:spPr>
          <a:xfrm>
            <a:off x="251754" y="922119"/>
            <a:ext cx="14661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1.2.3</a:t>
            </a:r>
          </a:p>
        </p:txBody>
      </p:sp>
    </p:spTree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t="10566"/>
          <a:stretch>
            <a:fillRect/>
          </a:stretch>
        </p:blipFill>
        <p:spPr>
          <a:xfrm>
            <a:off x="1879226" y="1311910"/>
            <a:ext cx="4291965" cy="441833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811791" y="21983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830841" y="291084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828301" y="39033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820681" y="52324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171191" y="18853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185161" y="497173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423421" y="848995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Ctrl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858781" y="13119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935741" y="848995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-C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sp>
        <p:nvSpPr>
          <p:cNvPr id="48" name="矩形 47"/>
          <p:cNvSpPr/>
          <p:nvPr/>
        </p:nvSpPr>
        <p:spPr>
          <a:xfrm>
            <a:off x="2335156" y="4845050"/>
            <a:ext cx="3836035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2423421" y="1789430"/>
            <a:ext cx="3747770" cy="47117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F8ADA1F-CC25-6960-B876-3D40448F1284}"/>
              </a:ext>
            </a:extLst>
          </p:cNvPr>
          <p:cNvSpPr txBox="1"/>
          <p:nvPr/>
        </p:nvSpPr>
        <p:spPr>
          <a:xfrm>
            <a:off x="9791300" y="266573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39B5960-721B-2560-F681-8F89201D70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1588" y="2412852"/>
            <a:ext cx="3139712" cy="1295512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630EA41A-2180-3E08-62AA-B4F8537EBE3E}"/>
              </a:ext>
            </a:extLst>
          </p:cNvPr>
          <p:cNvSpPr/>
          <p:nvPr/>
        </p:nvSpPr>
        <p:spPr>
          <a:xfrm>
            <a:off x="6673850" y="2581819"/>
            <a:ext cx="3117450" cy="47117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30D84DE-ADE7-8DAA-215C-FEBC1F8437FE}"/>
              </a:ext>
            </a:extLst>
          </p:cNvPr>
          <p:cNvSpPr txBox="1"/>
          <p:nvPr/>
        </p:nvSpPr>
        <p:spPr>
          <a:xfrm>
            <a:off x="251754" y="922119"/>
            <a:ext cx="149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4.5.6</a:t>
            </a:r>
          </a:p>
        </p:txBody>
      </p:sp>
    </p:spTree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6383" y="1531844"/>
            <a:ext cx="4617720" cy="408749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327698" y="241830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346748" y="303298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44208" y="40432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36588" y="52834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5952156" y="206016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895939" y="498719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39328" y="1068929"/>
            <a:ext cx="40551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 1         1         2        2         2             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651875" y="635"/>
            <a:ext cx="35394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Ctrl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2</a:t>
            </a:r>
            <a:r>
              <a:rPr lang="zh-CN" altLang="en-US" b="1"/>
              <a:t>：</a:t>
            </a:r>
            <a:r>
              <a:rPr lang="en-US" altLang="zh-CN" b="1"/>
              <a:t>HR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374688" y="163852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451648" y="1068929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-C-7</a:t>
            </a:r>
            <a:r>
              <a:rPr lang="zh-CN" altLang="en-US" dirty="0"/>
              <a:t>、</a:t>
            </a:r>
            <a:r>
              <a:rPr lang="en-US" altLang="zh-CN" dirty="0"/>
              <a:t>8</a:t>
            </a:r>
            <a:r>
              <a:rPr lang="zh-CN" altLang="en-US" dirty="0"/>
              <a:t>、</a:t>
            </a:r>
            <a:r>
              <a:rPr lang="en-US" altLang="zh-CN" dirty="0"/>
              <a:t>9</a:t>
            </a:r>
          </a:p>
        </p:txBody>
      </p:sp>
      <p:sp>
        <p:nvSpPr>
          <p:cNvPr id="48" name="矩形 47"/>
          <p:cNvSpPr/>
          <p:nvPr/>
        </p:nvSpPr>
        <p:spPr>
          <a:xfrm>
            <a:off x="1851063" y="4860514"/>
            <a:ext cx="3944056" cy="4984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939328" y="1947134"/>
            <a:ext cx="3914775" cy="47117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45A9082-4271-B87E-DA0D-2A918C74C7C4}"/>
              </a:ext>
            </a:extLst>
          </p:cNvPr>
          <p:cNvSpPr txBox="1"/>
          <p:nvPr/>
        </p:nvSpPr>
        <p:spPr>
          <a:xfrm>
            <a:off x="10119565" y="299538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C666375C-75A6-E9FD-D3EE-7EB404ADCD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36076" y="2599231"/>
            <a:ext cx="3185436" cy="1112616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DA84B364-6831-ABDD-80CB-7FC7C3FDB232}"/>
              </a:ext>
            </a:extLst>
          </p:cNvPr>
          <p:cNvSpPr/>
          <p:nvPr/>
        </p:nvSpPr>
        <p:spPr>
          <a:xfrm>
            <a:off x="6836077" y="2928208"/>
            <a:ext cx="3185436" cy="3762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7D53983-9B6F-A7A7-1588-75D54E8058E3}"/>
              </a:ext>
            </a:extLst>
          </p:cNvPr>
          <p:cNvSpPr txBox="1"/>
          <p:nvPr/>
        </p:nvSpPr>
        <p:spPr>
          <a:xfrm>
            <a:off x="162257" y="571668"/>
            <a:ext cx="15936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7.8.9</a:t>
            </a:r>
          </a:p>
        </p:txBody>
      </p:sp>
    </p:spTree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6144" y="1856553"/>
            <a:ext cx="4794885" cy="355727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682224" y="305098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82224" y="396221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682224" y="498837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361029" y="226041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405479" y="461181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463274" y="1486983"/>
            <a:ext cx="4893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 1       2        3      4              1      2       3      4               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3710539" y="1486983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G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51980" y="635"/>
            <a:ext cx="5239385" cy="1091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si-FOXO1-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2         </a:t>
            </a:r>
            <a:r>
              <a:rPr lang="en-US" altLang="zh-CN" b="1"/>
              <a:t>4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3</a:t>
            </a:r>
            <a:endParaRPr lang="zh-CN" altLang="en-US" b="1"/>
          </a:p>
        </p:txBody>
      </p:sp>
      <p:sp>
        <p:nvSpPr>
          <p:cNvPr id="4" name="文本框 3"/>
          <p:cNvSpPr txBox="1"/>
          <p:nvPr/>
        </p:nvSpPr>
        <p:spPr>
          <a:xfrm>
            <a:off x="682224" y="250552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682224" y="196005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47" name="矩形 46"/>
          <p:cNvSpPr/>
          <p:nvPr/>
        </p:nvSpPr>
        <p:spPr>
          <a:xfrm>
            <a:off x="1589003" y="2173418"/>
            <a:ext cx="4587689" cy="4121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1566144" y="4491803"/>
            <a:ext cx="4791075" cy="4851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A110983-E8A9-4193-1AD1-A0E808688484}"/>
              </a:ext>
            </a:extLst>
          </p:cNvPr>
          <p:cNvSpPr txBox="1"/>
          <p:nvPr/>
        </p:nvSpPr>
        <p:spPr>
          <a:xfrm>
            <a:off x="11056138" y="236317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A06C5352-42AF-8641-4AFF-6F8F55291AB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20280" y="2139691"/>
            <a:ext cx="3939881" cy="815411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70523C2E-6A67-4B76-CB25-661A180D29C3}"/>
              </a:ext>
            </a:extLst>
          </p:cNvPr>
          <p:cNvSpPr/>
          <p:nvPr/>
        </p:nvSpPr>
        <p:spPr>
          <a:xfrm>
            <a:off x="7116256" y="2348753"/>
            <a:ext cx="3939882" cy="3237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9B9B265-A26B-64D3-7BDB-ED8964323F88}"/>
              </a:ext>
            </a:extLst>
          </p:cNvPr>
          <p:cNvSpPr txBox="1"/>
          <p:nvPr/>
        </p:nvSpPr>
        <p:spPr>
          <a:xfrm>
            <a:off x="251754" y="922119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1.2</a:t>
            </a:r>
          </a:p>
        </p:txBody>
      </p:sp>
    </p:spTree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421005" y="282257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421005" y="37338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421005" y="475996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221095" y="197675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221095" y="43834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202055" y="1258570"/>
            <a:ext cx="4893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2        3      4              1      2       3      4               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3449320" y="1258570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G-3</a:t>
            </a:r>
            <a:r>
              <a:rPr lang="zh-CN" altLang="en-US" dirty="0"/>
              <a:t>、</a:t>
            </a:r>
            <a:r>
              <a:rPr lang="en-US" altLang="zh-CN" dirty="0"/>
              <a:t>4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51980" y="635"/>
            <a:ext cx="5239385" cy="1091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si-FOXO1-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2         </a:t>
            </a:r>
            <a:r>
              <a:rPr lang="en-US" altLang="zh-CN" b="1"/>
              <a:t>4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3</a:t>
            </a:r>
            <a:endParaRPr lang="zh-CN" altLang="en-US" b="1"/>
          </a:p>
        </p:txBody>
      </p:sp>
      <p:sp>
        <p:nvSpPr>
          <p:cNvPr id="4" name="文本框 3"/>
          <p:cNvSpPr txBox="1"/>
          <p:nvPr/>
        </p:nvSpPr>
        <p:spPr>
          <a:xfrm>
            <a:off x="421005" y="22771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421005" y="173164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85240" y="1660525"/>
            <a:ext cx="4810760" cy="3536950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1304925" y="1946625"/>
            <a:ext cx="4689337" cy="4121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8" name="矩形 47"/>
          <p:cNvSpPr/>
          <p:nvPr/>
        </p:nvSpPr>
        <p:spPr>
          <a:xfrm>
            <a:off x="1327784" y="4263390"/>
            <a:ext cx="4768216" cy="4851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704DB64-0F17-EA01-3863-65B1455A4C09}"/>
              </a:ext>
            </a:extLst>
          </p:cNvPr>
          <p:cNvSpPr txBox="1"/>
          <p:nvPr/>
        </p:nvSpPr>
        <p:spPr>
          <a:xfrm>
            <a:off x="11030230" y="2684247"/>
            <a:ext cx="883920" cy="25290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3CEF79EB-4B59-CDFC-B6BF-65B5D1BF4B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0987" y="2479152"/>
            <a:ext cx="4016088" cy="701101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E66C37B4-64DA-869A-02B3-73BD31F23872}"/>
              </a:ext>
            </a:extLst>
          </p:cNvPr>
          <p:cNvSpPr/>
          <p:nvPr/>
        </p:nvSpPr>
        <p:spPr>
          <a:xfrm>
            <a:off x="6870987" y="2684247"/>
            <a:ext cx="3922519" cy="351512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75F3DEB-5AE5-F104-39E8-8F59E8C0A234}"/>
              </a:ext>
            </a:extLst>
          </p:cNvPr>
          <p:cNvSpPr txBox="1"/>
          <p:nvPr/>
        </p:nvSpPr>
        <p:spPr>
          <a:xfrm>
            <a:off x="251754" y="922119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3.4</a:t>
            </a:r>
          </a:p>
        </p:txBody>
      </p:sp>
    </p:spTree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1500057" y="27698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500057" y="38608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500057" y="50292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671896" y="47593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3088192" y="985520"/>
            <a:ext cx="2597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  1       2        3       4               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520502" y="985520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G-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51980" y="635"/>
            <a:ext cx="5239385" cy="1091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si-FOXO1-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2         </a:t>
            </a:r>
            <a:r>
              <a:rPr lang="en-US" altLang="zh-CN" b="1"/>
              <a:t>4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3</a:t>
            </a:r>
            <a:endParaRPr lang="zh-CN" altLang="en-US" b="1"/>
          </a:p>
        </p:txBody>
      </p:sp>
      <p:sp>
        <p:nvSpPr>
          <p:cNvPr id="4" name="文本框 3"/>
          <p:cNvSpPr txBox="1"/>
          <p:nvPr/>
        </p:nvSpPr>
        <p:spPr>
          <a:xfrm>
            <a:off x="1500057" y="200406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500057" y="14585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rcRect r="93459"/>
          <a:stretch>
            <a:fillRect/>
          </a:stretch>
        </p:blipFill>
        <p:spPr>
          <a:xfrm>
            <a:off x="2447477" y="1353820"/>
            <a:ext cx="351790" cy="428117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rcRect l="51862"/>
          <a:stretch>
            <a:fillRect/>
          </a:stretch>
        </p:blipFill>
        <p:spPr>
          <a:xfrm>
            <a:off x="3088192" y="1353820"/>
            <a:ext cx="2597150" cy="4295140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3087556" y="4651375"/>
            <a:ext cx="2597786" cy="48514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3150310" y="1863501"/>
            <a:ext cx="2403886" cy="4121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67026B3-45B0-04BB-6F0A-CD2557B79222}"/>
              </a:ext>
            </a:extLst>
          </p:cNvPr>
          <p:cNvSpPr txBox="1"/>
          <p:nvPr/>
        </p:nvSpPr>
        <p:spPr>
          <a:xfrm>
            <a:off x="5671896" y="192436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1C120DE-CADC-DE1D-DC2A-6BF063E2D56B}"/>
              </a:ext>
            </a:extLst>
          </p:cNvPr>
          <p:cNvSpPr txBox="1"/>
          <p:nvPr/>
        </p:nvSpPr>
        <p:spPr>
          <a:xfrm>
            <a:off x="8561441" y="197608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BC234588-8A88-F558-024D-EAFDCEB5CE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4914" y="1610915"/>
            <a:ext cx="2103302" cy="975445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215B57AE-8F9C-D0FB-4A97-0F8677092902}"/>
              </a:ext>
            </a:extLst>
          </p:cNvPr>
          <p:cNvSpPr/>
          <p:nvPr/>
        </p:nvSpPr>
        <p:spPr>
          <a:xfrm>
            <a:off x="6424914" y="1924367"/>
            <a:ext cx="2103302" cy="329108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0BE3D18-2AFA-06AD-4532-AA00EE789ACE}"/>
              </a:ext>
            </a:extLst>
          </p:cNvPr>
          <p:cNvSpPr txBox="1"/>
          <p:nvPr/>
        </p:nvSpPr>
        <p:spPr>
          <a:xfrm>
            <a:off x="251754" y="922119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5</a:t>
            </a:r>
          </a:p>
        </p:txBody>
      </p:sp>
    </p:spTree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3" name="文本框 42"/>
          <p:cNvSpPr txBox="1"/>
          <p:nvPr/>
        </p:nvSpPr>
        <p:spPr>
          <a:xfrm>
            <a:off x="1876575" y="305251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876575" y="42145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876575" y="554298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062495" y="192729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6062495" y="5140436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3464710" y="1010359"/>
            <a:ext cx="2597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 2         3        4               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897020" y="1010359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0"/>
            <a:ext cx="2753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G-6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51980" y="635"/>
            <a:ext cx="5239385" cy="1091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si-FOXO1-1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/>
              <a:t>3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2         </a:t>
            </a:r>
            <a:r>
              <a:rPr lang="en-US" altLang="zh-CN" b="1"/>
              <a:t>4</a:t>
            </a:r>
            <a:r>
              <a:rPr lang="zh-CN" altLang="en-US" b="1"/>
              <a:t>：</a:t>
            </a:r>
            <a:r>
              <a:rPr lang="en-US" altLang="zh-CN" b="1">
                <a:sym typeface="+mn-ea"/>
              </a:rPr>
              <a:t>si-FOXO1-3</a:t>
            </a:r>
            <a:endParaRPr lang="zh-CN" altLang="en-US" b="1"/>
          </a:p>
        </p:txBody>
      </p:sp>
      <p:sp>
        <p:nvSpPr>
          <p:cNvPr id="4" name="文本框 3"/>
          <p:cNvSpPr txBox="1"/>
          <p:nvPr/>
        </p:nvSpPr>
        <p:spPr>
          <a:xfrm>
            <a:off x="1876575" y="226892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876575" y="148343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37330" y="1483434"/>
            <a:ext cx="3225165" cy="4711065"/>
          </a:xfrm>
          <a:prstGeom prst="rect">
            <a:avLst/>
          </a:prstGeom>
        </p:spPr>
      </p:pic>
      <p:sp>
        <p:nvSpPr>
          <p:cNvPr id="48" name="矩形 47"/>
          <p:cNvSpPr/>
          <p:nvPr/>
        </p:nvSpPr>
        <p:spPr>
          <a:xfrm>
            <a:off x="3182471" y="4916244"/>
            <a:ext cx="2880024" cy="55626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3296435" y="1865704"/>
            <a:ext cx="2656130" cy="41211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D5728CC-6924-765B-8C50-D95188BB0EB5}"/>
              </a:ext>
            </a:extLst>
          </p:cNvPr>
          <p:cNvSpPr txBox="1"/>
          <p:nvPr/>
        </p:nvSpPr>
        <p:spPr>
          <a:xfrm>
            <a:off x="9799059" y="445967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FOXO1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E7F387E-E797-1EB1-DB8D-1529C3CBB744}"/>
              </a:ext>
            </a:extLst>
          </p:cNvPr>
          <p:cNvSpPr txBox="1"/>
          <p:nvPr/>
        </p:nvSpPr>
        <p:spPr>
          <a:xfrm>
            <a:off x="8235104" y="3756045"/>
            <a:ext cx="103905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FFB4475-8AA3-3646-F7DA-C0C9649E74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80105" y="4260795"/>
            <a:ext cx="2255715" cy="624894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C43267A7-236D-5096-C2BD-06BAAF12012B}"/>
              </a:ext>
            </a:extLst>
          </p:cNvPr>
          <p:cNvSpPr/>
          <p:nvPr/>
        </p:nvSpPr>
        <p:spPr>
          <a:xfrm>
            <a:off x="7480105" y="4459679"/>
            <a:ext cx="2255715" cy="28956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753E5E3-05B1-8ECA-528E-C87BBF2855CE}"/>
              </a:ext>
            </a:extLst>
          </p:cNvPr>
          <p:cNvSpPr txBox="1"/>
          <p:nvPr/>
        </p:nvSpPr>
        <p:spPr>
          <a:xfrm>
            <a:off x="251754" y="922119"/>
            <a:ext cx="13087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6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50"/>
          <p:cNvSpPr txBox="1"/>
          <p:nvPr/>
        </p:nvSpPr>
        <p:spPr>
          <a:xfrm>
            <a:off x="0" y="0"/>
            <a:ext cx="21596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C-1</a:t>
            </a:r>
            <a:r>
              <a:rPr lang="zh-CN" altLang="en-US" dirty="0"/>
              <a:t>、</a:t>
            </a:r>
            <a:r>
              <a:rPr lang="en-US" altLang="zh-CN" dirty="0"/>
              <a:t>2</a:t>
            </a:r>
            <a:r>
              <a:rPr lang="zh-CN" altLang="en-US" dirty="0"/>
              <a:t>、</a:t>
            </a:r>
            <a:r>
              <a:rPr lang="en-US" altLang="zh-CN" dirty="0"/>
              <a:t>3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1465971" y="1697803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663331" y="2776731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0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633394" y="325403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7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653806" y="358629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653106" y="430709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4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663331" y="500361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59288" y="240392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975241" y="1667323"/>
            <a:ext cx="30537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1     2          1     2     1     2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0500009" y="2932243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5374274" y="4935369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426" y="2035623"/>
            <a:ext cx="1390660" cy="3500463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3764" y="2035623"/>
            <a:ext cx="2432108" cy="3500463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2035622"/>
            <a:ext cx="4242049" cy="3500463"/>
          </a:xfrm>
          <a:prstGeom prst="rect">
            <a:avLst/>
          </a:prstGeom>
        </p:spPr>
      </p:pic>
      <p:sp>
        <p:nvSpPr>
          <p:cNvPr id="15" name="矩形 14"/>
          <p:cNvSpPr/>
          <p:nvPr/>
        </p:nvSpPr>
        <p:spPr>
          <a:xfrm>
            <a:off x="1853951" y="4935369"/>
            <a:ext cx="3452127" cy="37719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8563099" y="3002710"/>
            <a:ext cx="1774950" cy="245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6556605" y="3021841"/>
            <a:ext cx="782469" cy="26793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6047335" y="1692765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M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6556605" y="1662285"/>
            <a:ext cx="3849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1     2                         1     2     1     2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C85FFDC-A3B5-B411-6746-B0A2C21109A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74015" y="5721900"/>
            <a:ext cx="3200677" cy="937341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0D241104-74CD-4501-70C9-7EB07267458B}"/>
              </a:ext>
            </a:extLst>
          </p:cNvPr>
          <p:cNvSpPr/>
          <p:nvPr/>
        </p:nvSpPr>
        <p:spPr>
          <a:xfrm>
            <a:off x="8186582" y="6091547"/>
            <a:ext cx="1488110" cy="25491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D80FA6C4-6D58-629D-243B-46116B4A9ED2}"/>
              </a:ext>
            </a:extLst>
          </p:cNvPr>
          <p:cNvSpPr/>
          <p:nvPr/>
        </p:nvSpPr>
        <p:spPr>
          <a:xfrm>
            <a:off x="6474015" y="6125883"/>
            <a:ext cx="715679" cy="28166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767C532-E04A-CE28-B817-5BCF6FD47726}"/>
              </a:ext>
            </a:extLst>
          </p:cNvPr>
          <p:cNvSpPr txBox="1"/>
          <p:nvPr/>
        </p:nvSpPr>
        <p:spPr>
          <a:xfrm>
            <a:off x="9674692" y="606801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561CDEA-9F57-7975-AFA3-09E64AD77602}"/>
              </a:ext>
            </a:extLst>
          </p:cNvPr>
          <p:cNvSpPr txBox="1"/>
          <p:nvPr/>
        </p:nvSpPr>
        <p:spPr>
          <a:xfrm>
            <a:off x="281940" y="783901"/>
            <a:ext cx="1445883" cy="3682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1.2.3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D6D3F18-0472-3B9D-BCED-28ED147D99D3}"/>
              </a:ext>
            </a:extLst>
          </p:cNvPr>
          <p:cNvSpPr txBox="1"/>
          <p:nvPr/>
        </p:nvSpPr>
        <p:spPr>
          <a:xfrm>
            <a:off x="9881870" y="292100"/>
            <a:ext cx="2028190" cy="881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si-circDhx32</a:t>
            </a:r>
          </a:p>
        </p:txBody>
      </p:sp>
    </p:spTree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0" y="0"/>
            <a:ext cx="1790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6-I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42465" y="1568450"/>
            <a:ext cx="7097395" cy="3721100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906145" y="33705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906145" y="415480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906145" y="48691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906145" y="272859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70 kD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906145" y="2320925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 k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906145" y="187198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30 kD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906145" y="162687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70 kD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942465" y="1200150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5437505" y="1200150"/>
            <a:ext cx="39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6951980" y="635"/>
            <a:ext cx="5239385" cy="5715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/>
              <a:t>1</a:t>
            </a:r>
            <a:r>
              <a:rPr lang="zh-CN" altLang="en-US" b="1"/>
              <a:t>：</a:t>
            </a:r>
            <a:r>
              <a:rPr lang="en-US" altLang="zh-CN" b="1"/>
              <a:t>NC                        2</a:t>
            </a:r>
            <a:r>
              <a:rPr lang="zh-CN" altLang="en-US" b="1"/>
              <a:t>：</a:t>
            </a:r>
            <a:r>
              <a:rPr lang="en-US" altLang="zh-CN" b="1"/>
              <a:t>oe-FOXO1-1</a:t>
            </a:r>
            <a:endParaRPr lang="zh-CN" altLang="en-US" b="1"/>
          </a:p>
        </p:txBody>
      </p:sp>
      <p:sp>
        <p:nvSpPr>
          <p:cNvPr id="12" name="文本框 11"/>
          <p:cNvSpPr txBox="1"/>
          <p:nvPr/>
        </p:nvSpPr>
        <p:spPr>
          <a:xfrm>
            <a:off x="2321560" y="1187450"/>
            <a:ext cx="30841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1      1       2      2       2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5838190" y="1187450"/>
            <a:ext cx="30841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  1      1      1       2      2       2</a:t>
            </a:r>
          </a:p>
        </p:txBody>
      </p:sp>
      <p:sp>
        <p:nvSpPr>
          <p:cNvPr id="47" name="矩形 46"/>
          <p:cNvSpPr/>
          <p:nvPr/>
        </p:nvSpPr>
        <p:spPr>
          <a:xfrm>
            <a:off x="2341880" y="2474595"/>
            <a:ext cx="6544945" cy="41211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2341880" y="4554220"/>
            <a:ext cx="6580505" cy="412115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/>
          <p:cNvSpPr txBox="1"/>
          <p:nvPr/>
        </p:nvSpPr>
        <p:spPr>
          <a:xfrm>
            <a:off x="9039860" y="255809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9079278" y="463772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/>
              <a:t>GAPDH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52DF8D9-7929-A76F-A567-C53E2D99443E}"/>
              </a:ext>
            </a:extLst>
          </p:cNvPr>
          <p:cNvSpPr txBox="1"/>
          <p:nvPr/>
        </p:nvSpPr>
        <p:spPr>
          <a:xfrm>
            <a:off x="8155940" y="574321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1559B24B-FDE0-1C23-D588-DDA57FC76D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54696" y="5392660"/>
            <a:ext cx="5502117" cy="701101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9EAB4009-6684-775C-9B11-3C8DE5C6C7D0}"/>
              </a:ext>
            </a:extLst>
          </p:cNvPr>
          <p:cNvSpPr/>
          <p:nvPr/>
        </p:nvSpPr>
        <p:spPr>
          <a:xfrm>
            <a:off x="2654697" y="5743211"/>
            <a:ext cx="5501244" cy="2451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19463FC-2647-16DC-3307-3A60E596614E}"/>
              </a:ext>
            </a:extLst>
          </p:cNvPr>
          <p:cNvSpPr txBox="1"/>
          <p:nvPr/>
        </p:nvSpPr>
        <p:spPr>
          <a:xfrm>
            <a:off x="195656" y="668893"/>
            <a:ext cx="25587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1.2.3.4.5.6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6E19B63-E811-E422-5371-28AEF36466C2}"/>
              </a:ext>
            </a:extLst>
          </p:cNvPr>
          <p:cNvSpPr txBox="1"/>
          <p:nvPr/>
        </p:nvSpPr>
        <p:spPr>
          <a:xfrm>
            <a:off x="4572000" y="6195695"/>
            <a:ext cx="173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SHOW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组合 28"/>
          <p:cNvGrpSpPr/>
          <p:nvPr/>
        </p:nvGrpSpPr>
        <p:grpSpPr>
          <a:xfrm>
            <a:off x="2371112" y="2024417"/>
            <a:ext cx="3367452" cy="3439771"/>
            <a:chOff x="585307" y="3069127"/>
            <a:chExt cx="3367452" cy="3439771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/>
            <a:srcRect r="80172"/>
            <a:stretch>
              <a:fillRect/>
            </a:stretch>
          </p:blipFill>
          <p:spPr>
            <a:xfrm>
              <a:off x="585307" y="3069127"/>
              <a:ext cx="1136906" cy="343183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3"/>
            <a:srcRect l="81045"/>
            <a:stretch>
              <a:fillRect/>
            </a:stretch>
          </p:blipFill>
          <p:spPr>
            <a:xfrm>
              <a:off x="2865966" y="3077068"/>
              <a:ext cx="1086793" cy="343183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3"/>
            <a:srcRect l="47061" r="32396"/>
            <a:stretch>
              <a:fillRect/>
            </a:stretch>
          </p:blipFill>
          <p:spPr>
            <a:xfrm>
              <a:off x="1717572" y="3069127"/>
              <a:ext cx="1177924" cy="3431830"/>
            </a:xfrm>
            <a:prstGeom prst="rect">
              <a:avLst/>
            </a:prstGeom>
          </p:spPr>
        </p:pic>
      </p:grpSp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497493" y="659860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51" name="文本框 50"/>
          <p:cNvSpPr txBox="1"/>
          <p:nvPr/>
        </p:nvSpPr>
        <p:spPr>
          <a:xfrm>
            <a:off x="0" y="0"/>
            <a:ext cx="21596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5C-4</a:t>
            </a:r>
            <a:r>
              <a:rPr lang="zh-CN" altLang="en-US" dirty="0"/>
              <a:t>、</a:t>
            </a:r>
            <a:r>
              <a:rPr lang="en-US" altLang="zh-CN" dirty="0"/>
              <a:t>5</a:t>
            </a:r>
            <a:r>
              <a:rPr lang="zh-CN" altLang="en-US" dirty="0"/>
              <a:t>、</a:t>
            </a:r>
            <a:r>
              <a:rPr lang="en-US" altLang="zh-CN" dirty="0"/>
              <a:t>6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2321980" y="1649957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M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1525747" y="274846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0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1536375" y="318710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7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1526850" y="361191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55 kD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1528120" y="4265332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0 kD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536375" y="5050827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35 kD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536375" y="2299200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3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12" name="文本框 11"/>
          <p:cNvSpPr txBox="1"/>
          <p:nvPr/>
        </p:nvSpPr>
        <p:spPr>
          <a:xfrm>
            <a:off x="2859080" y="1648176"/>
            <a:ext cx="30537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1     2        1     2      1     2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0092934" y="3088327"/>
            <a:ext cx="616479" cy="28067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5750927" y="4660868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GAPDH</a:t>
            </a:r>
          </a:p>
        </p:txBody>
      </p:sp>
      <p:sp>
        <p:nvSpPr>
          <p:cNvPr id="9" name="矩形 8"/>
          <p:cNvSpPr/>
          <p:nvPr/>
        </p:nvSpPr>
        <p:spPr>
          <a:xfrm>
            <a:off x="3779744" y="4612585"/>
            <a:ext cx="1761600" cy="34167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1" name="组合 30"/>
          <p:cNvGrpSpPr/>
          <p:nvPr/>
        </p:nvGrpSpPr>
        <p:grpSpPr>
          <a:xfrm>
            <a:off x="6508857" y="2034863"/>
            <a:ext cx="3541667" cy="3461556"/>
            <a:chOff x="8400040" y="3069126"/>
            <a:chExt cx="3541667" cy="3461556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400040" y="3069127"/>
              <a:ext cx="1076333" cy="3452838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488736" y="3077845"/>
              <a:ext cx="1219251" cy="3452837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722456" y="3069126"/>
              <a:ext cx="1219251" cy="3447715"/>
            </a:xfrm>
            <a:prstGeom prst="rect">
              <a:avLst/>
            </a:prstGeom>
          </p:spPr>
        </p:pic>
      </p:grpSp>
      <p:sp>
        <p:nvSpPr>
          <p:cNvPr id="30" name="文本框 29"/>
          <p:cNvSpPr txBox="1"/>
          <p:nvPr/>
        </p:nvSpPr>
        <p:spPr>
          <a:xfrm>
            <a:off x="1525747" y="2022194"/>
            <a:ext cx="883920" cy="2451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 dirty="0"/>
              <a:t>170 </a:t>
            </a:r>
            <a:r>
              <a:rPr lang="en-US" altLang="zh-CN" sz="1200" b="1" dirty="0" err="1"/>
              <a:t>kD</a:t>
            </a:r>
            <a:endParaRPr lang="en-US" altLang="zh-CN" sz="1200" b="1" dirty="0"/>
          </a:p>
        </p:txBody>
      </p:sp>
      <p:sp>
        <p:nvSpPr>
          <p:cNvPr id="15" name="矩形 14"/>
          <p:cNvSpPr/>
          <p:nvPr/>
        </p:nvSpPr>
        <p:spPr>
          <a:xfrm>
            <a:off x="7921843" y="3027778"/>
            <a:ext cx="1885172" cy="36830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文本框 31"/>
          <p:cNvSpPr txBox="1"/>
          <p:nvPr/>
        </p:nvSpPr>
        <p:spPr>
          <a:xfrm>
            <a:off x="6406850" y="1667717"/>
            <a:ext cx="509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M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6882240" y="1665936"/>
            <a:ext cx="30537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1     2        1     2      1     2</a:t>
            </a:r>
          </a:p>
        </p:txBody>
      </p:sp>
      <p:sp>
        <p:nvSpPr>
          <p:cNvPr id="36" name="矩形 35"/>
          <p:cNvSpPr/>
          <p:nvPr/>
        </p:nvSpPr>
        <p:spPr>
          <a:xfrm>
            <a:off x="2613953" y="4589817"/>
            <a:ext cx="980555" cy="461010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6758830" y="3130977"/>
            <a:ext cx="832541" cy="357359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/>
          <p:cNvSpPr txBox="1"/>
          <p:nvPr/>
        </p:nvSpPr>
        <p:spPr>
          <a:xfrm>
            <a:off x="5970238" y="6045428"/>
            <a:ext cx="10344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endParaRPr lang="zh-CN" alt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8688536-202A-F864-3B6D-A8A7E93D730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47023" y="5652132"/>
            <a:ext cx="2453853" cy="815411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7B74E5AE-E4C3-16F4-4128-D71070A903D7}"/>
              </a:ext>
            </a:extLst>
          </p:cNvPr>
          <p:cNvSpPr/>
          <p:nvPr/>
        </p:nvSpPr>
        <p:spPr>
          <a:xfrm>
            <a:off x="7996698" y="6059721"/>
            <a:ext cx="1504178" cy="28961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667BB081-8D91-1711-9172-1F8B9A291D35}"/>
              </a:ext>
            </a:extLst>
          </p:cNvPr>
          <p:cNvSpPr/>
          <p:nvPr/>
        </p:nvSpPr>
        <p:spPr>
          <a:xfrm>
            <a:off x="7047023" y="6203576"/>
            <a:ext cx="644695" cy="179629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759CF79-F394-07B5-A922-42678D043633}"/>
              </a:ext>
            </a:extLst>
          </p:cNvPr>
          <p:cNvSpPr txBox="1"/>
          <p:nvPr/>
        </p:nvSpPr>
        <p:spPr>
          <a:xfrm>
            <a:off x="9497616" y="6068661"/>
            <a:ext cx="616479" cy="28067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/>
              <a:t>Foxo1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CE44D16-3EC4-6648-1627-60D78B2D3CB4}"/>
              </a:ext>
            </a:extLst>
          </p:cNvPr>
          <p:cNvSpPr txBox="1"/>
          <p:nvPr/>
        </p:nvSpPr>
        <p:spPr>
          <a:xfrm>
            <a:off x="281940" y="783901"/>
            <a:ext cx="15524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800" b="1" dirty="0"/>
              <a:t>Foxo1-4.5.6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3E2D2F9-4494-72A0-7795-9F1642449AA1}"/>
              </a:ext>
            </a:extLst>
          </p:cNvPr>
          <p:cNvSpPr txBox="1"/>
          <p:nvPr/>
        </p:nvSpPr>
        <p:spPr>
          <a:xfrm>
            <a:off x="9881870" y="292100"/>
            <a:ext cx="2028190" cy="881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1</a:t>
            </a:r>
            <a:r>
              <a:rPr lang="zh-CN" altLang="en-US" b="1" dirty="0"/>
              <a:t>：</a:t>
            </a:r>
            <a:r>
              <a:rPr lang="en-US" altLang="zh-CN" b="1" dirty="0"/>
              <a:t>NC</a:t>
            </a:r>
          </a:p>
          <a:p>
            <a:pPr indent="0" fontAlgn="auto">
              <a:lnSpc>
                <a:spcPct val="150000"/>
              </a:lnSpc>
            </a:pPr>
            <a:r>
              <a:rPr lang="en-US" altLang="zh-CN" b="1" dirty="0"/>
              <a:t>2</a:t>
            </a:r>
            <a:r>
              <a:rPr lang="zh-CN" altLang="en-US" b="1" dirty="0"/>
              <a:t>：</a:t>
            </a:r>
            <a:r>
              <a:rPr lang="en-US" altLang="zh-CN" b="1" dirty="0"/>
              <a:t>si-circDhx32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TE1MmE4NTVkZGU5ZTNkODM2ZjE2MzVmNzcyMGNiODg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8</TotalTime>
  <Words>2779</Words>
  <Application>Microsoft Office PowerPoint</Application>
  <PresentationFormat>宽屏</PresentationFormat>
  <Paragraphs>1224</Paragraphs>
  <Slides>80</Slides>
  <Notes>33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0</vt:i4>
      </vt:variant>
    </vt:vector>
  </HeadingPairs>
  <TitlesOfParts>
    <vt:vector size="8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唯 司</dc:creator>
  <cp:lastModifiedBy>唯 司</cp:lastModifiedBy>
  <cp:revision>290</cp:revision>
  <dcterms:created xsi:type="dcterms:W3CDTF">2023-10-19T06:46:00Z</dcterms:created>
  <dcterms:modified xsi:type="dcterms:W3CDTF">2025-03-04T08:43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A6CC2D7B69F4EA2898022D8AE05F086_12</vt:lpwstr>
  </property>
  <property fmtid="{D5CDD505-2E9C-101B-9397-08002B2CF9AE}" pid="3" name="KSOProductBuildVer">
    <vt:lpwstr>2052-12.1.0.17133</vt:lpwstr>
  </property>
</Properties>
</file>